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kle Pauzaite" userId="06f7e524-8501-4f81-9b2a-484f6f2c7061" providerId="ADAL" clId="{8E5480CC-6F87-4B3E-88EB-9BB047D963B1}"/>
    <pc:docChg chg="custSel addSld modSld">
      <pc:chgData name="Tekle Pauzaite" userId="06f7e524-8501-4f81-9b2a-484f6f2c7061" providerId="ADAL" clId="{8E5480CC-6F87-4B3E-88EB-9BB047D963B1}" dt="2024-04-03T08:30:26.219" v="560" actId="571"/>
      <pc:docMkLst>
        <pc:docMk/>
      </pc:docMkLst>
      <pc:sldChg chg="addSp delSp modSp add">
        <pc:chgData name="Tekle Pauzaite" userId="06f7e524-8501-4f81-9b2a-484f6f2c7061" providerId="ADAL" clId="{8E5480CC-6F87-4B3E-88EB-9BB047D963B1}" dt="2024-04-03T08:09:19.356" v="231" actId="571"/>
        <pc:sldMkLst>
          <pc:docMk/>
          <pc:sldMk cId="1168536805" sldId="256"/>
        </pc:sldMkLst>
        <pc:spChg chg="del">
          <ac:chgData name="Tekle Pauzaite" userId="06f7e524-8501-4f81-9b2a-484f6f2c7061" providerId="ADAL" clId="{8E5480CC-6F87-4B3E-88EB-9BB047D963B1}" dt="2024-04-03T08:00:18.334" v="1"/>
          <ac:spMkLst>
            <pc:docMk/>
            <pc:sldMk cId="1168536805" sldId="256"/>
            <ac:spMk id="2" creationId="{8D2BD087-545F-45B4-9E4E-6B8BBDC9C856}"/>
          </ac:spMkLst>
        </pc:spChg>
        <pc:spChg chg="del">
          <ac:chgData name="Tekle Pauzaite" userId="06f7e524-8501-4f81-9b2a-484f6f2c7061" providerId="ADAL" clId="{8E5480CC-6F87-4B3E-88EB-9BB047D963B1}" dt="2024-04-03T08:00:18.334" v="1"/>
          <ac:spMkLst>
            <pc:docMk/>
            <pc:sldMk cId="1168536805" sldId="256"/>
            <ac:spMk id="3" creationId="{0F4C3BBC-50B9-44B0-B1E3-8171FDFE827A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11" creationId="{6E6937C5-3D71-4EF4-A968-82044EBFAADA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12" creationId="{E4E170B6-D9E1-4E63-9B58-F560BC0FEC71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13" creationId="{B862180F-A7AC-4876-BB61-E7E431286513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14" creationId="{F27042F3-10A9-4EF9-A4C1-B2B57E7B6CD2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15" creationId="{0E6A0A7C-65BD-4BF7-8C71-B9886EDED4F9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16" creationId="{8A5DA23B-3696-4240-A702-85406DF5C998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17" creationId="{6CC38FF2-6FF1-4375-8B2B-7E73B217790C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18" creationId="{75691320-0612-424F-95E7-AF5CCA61901B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19" creationId="{053D75B3-76D9-44B4-B4AD-C49846979D8E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20" creationId="{3CB80E99-AA30-46C8-869E-1B4842FA2A83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21" creationId="{17E07662-71A0-4404-B822-9EF26623C5BD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24" creationId="{8C1232F4-835E-4C65-A8D5-AD5C1C7E1C2F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25" creationId="{9EFFD095-1203-4363-9523-3969ECF83F16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28" creationId="{9FD45DE2-7461-4FD2-B597-D7D6D0806A96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29" creationId="{8C2BCBA4-3286-4129-98D5-9771BA4F995C}"/>
          </ac:spMkLst>
        </pc:spChg>
        <pc:spChg chg="mod topLvl">
          <ac:chgData name="Tekle Pauzaite" userId="06f7e524-8501-4f81-9b2a-484f6f2c7061" providerId="ADAL" clId="{8E5480CC-6F87-4B3E-88EB-9BB047D963B1}" dt="2024-04-03T08:00:34.853" v="4" actId="165"/>
          <ac:spMkLst>
            <pc:docMk/>
            <pc:sldMk cId="1168536805" sldId="256"/>
            <ac:spMk id="32" creationId="{AC19F593-B0C9-46C7-8113-6F4D81D865DE}"/>
          </ac:spMkLst>
        </pc:spChg>
        <pc:spChg chg="add mod">
          <ac:chgData name="Tekle Pauzaite" userId="06f7e524-8501-4f81-9b2a-484f6f2c7061" providerId="ADAL" clId="{8E5480CC-6F87-4B3E-88EB-9BB047D963B1}" dt="2024-04-03T08:01:37.404" v="28" actId="208"/>
          <ac:spMkLst>
            <pc:docMk/>
            <pc:sldMk cId="1168536805" sldId="256"/>
            <ac:spMk id="34" creationId="{5A1139CB-4BE1-4C06-8102-4E8ACFCFB12F}"/>
          </ac:spMkLst>
        </pc:spChg>
        <pc:spChg chg="add mod">
          <ac:chgData name="Tekle Pauzaite" userId="06f7e524-8501-4f81-9b2a-484f6f2c7061" providerId="ADAL" clId="{8E5480CC-6F87-4B3E-88EB-9BB047D963B1}" dt="2024-04-03T08:02:25.104" v="52" actId="571"/>
          <ac:spMkLst>
            <pc:docMk/>
            <pc:sldMk cId="1168536805" sldId="256"/>
            <ac:spMk id="36" creationId="{ED752801-24F8-4714-BE08-9389A4C0371D}"/>
          </ac:spMkLst>
        </pc:spChg>
        <pc:spChg chg="add mod">
          <ac:chgData name="Tekle Pauzaite" userId="06f7e524-8501-4f81-9b2a-484f6f2c7061" providerId="ADAL" clId="{8E5480CC-6F87-4B3E-88EB-9BB047D963B1}" dt="2024-04-03T08:03:18.133" v="70" actId="571"/>
          <ac:spMkLst>
            <pc:docMk/>
            <pc:sldMk cId="1168536805" sldId="256"/>
            <ac:spMk id="38" creationId="{5E3C73FA-315D-4103-8539-D1F42B126CB2}"/>
          </ac:spMkLst>
        </pc:spChg>
        <pc:spChg chg="add mod">
          <ac:chgData name="Tekle Pauzaite" userId="06f7e524-8501-4f81-9b2a-484f6f2c7061" providerId="ADAL" clId="{8E5480CC-6F87-4B3E-88EB-9BB047D963B1}" dt="2024-04-03T08:04:24.540" v="102" actId="1076"/>
          <ac:spMkLst>
            <pc:docMk/>
            <pc:sldMk cId="1168536805" sldId="256"/>
            <ac:spMk id="40" creationId="{CE3EFDD7-B69D-4B42-A29B-FD32D19886F3}"/>
          </ac:spMkLst>
        </pc:spChg>
        <pc:spChg chg="add mod">
          <ac:chgData name="Tekle Pauzaite" userId="06f7e524-8501-4f81-9b2a-484f6f2c7061" providerId="ADAL" clId="{8E5480CC-6F87-4B3E-88EB-9BB047D963B1}" dt="2024-04-03T08:08:58.178" v="228" actId="1037"/>
          <ac:spMkLst>
            <pc:docMk/>
            <pc:sldMk cId="1168536805" sldId="256"/>
            <ac:spMk id="42" creationId="{1942DBF6-CCDE-4CDD-A906-6234B085ACAB}"/>
          </ac:spMkLst>
        </pc:spChg>
        <pc:spChg chg="add mod">
          <ac:chgData name="Tekle Pauzaite" userId="06f7e524-8501-4f81-9b2a-484f6f2c7061" providerId="ADAL" clId="{8E5480CC-6F87-4B3E-88EB-9BB047D963B1}" dt="2024-04-03T08:08:58.178" v="228" actId="1037"/>
          <ac:spMkLst>
            <pc:docMk/>
            <pc:sldMk cId="1168536805" sldId="256"/>
            <ac:spMk id="44" creationId="{D97A3787-B623-4A2B-B6C7-6015BDEA2749}"/>
          </ac:spMkLst>
        </pc:spChg>
        <pc:spChg chg="add del mod">
          <ac:chgData name="Tekle Pauzaite" userId="06f7e524-8501-4f81-9b2a-484f6f2c7061" providerId="ADAL" clId="{8E5480CC-6F87-4B3E-88EB-9BB047D963B1}" dt="2024-04-03T08:05:45.869" v="133" actId="478"/>
          <ac:spMkLst>
            <pc:docMk/>
            <pc:sldMk cId="1168536805" sldId="256"/>
            <ac:spMk id="47" creationId="{551CCE45-9394-4566-8BE4-F611D50BACAD}"/>
          </ac:spMkLst>
        </pc:spChg>
        <pc:spChg chg="add mod">
          <ac:chgData name="Tekle Pauzaite" userId="06f7e524-8501-4f81-9b2a-484f6f2c7061" providerId="ADAL" clId="{8E5480CC-6F87-4B3E-88EB-9BB047D963B1}" dt="2024-04-03T08:08:58.178" v="228" actId="1037"/>
          <ac:spMkLst>
            <pc:docMk/>
            <pc:sldMk cId="1168536805" sldId="256"/>
            <ac:spMk id="48" creationId="{E4B69102-1136-4E0A-B673-2530C9043E09}"/>
          </ac:spMkLst>
        </pc:spChg>
        <pc:spChg chg="add mod">
          <ac:chgData name="Tekle Pauzaite" userId="06f7e524-8501-4f81-9b2a-484f6f2c7061" providerId="ADAL" clId="{8E5480CC-6F87-4B3E-88EB-9BB047D963B1}" dt="2024-04-03T08:06:03.021" v="136" actId="571"/>
          <ac:spMkLst>
            <pc:docMk/>
            <pc:sldMk cId="1168536805" sldId="256"/>
            <ac:spMk id="49" creationId="{903FDF01-2762-4BBD-A50C-5848526A93ED}"/>
          </ac:spMkLst>
        </pc:spChg>
        <pc:spChg chg="add mod">
          <ac:chgData name="Tekle Pauzaite" userId="06f7e524-8501-4f81-9b2a-484f6f2c7061" providerId="ADAL" clId="{8E5480CC-6F87-4B3E-88EB-9BB047D963B1}" dt="2024-04-03T08:06:09.229" v="137" actId="571"/>
          <ac:spMkLst>
            <pc:docMk/>
            <pc:sldMk cId="1168536805" sldId="256"/>
            <ac:spMk id="50" creationId="{EE3EC8F9-83FE-470C-ACCC-9DD6AD9C74BF}"/>
          </ac:spMkLst>
        </pc:spChg>
        <pc:spChg chg="add mod">
          <ac:chgData name="Tekle Pauzaite" userId="06f7e524-8501-4f81-9b2a-484f6f2c7061" providerId="ADAL" clId="{8E5480CC-6F87-4B3E-88EB-9BB047D963B1}" dt="2024-04-03T08:06:13.380" v="138" actId="571"/>
          <ac:spMkLst>
            <pc:docMk/>
            <pc:sldMk cId="1168536805" sldId="256"/>
            <ac:spMk id="51" creationId="{8CCB9680-51FD-4655-B951-65256E0BC2B4}"/>
          </ac:spMkLst>
        </pc:spChg>
        <pc:spChg chg="add mod">
          <ac:chgData name="Tekle Pauzaite" userId="06f7e524-8501-4f81-9b2a-484f6f2c7061" providerId="ADAL" clId="{8E5480CC-6F87-4B3E-88EB-9BB047D963B1}" dt="2024-04-03T08:06:18.532" v="139" actId="571"/>
          <ac:spMkLst>
            <pc:docMk/>
            <pc:sldMk cId="1168536805" sldId="256"/>
            <ac:spMk id="52" creationId="{CF597C40-A8BF-4CB3-89AC-B9B8992F8456}"/>
          </ac:spMkLst>
        </pc:spChg>
        <pc:spChg chg="add mod">
          <ac:chgData name="Tekle Pauzaite" userId="06f7e524-8501-4f81-9b2a-484f6f2c7061" providerId="ADAL" clId="{8E5480CC-6F87-4B3E-88EB-9BB047D963B1}" dt="2024-04-03T08:09:05.499" v="229" actId="1076"/>
          <ac:spMkLst>
            <pc:docMk/>
            <pc:sldMk cId="1168536805" sldId="256"/>
            <ac:spMk id="53" creationId="{8E6DACDE-7E44-4319-8AF5-01B096CFCD8D}"/>
          </ac:spMkLst>
        </pc:spChg>
        <pc:spChg chg="add mod">
          <ac:chgData name="Tekle Pauzaite" userId="06f7e524-8501-4f81-9b2a-484f6f2c7061" providerId="ADAL" clId="{8E5480CC-6F87-4B3E-88EB-9BB047D963B1}" dt="2024-04-03T08:08:58.178" v="228" actId="1037"/>
          <ac:spMkLst>
            <pc:docMk/>
            <pc:sldMk cId="1168536805" sldId="256"/>
            <ac:spMk id="56" creationId="{793CF4BE-59AC-44F9-8628-85524D5C25B0}"/>
          </ac:spMkLst>
        </pc:spChg>
        <pc:spChg chg="add mod">
          <ac:chgData name="Tekle Pauzaite" userId="06f7e524-8501-4f81-9b2a-484f6f2c7061" providerId="ADAL" clId="{8E5480CC-6F87-4B3E-88EB-9BB047D963B1}" dt="2024-04-03T08:09:15.852" v="230" actId="571"/>
          <ac:spMkLst>
            <pc:docMk/>
            <pc:sldMk cId="1168536805" sldId="256"/>
            <ac:spMk id="57" creationId="{6D2180F1-14D7-4E5E-8DF7-C9BBCEA839B0}"/>
          </ac:spMkLst>
        </pc:spChg>
        <pc:spChg chg="add mod">
          <ac:chgData name="Tekle Pauzaite" userId="06f7e524-8501-4f81-9b2a-484f6f2c7061" providerId="ADAL" clId="{8E5480CC-6F87-4B3E-88EB-9BB047D963B1}" dt="2024-04-03T08:09:19.356" v="231" actId="571"/>
          <ac:spMkLst>
            <pc:docMk/>
            <pc:sldMk cId="1168536805" sldId="256"/>
            <ac:spMk id="58" creationId="{746F542A-CFDB-400F-A0DA-C27C7A13E2FD}"/>
          </ac:spMkLst>
        </pc:spChg>
        <pc:grpChg chg="add del mod">
          <ac:chgData name="Tekle Pauzaite" userId="06f7e524-8501-4f81-9b2a-484f6f2c7061" providerId="ADAL" clId="{8E5480CC-6F87-4B3E-88EB-9BB047D963B1}" dt="2024-04-03T08:00:34.853" v="4" actId="165"/>
          <ac:grpSpMkLst>
            <pc:docMk/>
            <pc:sldMk cId="1168536805" sldId="256"/>
            <ac:grpSpMk id="4" creationId="{58B07B29-B863-440D-8B49-0EFC2A66C0D5}"/>
          </ac:grpSpMkLst>
        </pc:grpChg>
        <pc:picChg chg="mod topLvl">
          <ac:chgData name="Tekle Pauzaite" userId="06f7e524-8501-4f81-9b2a-484f6f2c7061" providerId="ADAL" clId="{8E5480CC-6F87-4B3E-88EB-9BB047D963B1}" dt="2024-04-03T08:00:34.853" v="4" actId="165"/>
          <ac:picMkLst>
            <pc:docMk/>
            <pc:sldMk cId="1168536805" sldId="256"/>
            <ac:picMk id="5" creationId="{C5ED6DC1-476E-40C5-ACD2-0E1A57C73DC6}"/>
          </ac:picMkLst>
        </pc:picChg>
        <pc:picChg chg="mod topLvl">
          <ac:chgData name="Tekle Pauzaite" userId="06f7e524-8501-4f81-9b2a-484f6f2c7061" providerId="ADAL" clId="{8E5480CC-6F87-4B3E-88EB-9BB047D963B1}" dt="2024-04-03T08:00:34.853" v="4" actId="165"/>
          <ac:picMkLst>
            <pc:docMk/>
            <pc:sldMk cId="1168536805" sldId="256"/>
            <ac:picMk id="6" creationId="{9694AE06-86A4-484D-83D7-797A2B896317}"/>
          </ac:picMkLst>
        </pc:picChg>
        <pc:picChg chg="mod topLvl">
          <ac:chgData name="Tekle Pauzaite" userId="06f7e524-8501-4f81-9b2a-484f6f2c7061" providerId="ADAL" clId="{8E5480CC-6F87-4B3E-88EB-9BB047D963B1}" dt="2024-04-03T08:00:34.853" v="4" actId="165"/>
          <ac:picMkLst>
            <pc:docMk/>
            <pc:sldMk cId="1168536805" sldId="256"/>
            <ac:picMk id="7" creationId="{7B666102-E86B-4BD2-B3E5-53376E3DE182}"/>
          </ac:picMkLst>
        </pc:picChg>
        <pc:picChg chg="mod topLvl">
          <ac:chgData name="Tekle Pauzaite" userId="06f7e524-8501-4f81-9b2a-484f6f2c7061" providerId="ADAL" clId="{8E5480CC-6F87-4B3E-88EB-9BB047D963B1}" dt="2024-04-03T08:00:34.853" v="4" actId="165"/>
          <ac:picMkLst>
            <pc:docMk/>
            <pc:sldMk cId="1168536805" sldId="256"/>
            <ac:picMk id="8" creationId="{39DC4208-6BEC-449F-870E-E03FA13CE223}"/>
          </ac:picMkLst>
        </pc:picChg>
        <pc:picChg chg="mod topLvl">
          <ac:chgData name="Tekle Pauzaite" userId="06f7e524-8501-4f81-9b2a-484f6f2c7061" providerId="ADAL" clId="{8E5480CC-6F87-4B3E-88EB-9BB047D963B1}" dt="2024-04-03T08:00:34.853" v="4" actId="165"/>
          <ac:picMkLst>
            <pc:docMk/>
            <pc:sldMk cId="1168536805" sldId="256"/>
            <ac:picMk id="9" creationId="{20361C98-F721-49FE-821A-D6A887239A46}"/>
          </ac:picMkLst>
        </pc:picChg>
        <pc:picChg chg="mod topLvl">
          <ac:chgData name="Tekle Pauzaite" userId="06f7e524-8501-4f81-9b2a-484f6f2c7061" providerId="ADAL" clId="{8E5480CC-6F87-4B3E-88EB-9BB047D963B1}" dt="2024-04-03T08:00:34.853" v="4" actId="165"/>
          <ac:picMkLst>
            <pc:docMk/>
            <pc:sldMk cId="1168536805" sldId="256"/>
            <ac:picMk id="10" creationId="{C807DEC7-653E-47BF-B418-27A895671953}"/>
          </ac:picMkLst>
        </pc:picChg>
        <pc:picChg chg="mod topLvl">
          <ac:chgData name="Tekle Pauzaite" userId="06f7e524-8501-4f81-9b2a-484f6f2c7061" providerId="ADAL" clId="{8E5480CC-6F87-4B3E-88EB-9BB047D963B1}" dt="2024-04-03T08:00:34.853" v="4" actId="165"/>
          <ac:picMkLst>
            <pc:docMk/>
            <pc:sldMk cId="1168536805" sldId="256"/>
            <ac:picMk id="22" creationId="{AA6BDD6E-E390-47B5-84BC-8E88FB65BA0C}"/>
          </ac:picMkLst>
        </pc:picChg>
        <pc:picChg chg="mod topLvl">
          <ac:chgData name="Tekle Pauzaite" userId="06f7e524-8501-4f81-9b2a-484f6f2c7061" providerId="ADAL" clId="{8E5480CC-6F87-4B3E-88EB-9BB047D963B1}" dt="2024-04-03T08:00:34.853" v="4" actId="165"/>
          <ac:picMkLst>
            <pc:docMk/>
            <pc:sldMk cId="1168536805" sldId="256"/>
            <ac:picMk id="23" creationId="{C7A32732-0B2D-4B41-AD38-93A3E6D3D216}"/>
          </ac:picMkLst>
        </pc:picChg>
        <pc:picChg chg="add mod modCrop">
          <ac:chgData name="Tekle Pauzaite" userId="06f7e524-8501-4f81-9b2a-484f6f2c7061" providerId="ADAL" clId="{8E5480CC-6F87-4B3E-88EB-9BB047D963B1}" dt="2024-04-03T08:01:09.500" v="25" actId="1076"/>
          <ac:picMkLst>
            <pc:docMk/>
            <pc:sldMk cId="1168536805" sldId="256"/>
            <ac:picMk id="33" creationId="{9A157C6F-1873-4784-92B8-947D1D5B549A}"/>
          </ac:picMkLst>
        </pc:picChg>
        <pc:picChg chg="add mod modCrop">
          <ac:chgData name="Tekle Pauzaite" userId="06f7e524-8501-4f81-9b2a-484f6f2c7061" providerId="ADAL" clId="{8E5480CC-6F87-4B3E-88EB-9BB047D963B1}" dt="2024-04-03T08:02:14.303" v="51" actId="14100"/>
          <ac:picMkLst>
            <pc:docMk/>
            <pc:sldMk cId="1168536805" sldId="256"/>
            <ac:picMk id="35" creationId="{DA826FDA-7421-4B4B-9D70-AEDA65319D43}"/>
          </ac:picMkLst>
        </pc:picChg>
        <pc:picChg chg="add mod modCrop">
          <ac:chgData name="Tekle Pauzaite" userId="06f7e524-8501-4f81-9b2a-484f6f2c7061" providerId="ADAL" clId="{8E5480CC-6F87-4B3E-88EB-9BB047D963B1}" dt="2024-04-03T08:02:46.764" v="69" actId="1076"/>
          <ac:picMkLst>
            <pc:docMk/>
            <pc:sldMk cId="1168536805" sldId="256"/>
            <ac:picMk id="37" creationId="{9B4C8B3D-6AFC-44C8-9111-354A5A72D404}"/>
          </ac:picMkLst>
        </pc:picChg>
        <pc:picChg chg="add mod modCrop">
          <ac:chgData name="Tekle Pauzaite" userId="06f7e524-8501-4f81-9b2a-484f6f2c7061" providerId="ADAL" clId="{8E5480CC-6F87-4B3E-88EB-9BB047D963B1}" dt="2024-04-03T08:04:17.260" v="100" actId="1076"/>
          <ac:picMkLst>
            <pc:docMk/>
            <pc:sldMk cId="1168536805" sldId="256"/>
            <ac:picMk id="39" creationId="{888771B0-7853-4410-815D-18CA7A3CD80A}"/>
          </ac:picMkLst>
        </pc:picChg>
        <pc:picChg chg="add mod modCrop">
          <ac:chgData name="Tekle Pauzaite" userId="06f7e524-8501-4f81-9b2a-484f6f2c7061" providerId="ADAL" clId="{8E5480CC-6F87-4B3E-88EB-9BB047D963B1}" dt="2024-04-03T08:08:58.178" v="228" actId="1037"/>
          <ac:picMkLst>
            <pc:docMk/>
            <pc:sldMk cId="1168536805" sldId="256"/>
            <ac:picMk id="41" creationId="{3982A2FF-A0D2-41C2-9AA3-4E79D0A27A53}"/>
          </ac:picMkLst>
        </pc:picChg>
        <pc:picChg chg="add mod modCrop">
          <ac:chgData name="Tekle Pauzaite" userId="06f7e524-8501-4f81-9b2a-484f6f2c7061" providerId="ADAL" clId="{8E5480CC-6F87-4B3E-88EB-9BB047D963B1}" dt="2024-04-03T08:08:58.178" v="228" actId="1037"/>
          <ac:picMkLst>
            <pc:docMk/>
            <pc:sldMk cId="1168536805" sldId="256"/>
            <ac:picMk id="43" creationId="{164A0FFA-30DA-4197-829D-B61F5F8F483E}"/>
          </ac:picMkLst>
        </pc:picChg>
        <pc:picChg chg="add mod modCrop">
          <ac:chgData name="Tekle Pauzaite" userId="06f7e524-8501-4f81-9b2a-484f6f2c7061" providerId="ADAL" clId="{8E5480CC-6F87-4B3E-88EB-9BB047D963B1}" dt="2024-04-03T08:08:58.178" v="228" actId="1037"/>
          <ac:picMkLst>
            <pc:docMk/>
            <pc:sldMk cId="1168536805" sldId="256"/>
            <ac:picMk id="45" creationId="{FEFA859F-04B5-43A4-8204-DA1A028ADB67}"/>
          </ac:picMkLst>
        </pc:picChg>
        <pc:picChg chg="add del mod">
          <ac:chgData name="Tekle Pauzaite" userId="06f7e524-8501-4f81-9b2a-484f6f2c7061" providerId="ADAL" clId="{8E5480CC-6F87-4B3E-88EB-9BB047D963B1}" dt="2024-04-03T08:05:45.869" v="133" actId="478"/>
          <ac:picMkLst>
            <pc:docMk/>
            <pc:sldMk cId="1168536805" sldId="256"/>
            <ac:picMk id="46" creationId="{212E9E98-30E2-4C92-8355-FDAB87BFCD94}"/>
          </ac:picMkLst>
        </pc:picChg>
        <pc:picChg chg="add del mod">
          <ac:chgData name="Tekle Pauzaite" userId="06f7e524-8501-4f81-9b2a-484f6f2c7061" providerId="ADAL" clId="{8E5480CC-6F87-4B3E-88EB-9BB047D963B1}" dt="2024-04-03T08:07:33.807" v="186" actId="478"/>
          <ac:picMkLst>
            <pc:docMk/>
            <pc:sldMk cId="1168536805" sldId="256"/>
            <ac:picMk id="54" creationId="{501C73D4-EBF2-4040-81B8-6837D0878A47}"/>
          </ac:picMkLst>
        </pc:picChg>
        <pc:picChg chg="add del mod">
          <ac:chgData name="Tekle Pauzaite" userId="06f7e524-8501-4f81-9b2a-484f6f2c7061" providerId="ADAL" clId="{8E5480CC-6F87-4B3E-88EB-9BB047D963B1}" dt="2024-04-03T08:08:46.287" v="189" actId="478"/>
          <ac:picMkLst>
            <pc:docMk/>
            <pc:sldMk cId="1168536805" sldId="256"/>
            <ac:picMk id="55" creationId="{E5CC8137-91CC-4FF7-99A2-D2BAC6847183}"/>
          </ac:picMkLst>
        </pc:picChg>
        <pc:cxnChg chg="mod topLvl">
          <ac:chgData name="Tekle Pauzaite" userId="06f7e524-8501-4f81-9b2a-484f6f2c7061" providerId="ADAL" clId="{8E5480CC-6F87-4B3E-88EB-9BB047D963B1}" dt="2024-04-03T08:00:34.853" v="4" actId="165"/>
          <ac:cxnSpMkLst>
            <pc:docMk/>
            <pc:sldMk cId="1168536805" sldId="256"/>
            <ac:cxnSpMk id="26" creationId="{09B31248-90CC-42E5-8728-6DA71E89FE37}"/>
          </ac:cxnSpMkLst>
        </pc:cxnChg>
        <pc:cxnChg chg="mod topLvl">
          <ac:chgData name="Tekle Pauzaite" userId="06f7e524-8501-4f81-9b2a-484f6f2c7061" providerId="ADAL" clId="{8E5480CC-6F87-4B3E-88EB-9BB047D963B1}" dt="2024-04-03T08:00:34.853" v="4" actId="165"/>
          <ac:cxnSpMkLst>
            <pc:docMk/>
            <pc:sldMk cId="1168536805" sldId="256"/>
            <ac:cxnSpMk id="27" creationId="{6A952A6E-5510-48B6-9B22-2BBCA62418A1}"/>
          </ac:cxnSpMkLst>
        </pc:cxnChg>
        <pc:cxnChg chg="mod topLvl">
          <ac:chgData name="Tekle Pauzaite" userId="06f7e524-8501-4f81-9b2a-484f6f2c7061" providerId="ADAL" clId="{8E5480CC-6F87-4B3E-88EB-9BB047D963B1}" dt="2024-04-03T08:00:34.853" v="4" actId="165"/>
          <ac:cxnSpMkLst>
            <pc:docMk/>
            <pc:sldMk cId="1168536805" sldId="256"/>
            <ac:cxnSpMk id="30" creationId="{A7FF1418-C696-4869-AD9D-F61397F6F2AC}"/>
          </ac:cxnSpMkLst>
        </pc:cxnChg>
        <pc:cxnChg chg="mod topLvl">
          <ac:chgData name="Tekle Pauzaite" userId="06f7e524-8501-4f81-9b2a-484f6f2c7061" providerId="ADAL" clId="{8E5480CC-6F87-4B3E-88EB-9BB047D963B1}" dt="2024-04-03T08:00:34.853" v="4" actId="165"/>
          <ac:cxnSpMkLst>
            <pc:docMk/>
            <pc:sldMk cId="1168536805" sldId="256"/>
            <ac:cxnSpMk id="31" creationId="{66CF5F81-2D01-427B-B666-7708B5EF9BF5}"/>
          </ac:cxnSpMkLst>
        </pc:cxnChg>
      </pc:sldChg>
      <pc:sldChg chg="addSp delSp modSp add">
        <pc:chgData name="Tekle Pauzaite" userId="06f7e524-8501-4f81-9b2a-484f6f2c7061" providerId="ADAL" clId="{8E5480CC-6F87-4B3E-88EB-9BB047D963B1}" dt="2024-04-03T08:14:37.356" v="304" actId="571"/>
        <pc:sldMkLst>
          <pc:docMk/>
          <pc:sldMk cId="2197820951" sldId="257"/>
        </pc:sldMkLst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3" creationId="{F26C24A6-18F4-4341-9B7A-17D41386AE9D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4" creationId="{D6E64B8D-DD46-4438-B070-87B4275E3D96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5" creationId="{9A9188FA-2718-491E-B3EE-9768ACF02826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9" creationId="{CF3FF233-3E70-4A1D-8906-8AC47EBB0CC3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10" creationId="{9BE26FF8-04F0-4743-9D64-2738E5372B75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12" creationId="{339C171A-F50E-4DAF-8DB8-968007F4715C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13" creationId="{F74F2389-88DC-48AB-86C2-546C1AB3FD3C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14" creationId="{E415AD2E-B3B7-401D-A11D-55FC89049E54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15" creationId="{6B552B2D-5CF8-407C-9ABB-D1F4AB9521E6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16" creationId="{85E7B039-0A28-49CF-A848-33CF1070DA22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17" creationId="{F89468B5-1592-4AD5-86CB-F241F40D6CD7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18" creationId="{F022EDAC-62C0-4250-BBFA-1BCE7F0CFEFF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19" creationId="{48B731A9-D820-422E-97EA-6E2E2DD3830C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20" creationId="{15F35C8F-7A67-48F7-806C-371C9A0FCC6B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22" creationId="{0F989AE7-6078-415D-8AB7-360835616B58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23" creationId="{56E3C77C-50F3-4C55-95CC-3EA39A96340E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24" creationId="{45EBD1BB-C945-424A-BFFF-49A0C2E78109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25" creationId="{6DDA15C9-FC93-49C2-BBF8-070B08138B41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26" creationId="{21F9F4F4-314A-48D2-94DF-FDAB57B37006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31" creationId="{CA7B6F58-1CF5-4541-8761-62A577B88885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32" creationId="{00EF6B35-4DCE-4468-8640-7A69A37D525E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35" creationId="{C10604E2-0BE3-4DB0-A9DC-1988FCAC121A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36" creationId="{7A5A7B23-7710-4E99-8816-9FCF57DCF087}"/>
          </ac:spMkLst>
        </pc:spChg>
        <pc:spChg chg="mod topLvl">
          <ac:chgData name="Tekle Pauzaite" userId="06f7e524-8501-4f81-9b2a-484f6f2c7061" providerId="ADAL" clId="{8E5480CC-6F87-4B3E-88EB-9BB047D963B1}" dt="2024-04-03T08:11:55.053" v="242" actId="165"/>
          <ac:spMkLst>
            <pc:docMk/>
            <pc:sldMk cId="2197820951" sldId="257"/>
            <ac:spMk id="39" creationId="{04EFB4F0-5A70-4369-A172-1479FB297857}"/>
          </ac:spMkLst>
        </pc:spChg>
        <pc:spChg chg="add mod">
          <ac:chgData name="Tekle Pauzaite" userId="06f7e524-8501-4f81-9b2a-484f6f2c7061" providerId="ADAL" clId="{8E5480CC-6F87-4B3E-88EB-9BB047D963B1}" dt="2024-04-03T08:12:37.140" v="256" actId="14100"/>
          <ac:spMkLst>
            <pc:docMk/>
            <pc:sldMk cId="2197820951" sldId="257"/>
            <ac:spMk id="41" creationId="{D2529630-6003-4D16-884B-9E1AB761ED34}"/>
          </ac:spMkLst>
        </pc:spChg>
        <pc:spChg chg="add mod">
          <ac:chgData name="Tekle Pauzaite" userId="06f7e524-8501-4f81-9b2a-484f6f2c7061" providerId="ADAL" clId="{8E5480CC-6F87-4B3E-88EB-9BB047D963B1}" dt="2024-04-03T08:13:09.468" v="271" actId="14100"/>
          <ac:spMkLst>
            <pc:docMk/>
            <pc:sldMk cId="2197820951" sldId="257"/>
            <ac:spMk id="43" creationId="{FAEB797B-026A-4FBA-9A26-F487BDAE0B1A}"/>
          </ac:spMkLst>
        </pc:spChg>
        <pc:spChg chg="add mod">
          <ac:chgData name="Tekle Pauzaite" userId="06f7e524-8501-4f81-9b2a-484f6f2c7061" providerId="ADAL" clId="{8E5480CC-6F87-4B3E-88EB-9BB047D963B1}" dt="2024-04-03T08:13:41.860" v="282" actId="14100"/>
          <ac:spMkLst>
            <pc:docMk/>
            <pc:sldMk cId="2197820951" sldId="257"/>
            <ac:spMk id="45" creationId="{603B9E2E-ED3E-4B75-AA33-B9A3166CAA56}"/>
          </ac:spMkLst>
        </pc:spChg>
        <pc:spChg chg="add mod">
          <ac:chgData name="Tekle Pauzaite" userId="06f7e524-8501-4f81-9b2a-484f6f2c7061" providerId="ADAL" clId="{8E5480CC-6F87-4B3E-88EB-9BB047D963B1}" dt="2024-04-03T08:14:16.427" v="300" actId="14100"/>
          <ac:spMkLst>
            <pc:docMk/>
            <pc:sldMk cId="2197820951" sldId="257"/>
            <ac:spMk id="47" creationId="{A0DD897C-565B-421A-8D55-E02D458DB462}"/>
          </ac:spMkLst>
        </pc:spChg>
        <pc:spChg chg="add mod">
          <ac:chgData name="Tekle Pauzaite" userId="06f7e524-8501-4f81-9b2a-484f6f2c7061" providerId="ADAL" clId="{8E5480CC-6F87-4B3E-88EB-9BB047D963B1}" dt="2024-04-03T08:14:21.244" v="301" actId="571"/>
          <ac:spMkLst>
            <pc:docMk/>
            <pc:sldMk cId="2197820951" sldId="257"/>
            <ac:spMk id="48" creationId="{676DF236-8577-464C-AB2F-BF9E7A09147F}"/>
          </ac:spMkLst>
        </pc:spChg>
        <pc:spChg chg="add mod">
          <ac:chgData name="Tekle Pauzaite" userId="06f7e524-8501-4f81-9b2a-484f6f2c7061" providerId="ADAL" clId="{8E5480CC-6F87-4B3E-88EB-9BB047D963B1}" dt="2024-04-03T08:14:25.748" v="302" actId="571"/>
          <ac:spMkLst>
            <pc:docMk/>
            <pc:sldMk cId="2197820951" sldId="257"/>
            <ac:spMk id="49" creationId="{C0A70594-FBF9-4D77-9EAA-5DFA5C83E853}"/>
          </ac:spMkLst>
        </pc:spChg>
        <pc:spChg chg="add mod">
          <ac:chgData name="Tekle Pauzaite" userId="06f7e524-8501-4f81-9b2a-484f6f2c7061" providerId="ADAL" clId="{8E5480CC-6F87-4B3E-88EB-9BB047D963B1}" dt="2024-04-03T08:14:34.163" v="303" actId="571"/>
          <ac:spMkLst>
            <pc:docMk/>
            <pc:sldMk cId="2197820951" sldId="257"/>
            <ac:spMk id="50" creationId="{EE113162-22A4-4495-AE28-E2ED2C6D09D1}"/>
          </ac:spMkLst>
        </pc:spChg>
        <pc:spChg chg="add mod">
          <ac:chgData name="Tekle Pauzaite" userId="06f7e524-8501-4f81-9b2a-484f6f2c7061" providerId="ADAL" clId="{8E5480CC-6F87-4B3E-88EB-9BB047D963B1}" dt="2024-04-03T08:14:37.356" v="304" actId="571"/>
          <ac:spMkLst>
            <pc:docMk/>
            <pc:sldMk cId="2197820951" sldId="257"/>
            <ac:spMk id="51" creationId="{9ECDFC7E-A874-4DB7-B456-93ABA83D12AC}"/>
          </ac:spMkLst>
        </pc:spChg>
        <pc:grpChg chg="add del mod">
          <ac:chgData name="Tekle Pauzaite" userId="06f7e524-8501-4f81-9b2a-484f6f2c7061" providerId="ADAL" clId="{8E5480CC-6F87-4B3E-88EB-9BB047D963B1}" dt="2024-04-03T08:11:55.053" v="242" actId="165"/>
          <ac:grpSpMkLst>
            <pc:docMk/>
            <pc:sldMk cId="2197820951" sldId="257"/>
            <ac:grpSpMk id="2" creationId="{B93EF312-87B0-45FF-A98C-93415FEEFD07}"/>
          </ac:grpSpMkLst>
        </pc:grpChg>
        <pc:picChg chg="mod topLvl">
          <ac:chgData name="Tekle Pauzaite" userId="06f7e524-8501-4f81-9b2a-484f6f2c7061" providerId="ADAL" clId="{8E5480CC-6F87-4B3E-88EB-9BB047D963B1}" dt="2024-04-03T08:11:55.053" v="242" actId="165"/>
          <ac:picMkLst>
            <pc:docMk/>
            <pc:sldMk cId="2197820951" sldId="257"/>
            <ac:picMk id="6" creationId="{21918E86-BE87-4220-86E6-C83638643CBF}"/>
          </ac:picMkLst>
        </pc:picChg>
        <pc:picChg chg="mod topLvl">
          <ac:chgData name="Tekle Pauzaite" userId="06f7e524-8501-4f81-9b2a-484f6f2c7061" providerId="ADAL" clId="{8E5480CC-6F87-4B3E-88EB-9BB047D963B1}" dt="2024-04-03T08:11:55.053" v="242" actId="165"/>
          <ac:picMkLst>
            <pc:docMk/>
            <pc:sldMk cId="2197820951" sldId="257"/>
            <ac:picMk id="7" creationId="{87A13BA2-D507-46EE-BE04-4068C9FD5156}"/>
          </ac:picMkLst>
        </pc:picChg>
        <pc:picChg chg="mod topLvl">
          <ac:chgData name="Tekle Pauzaite" userId="06f7e524-8501-4f81-9b2a-484f6f2c7061" providerId="ADAL" clId="{8E5480CC-6F87-4B3E-88EB-9BB047D963B1}" dt="2024-04-03T08:11:55.053" v="242" actId="165"/>
          <ac:picMkLst>
            <pc:docMk/>
            <pc:sldMk cId="2197820951" sldId="257"/>
            <ac:picMk id="8" creationId="{A573096E-BD92-490F-867E-BE21AAAFBB4C}"/>
          </ac:picMkLst>
        </pc:picChg>
        <pc:picChg chg="mod topLvl">
          <ac:chgData name="Tekle Pauzaite" userId="06f7e524-8501-4f81-9b2a-484f6f2c7061" providerId="ADAL" clId="{8E5480CC-6F87-4B3E-88EB-9BB047D963B1}" dt="2024-04-03T08:11:55.053" v="242" actId="165"/>
          <ac:picMkLst>
            <pc:docMk/>
            <pc:sldMk cId="2197820951" sldId="257"/>
            <ac:picMk id="27" creationId="{A5A369B1-2DE8-41D0-A447-55418B1DB682}"/>
          </ac:picMkLst>
        </pc:picChg>
        <pc:picChg chg="add mod modCrop">
          <ac:chgData name="Tekle Pauzaite" userId="06f7e524-8501-4f81-9b2a-484f6f2c7061" providerId="ADAL" clId="{8E5480CC-6F87-4B3E-88EB-9BB047D963B1}" dt="2024-04-03T08:12:14.908" v="252" actId="1076"/>
          <ac:picMkLst>
            <pc:docMk/>
            <pc:sldMk cId="2197820951" sldId="257"/>
            <ac:picMk id="40" creationId="{F951747A-A0D7-4094-A424-B36EEBE09C2D}"/>
          </ac:picMkLst>
        </pc:picChg>
        <pc:picChg chg="add mod modCrop">
          <ac:chgData name="Tekle Pauzaite" userId="06f7e524-8501-4f81-9b2a-484f6f2c7061" providerId="ADAL" clId="{8E5480CC-6F87-4B3E-88EB-9BB047D963B1}" dt="2024-04-03T08:12:59.563" v="269" actId="1076"/>
          <ac:picMkLst>
            <pc:docMk/>
            <pc:sldMk cId="2197820951" sldId="257"/>
            <ac:picMk id="42" creationId="{16CC2216-B445-4694-9E11-2290B1CFF3B6}"/>
          </ac:picMkLst>
        </pc:picChg>
        <pc:picChg chg="add mod modCrop">
          <ac:chgData name="Tekle Pauzaite" userId="06f7e524-8501-4f81-9b2a-484f6f2c7061" providerId="ADAL" clId="{8E5480CC-6F87-4B3E-88EB-9BB047D963B1}" dt="2024-04-03T08:13:29.499" v="280" actId="1076"/>
          <ac:picMkLst>
            <pc:docMk/>
            <pc:sldMk cId="2197820951" sldId="257"/>
            <ac:picMk id="44" creationId="{D5B5C734-60E0-41BE-B84F-EBE3683BBF8C}"/>
          </ac:picMkLst>
        </pc:picChg>
        <pc:picChg chg="add mod modCrop">
          <ac:chgData name="Tekle Pauzaite" userId="06f7e524-8501-4f81-9b2a-484f6f2c7061" providerId="ADAL" clId="{8E5480CC-6F87-4B3E-88EB-9BB047D963B1}" dt="2024-04-03T08:14:07.364" v="298" actId="1076"/>
          <ac:picMkLst>
            <pc:docMk/>
            <pc:sldMk cId="2197820951" sldId="257"/>
            <ac:picMk id="46" creationId="{CD248093-9F2D-4A1B-AC0D-AE8B1FDB532C}"/>
          </ac:picMkLst>
        </pc:picChg>
        <pc:cxnChg chg="mod topLvl">
          <ac:chgData name="Tekle Pauzaite" userId="06f7e524-8501-4f81-9b2a-484f6f2c7061" providerId="ADAL" clId="{8E5480CC-6F87-4B3E-88EB-9BB047D963B1}" dt="2024-04-03T08:11:55.053" v="242" actId="165"/>
          <ac:cxnSpMkLst>
            <pc:docMk/>
            <pc:sldMk cId="2197820951" sldId="257"/>
            <ac:cxnSpMk id="11" creationId="{E1BB7094-4764-4918-9A0A-4436ECD2315E}"/>
          </ac:cxnSpMkLst>
        </pc:cxnChg>
        <pc:cxnChg chg="mod topLvl">
          <ac:chgData name="Tekle Pauzaite" userId="06f7e524-8501-4f81-9b2a-484f6f2c7061" providerId="ADAL" clId="{8E5480CC-6F87-4B3E-88EB-9BB047D963B1}" dt="2024-04-03T08:11:55.053" v="242" actId="165"/>
          <ac:cxnSpMkLst>
            <pc:docMk/>
            <pc:sldMk cId="2197820951" sldId="257"/>
            <ac:cxnSpMk id="21" creationId="{03141683-21A3-4EAA-83A9-52BEE9505251}"/>
          </ac:cxnSpMkLst>
        </pc:cxnChg>
        <pc:cxnChg chg="mod topLvl">
          <ac:chgData name="Tekle Pauzaite" userId="06f7e524-8501-4f81-9b2a-484f6f2c7061" providerId="ADAL" clId="{8E5480CC-6F87-4B3E-88EB-9BB047D963B1}" dt="2024-04-03T08:11:55.053" v="242" actId="165"/>
          <ac:cxnSpMkLst>
            <pc:docMk/>
            <pc:sldMk cId="2197820951" sldId="257"/>
            <ac:cxnSpMk id="28" creationId="{E70395FC-C5D7-48AF-9F8F-3AD10D8C1E10}"/>
          </ac:cxnSpMkLst>
        </pc:cxnChg>
        <pc:cxnChg chg="mod topLvl">
          <ac:chgData name="Tekle Pauzaite" userId="06f7e524-8501-4f81-9b2a-484f6f2c7061" providerId="ADAL" clId="{8E5480CC-6F87-4B3E-88EB-9BB047D963B1}" dt="2024-04-03T08:11:55.053" v="242" actId="165"/>
          <ac:cxnSpMkLst>
            <pc:docMk/>
            <pc:sldMk cId="2197820951" sldId="257"/>
            <ac:cxnSpMk id="29" creationId="{E35A8350-B2B9-47A3-9786-DF24C7AE40D4}"/>
          </ac:cxnSpMkLst>
        </pc:cxnChg>
        <pc:cxnChg chg="mod topLvl">
          <ac:chgData name="Tekle Pauzaite" userId="06f7e524-8501-4f81-9b2a-484f6f2c7061" providerId="ADAL" clId="{8E5480CC-6F87-4B3E-88EB-9BB047D963B1}" dt="2024-04-03T08:11:55.053" v="242" actId="165"/>
          <ac:cxnSpMkLst>
            <pc:docMk/>
            <pc:sldMk cId="2197820951" sldId="257"/>
            <ac:cxnSpMk id="30" creationId="{4EDBAD88-B45E-4F8A-B12D-4F58FEA1AFD0}"/>
          </ac:cxnSpMkLst>
        </pc:cxnChg>
        <pc:cxnChg chg="mod topLvl">
          <ac:chgData name="Tekle Pauzaite" userId="06f7e524-8501-4f81-9b2a-484f6f2c7061" providerId="ADAL" clId="{8E5480CC-6F87-4B3E-88EB-9BB047D963B1}" dt="2024-04-03T08:11:55.053" v="242" actId="165"/>
          <ac:cxnSpMkLst>
            <pc:docMk/>
            <pc:sldMk cId="2197820951" sldId="257"/>
            <ac:cxnSpMk id="33" creationId="{172B3497-35B1-4030-9F04-D85531B8E1DB}"/>
          </ac:cxnSpMkLst>
        </pc:cxnChg>
        <pc:cxnChg chg="mod topLvl">
          <ac:chgData name="Tekle Pauzaite" userId="06f7e524-8501-4f81-9b2a-484f6f2c7061" providerId="ADAL" clId="{8E5480CC-6F87-4B3E-88EB-9BB047D963B1}" dt="2024-04-03T08:11:55.053" v="242" actId="165"/>
          <ac:cxnSpMkLst>
            <pc:docMk/>
            <pc:sldMk cId="2197820951" sldId="257"/>
            <ac:cxnSpMk id="34" creationId="{6D58F144-1DE3-4AC0-AEE1-48ED2D59AF3E}"/>
          </ac:cxnSpMkLst>
        </pc:cxnChg>
        <pc:cxnChg chg="mod topLvl">
          <ac:chgData name="Tekle Pauzaite" userId="06f7e524-8501-4f81-9b2a-484f6f2c7061" providerId="ADAL" clId="{8E5480CC-6F87-4B3E-88EB-9BB047D963B1}" dt="2024-04-03T08:11:55.053" v="242" actId="165"/>
          <ac:cxnSpMkLst>
            <pc:docMk/>
            <pc:sldMk cId="2197820951" sldId="257"/>
            <ac:cxnSpMk id="37" creationId="{2FEAACEA-E92E-4444-98DF-DC672897F4E0}"/>
          </ac:cxnSpMkLst>
        </pc:cxnChg>
        <pc:cxnChg chg="mod topLvl">
          <ac:chgData name="Tekle Pauzaite" userId="06f7e524-8501-4f81-9b2a-484f6f2c7061" providerId="ADAL" clId="{8E5480CC-6F87-4B3E-88EB-9BB047D963B1}" dt="2024-04-03T08:11:55.053" v="242" actId="165"/>
          <ac:cxnSpMkLst>
            <pc:docMk/>
            <pc:sldMk cId="2197820951" sldId="257"/>
            <ac:cxnSpMk id="38" creationId="{38CA4D55-C2D8-4A81-98FE-3BDBA1A7EDBD}"/>
          </ac:cxnSpMkLst>
        </pc:cxnChg>
      </pc:sldChg>
      <pc:sldChg chg="addSp delSp modSp add">
        <pc:chgData name="Tekle Pauzaite" userId="06f7e524-8501-4f81-9b2a-484f6f2c7061" providerId="ADAL" clId="{8E5480CC-6F87-4B3E-88EB-9BB047D963B1}" dt="2024-04-03T08:19:00.379" v="412" actId="571"/>
        <pc:sldMkLst>
          <pc:docMk/>
          <pc:sldMk cId="3478909876" sldId="258"/>
        </pc:sldMkLst>
        <pc:spChg chg="add mod">
          <ac:chgData name="Tekle Pauzaite" userId="06f7e524-8501-4f81-9b2a-484f6f2c7061" providerId="ADAL" clId="{8E5480CC-6F87-4B3E-88EB-9BB047D963B1}" dt="2024-04-03T08:14:47.540" v="306" actId="1076"/>
          <ac:spMkLst>
            <pc:docMk/>
            <pc:sldMk cId="3478909876" sldId="258"/>
            <ac:spMk id="2" creationId="{C219F376-6AC5-4313-AB76-05D3AB71351A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4" creationId="{E77124CB-7F61-48DE-9291-3C046CFB5368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5" creationId="{7EF123B8-DFC2-41B1-A4A3-216CC71B51FB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6" creationId="{FFE2F6A5-8B40-4B93-8D73-83672AD22B94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7" creationId="{DE07FCAF-360A-4159-A639-F483815A660F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9" creationId="{AA474611-44E2-4A87-A613-A781AEE679AB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0" creationId="{CFE87A2D-ED16-44EE-A1BC-C2F8A9A96CE3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1" creationId="{9D6DFF50-54E8-43F1-B1D6-C0E5677579CE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2" creationId="{A1ACD153-FD9E-418D-BDC9-2893F8AF8D96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3" creationId="{7EC5CCF1-FB6A-4D6E-B9BB-DB9254CD9B1B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4" creationId="{86CB8C0B-365C-472B-9BD5-41A1607966A9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5" creationId="{4E26D758-4A01-49E4-A44D-6681755905E3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6" creationId="{9547CD9A-22AE-477E-962C-66D333098F75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7" creationId="{D9380862-57EF-45FB-964C-4D1A197E847B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8" creationId="{60176208-B9B6-49BF-BF8F-8D16DC151A02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19" creationId="{DFEDE59B-0672-4504-8FF9-33CDD9960CC8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20" creationId="{7FB0403A-3637-48B6-BCBA-A5CE399374E2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21" creationId="{76D2A5F6-16E5-47C8-894E-EF10E11F3D41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23" creationId="{F25AF3B6-920E-4EBE-8462-FCF1ED5CF227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24" creationId="{03FAF14A-7386-4590-820C-BF1A8F8DDDB0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25" creationId="{4D117203-9805-43F4-8966-CEA08EBF8263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26" creationId="{A10BE83F-55C8-4916-A471-960AAA988DD2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27" creationId="{E0E3CC02-0A60-40A3-A00A-75BFF06AABD6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28" creationId="{44689B0D-CD1D-4C18-8B92-4209BFF2BD69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29" creationId="{B4A0EC5E-98C3-499C-B3A2-48B677FC5880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30" creationId="{6066A984-3BCF-4C8B-A896-48CF4328E34A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31" creationId="{1E68201C-6511-47C9-9C27-D0476C31886B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32" creationId="{231A4D37-C9FA-4BF5-912F-16CD7C777BF1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33" creationId="{464969D9-CC86-4775-B7B9-5BD5E2C78FBC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40" creationId="{74E15099-8C98-4AC8-B954-D5759F5BC7C7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41" creationId="{D4599040-E771-4E40-A608-EE8474746D53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44" creationId="{2942628A-4FAF-4DA7-BFD8-99D864EA9F25}"/>
          </ac:spMkLst>
        </pc:spChg>
        <pc:spChg chg="mod topLvl">
          <ac:chgData name="Tekle Pauzaite" userId="06f7e524-8501-4f81-9b2a-484f6f2c7061" providerId="ADAL" clId="{8E5480CC-6F87-4B3E-88EB-9BB047D963B1}" dt="2024-04-03T08:14:50.797" v="307" actId="165"/>
          <ac:spMkLst>
            <pc:docMk/>
            <pc:sldMk cId="3478909876" sldId="258"/>
            <ac:spMk id="46" creationId="{C2654015-51DC-439F-B679-0DDF0BACDAA2}"/>
          </ac:spMkLst>
        </pc:spChg>
        <pc:spChg chg="add mod">
          <ac:chgData name="Tekle Pauzaite" userId="06f7e524-8501-4f81-9b2a-484f6f2c7061" providerId="ADAL" clId="{8E5480CC-6F87-4B3E-88EB-9BB047D963B1}" dt="2024-04-03T08:15:19.724" v="323" actId="14100"/>
          <ac:spMkLst>
            <pc:docMk/>
            <pc:sldMk cId="3478909876" sldId="258"/>
            <ac:spMk id="48" creationId="{B5185257-9DB7-478F-8180-F590824DA222}"/>
          </ac:spMkLst>
        </pc:spChg>
        <pc:spChg chg="add mod">
          <ac:chgData name="Tekle Pauzaite" userId="06f7e524-8501-4f81-9b2a-484f6f2c7061" providerId="ADAL" clId="{8E5480CC-6F87-4B3E-88EB-9BB047D963B1}" dt="2024-04-03T08:15:45.019" v="337" actId="571"/>
          <ac:spMkLst>
            <pc:docMk/>
            <pc:sldMk cId="3478909876" sldId="258"/>
            <ac:spMk id="50" creationId="{25D9928E-5627-44A1-B5B5-012852501E1E}"/>
          </ac:spMkLst>
        </pc:spChg>
        <pc:spChg chg="add mod">
          <ac:chgData name="Tekle Pauzaite" userId="06f7e524-8501-4f81-9b2a-484f6f2c7061" providerId="ADAL" clId="{8E5480CC-6F87-4B3E-88EB-9BB047D963B1}" dt="2024-04-03T08:16:20.732" v="353" actId="571"/>
          <ac:spMkLst>
            <pc:docMk/>
            <pc:sldMk cId="3478909876" sldId="258"/>
            <ac:spMk id="52" creationId="{89C2741B-64F1-4BCC-BB94-AFDA50B3D541}"/>
          </ac:spMkLst>
        </pc:spChg>
        <pc:spChg chg="add mod">
          <ac:chgData name="Tekle Pauzaite" userId="06f7e524-8501-4f81-9b2a-484f6f2c7061" providerId="ADAL" clId="{8E5480CC-6F87-4B3E-88EB-9BB047D963B1}" dt="2024-04-03T08:17:03.107" v="378" actId="14100"/>
          <ac:spMkLst>
            <pc:docMk/>
            <pc:sldMk cId="3478909876" sldId="258"/>
            <ac:spMk id="54" creationId="{A8A75E76-E980-4008-AB1F-2947C1DF19D8}"/>
          </ac:spMkLst>
        </pc:spChg>
        <pc:spChg chg="add mod">
          <ac:chgData name="Tekle Pauzaite" userId="06f7e524-8501-4f81-9b2a-484f6f2c7061" providerId="ADAL" clId="{8E5480CC-6F87-4B3E-88EB-9BB047D963B1}" dt="2024-04-03T08:17:45.572" v="392" actId="571"/>
          <ac:spMkLst>
            <pc:docMk/>
            <pc:sldMk cId="3478909876" sldId="258"/>
            <ac:spMk id="56" creationId="{2EA82ACF-CD5A-466D-99C1-343D79861360}"/>
          </ac:spMkLst>
        </pc:spChg>
        <pc:spChg chg="add mod">
          <ac:chgData name="Tekle Pauzaite" userId="06f7e524-8501-4f81-9b2a-484f6f2c7061" providerId="ADAL" clId="{8E5480CC-6F87-4B3E-88EB-9BB047D963B1}" dt="2024-04-03T08:18:33.540" v="406" actId="571"/>
          <ac:spMkLst>
            <pc:docMk/>
            <pc:sldMk cId="3478909876" sldId="258"/>
            <ac:spMk id="58" creationId="{56D24C79-3F32-438C-9C12-E93C1EE8D4FA}"/>
          </ac:spMkLst>
        </pc:spChg>
        <pc:spChg chg="add mod">
          <ac:chgData name="Tekle Pauzaite" userId="06f7e524-8501-4f81-9b2a-484f6f2c7061" providerId="ADAL" clId="{8E5480CC-6F87-4B3E-88EB-9BB047D963B1}" dt="2024-04-03T08:18:42.556" v="407" actId="571"/>
          <ac:spMkLst>
            <pc:docMk/>
            <pc:sldMk cId="3478909876" sldId="258"/>
            <ac:spMk id="59" creationId="{31DF3DA2-E8BC-443B-B864-A1CCC2BB237F}"/>
          </ac:spMkLst>
        </pc:spChg>
        <pc:spChg chg="add mod">
          <ac:chgData name="Tekle Pauzaite" userId="06f7e524-8501-4f81-9b2a-484f6f2c7061" providerId="ADAL" clId="{8E5480CC-6F87-4B3E-88EB-9BB047D963B1}" dt="2024-04-03T08:18:45.948" v="408" actId="571"/>
          <ac:spMkLst>
            <pc:docMk/>
            <pc:sldMk cId="3478909876" sldId="258"/>
            <ac:spMk id="60" creationId="{DDF1B60F-5246-4CC9-A5F1-62AD3ACD1415}"/>
          </ac:spMkLst>
        </pc:spChg>
        <pc:spChg chg="add mod">
          <ac:chgData name="Tekle Pauzaite" userId="06f7e524-8501-4f81-9b2a-484f6f2c7061" providerId="ADAL" clId="{8E5480CC-6F87-4B3E-88EB-9BB047D963B1}" dt="2024-04-03T08:18:50.228" v="409" actId="571"/>
          <ac:spMkLst>
            <pc:docMk/>
            <pc:sldMk cId="3478909876" sldId="258"/>
            <ac:spMk id="61" creationId="{22959A97-E075-4A0A-A921-2BB944CE9A72}"/>
          </ac:spMkLst>
        </pc:spChg>
        <pc:spChg chg="add mod">
          <ac:chgData name="Tekle Pauzaite" userId="06f7e524-8501-4f81-9b2a-484f6f2c7061" providerId="ADAL" clId="{8E5480CC-6F87-4B3E-88EB-9BB047D963B1}" dt="2024-04-03T08:18:53.436" v="410" actId="571"/>
          <ac:spMkLst>
            <pc:docMk/>
            <pc:sldMk cId="3478909876" sldId="258"/>
            <ac:spMk id="62" creationId="{48A2DF24-F10F-42FE-97CD-8514B57E1A39}"/>
          </ac:spMkLst>
        </pc:spChg>
        <pc:spChg chg="add mod">
          <ac:chgData name="Tekle Pauzaite" userId="06f7e524-8501-4f81-9b2a-484f6f2c7061" providerId="ADAL" clId="{8E5480CC-6F87-4B3E-88EB-9BB047D963B1}" dt="2024-04-03T08:18:56.924" v="411" actId="571"/>
          <ac:spMkLst>
            <pc:docMk/>
            <pc:sldMk cId="3478909876" sldId="258"/>
            <ac:spMk id="63" creationId="{78C4E259-1632-4015-98B8-38C371F6493E}"/>
          </ac:spMkLst>
        </pc:spChg>
        <pc:spChg chg="add mod">
          <ac:chgData name="Tekle Pauzaite" userId="06f7e524-8501-4f81-9b2a-484f6f2c7061" providerId="ADAL" clId="{8E5480CC-6F87-4B3E-88EB-9BB047D963B1}" dt="2024-04-03T08:19:00.379" v="412" actId="571"/>
          <ac:spMkLst>
            <pc:docMk/>
            <pc:sldMk cId="3478909876" sldId="258"/>
            <ac:spMk id="64" creationId="{FFBC237D-1D02-4ACF-A545-019FF8A45524}"/>
          </ac:spMkLst>
        </pc:spChg>
        <pc:grpChg chg="add del mod">
          <ac:chgData name="Tekle Pauzaite" userId="06f7e524-8501-4f81-9b2a-484f6f2c7061" providerId="ADAL" clId="{8E5480CC-6F87-4B3E-88EB-9BB047D963B1}" dt="2024-04-03T08:14:50.797" v="307" actId="165"/>
          <ac:grpSpMkLst>
            <pc:docMk/>
            <pc:sldMk cId="3478909876" sldId="258"/>
            <ac:grpSpMk id="3" creationId="{B7D79DE7-F96E-4EB9-9C57-49094B97F6A5}"/>
          </ac:grpSpMkLst>
        </pc:grpChg>
        <pc:picChg chg="mod topLvl">
          <ac:chgData name="Tekle Pauzaite" userId="06f7e524-8501-4f81-9b2a-484f6f2c7061" providerId="ADAL" clId="{8E5480CC-6F87-4B3E-88EB-9BB047D963B1}" dt="2024-04-03T08:14:50.797" v="307" actId="165"/>
          <ac:picMkLst>
            <pc:docMk/>
            <pc:sldMk cId="3478909876" sldId="258"/>
            <ac:picMk id="34" creationId="{FFEF1708-8396-4F50-810A-34AB5C6DFB7E}"/>
          </ac:picMkLst>
        </pc:picChg>
        <pc:picChg chg="mod topLvl">
          <ac:chgData name="Tekle Pauzaite" userId="06f7e524-8501-4f81-9b2a-484f6f2c7061" providerId="ADAL" clId="{8E5480CC-6F87-4B3E-88EB-9BB047D963B1}" dt="2024-04-03T08:14:50.797" v="307" actId="165"/>
          <ac:picMkLst>
            <pc:docMk/>
            <pc:sldMk cId="3478909876" sldId="258"/>
            <ac:picMk id="35" creationId="{6A3A881E-EE2B-4827-A8F9-A78DE5062A80}"/>
          </ac:picMkLst>
        </pc:picChg>
        <pc:picChg chg="mod topLvl">
          <ac:chgData name="Tekle Pauzaite" userId="06f7e524-8501-4f81-9b2a-484f6f2c7061" providerId="ADAL" clId="{8E5480CC-6F87-4B3E-88EB-9BB047D963B1}" dt="2024-04-03T08:14:50.797" v="307" actId="165"/>
          <ac:picMkLst>
            <pc:docMk/>
            <pc:sldMk cId="3478909876" sldId="258"/>
            <ac:picMk id="36" creationId="{ADB44F98-DC3B-4A07-A992-F81AACA08640}"/>
          </ac:picMkLst>
        </pc:picChg>
        <pc:picChg chg="mod topLvl">
          <ac:chgData name="Tekle Pauzaite" userId="06f7e524-8501-4f81-9b2a-484f6f2c7061" providerId="ADAL" clId="{8E5480CC-6F87-4B3E-88EB-9BB047D963B1}" dt="2024-04-03T08:14:50.797" v="307" actId="165"/>
          <ac:picMkLst>
            <pc:docMk/>
            <pc:sldMk cId="3478909876" sldId="258"/>
            <ac:picMk id="37" creationId="{A6AAFB52-896D-40ED-80AB-D815F07753C1}"/>
          </ac:picMkLst>
        </pc:picChg>
        <pc:picChg chg="mod topLvl">
          <ac:chgData name="Tekle Pauzaite" userId="06f7e524-8501-4f81-9b2a-484f6f2c7061" providerId="ADAL" clId="{8E5480CC-6F87-4B3E-88EB-9BB047D963B1}" dt="2024-04-03T08:14:50.797" v="307" actId="165"/>
          <ac:picMkLst>
            <pc:docMk/>
            <pc:sldMk cId="3478909876" sldId="258"/>
            <ac:picMk id="38" creationId="{ED727F6A-E77C-4D93-9703-DDC5D67F693A}"/>
          </ac:picMkLst>
        </pc:picChg>
        <pc:picChg chg="mod topLvl">
          <ac:chgData name="Tekle Pauzaite" userId="06f7e524-8501-4f81-9b2a-484f6f2c7061" providerId="ADAL" clId="{8E5480CC-6F87-4B3E-88EB-9BB047D963B1}" dt="2024-04-03T08:14:50.797" v="307" actId="165"/>
          <ac:picMkLst>
            <pc:docMk/>
            <pc:sldMk cId="3478909876" sldId="258"/>
            <ac:picMk id="39" creationId="{9F3621E6-96A1-4A39-BD07-3A90EC5CDDFF}"/>
          </ac:picMkLst>
        </pc:picChg>
        <pc:picChg chg="add mod modCrop">
          <ac:chgData name="Tekle Pauzaite" userId="06f7e524-8501-4f81-9b2a-484f6f2c7061" providerId="ADAL" clId="{8E5480CC-6F87-4B3E-88EB-9BB047D963B1}" dt="2024-04-03T08:15:08.779" v="320" actId="1076"/>
          <ac:picMkLst>
            <pc:docMk/>
            <pc:sldMk cId="3478909876" sldId="258"/>
            <ac:picMk id="47" creationId="{C7D9E36B-7224-411F-A929-7B53A47F3C8B}"/>
          </ac:picMkLst>
        </pc:picChg>
        <pc:picChg chg="add mod modCrop">
          <ac:chgData name="Tekle Pauzaite" userId="06f7e524-8501-4f81-9b2a-484f6f2c7061" providerId="ADAL" clId="{8E5480CC-6F87-4B3E-88EB-9BB047D963B1}" dt="2024-04-03T08:15:38.356" v="336" actId="1076"/>
          <ac:picMkLst>
            <pc:docMk/>
            <pc:sldMk cId="3478909876" sldId="258"/>
            <ac:picMk id="49" creationId="{856C9402-2C6E-452B-B346-1D3C39E8D99C}"/>
          </ac:picMkLst>
        </pc:picChg>
        <pc:picChg chg="add mod modCrop">
          <ac:chgData name="Tekle Pauzaite" userId="06f7e524-8501-4f81-9b2a-484f6f2c7061" providerId="ADAL" clId="{8E5480CC-6F87-4B3E-88EB-9BB047D963B1}" dt="2024-04-03T08:16:09.339" v="352" actId="1076"/>
          <ac:picMkLst>
            <pc:docMk/>
            <pc:sldMk cId="3478909876" sldId="258"/>
            <ac:picMk id="51" creationId="{FF63E569-5736-43B6-AD3B-3BC714D5EE30}"/>
          </ac:picMkLst>
        </pc:picChg>
        <pc:picChg chg="add mod modCrop">
          <ac:chgData name="Tekle Pauzaite" userId="06f7e524-8501-4f81-9b2a-484f6f2c7061" providerId="ADAL" clId="{8E5480CC-6F87-4B3E-88EB-9BB047D963B1}" dt="2024-04-03T08:16:46.082" v="374" actId="1076"/>
          <ac:picMkLst>
            <pc:docMk/>
            <pc:sldMk cId="3478909876" sldId="258"/>
            <ac:picMk id="53" creationId="{FA223F06-9C36-4371-9963-91CF67074457}"/>
          </ac:picMkLst>
        </pc:picChg>
        <pc:picChg chg="add mod modCrop">
          <ac:chgData name="Tekle Pauzaite" userId="06f7e524-8501-4f81-9b2a-484f6f2c7061" providerId="ADAL" clId="{8E5480CC-6F87-4B3E-88EB-9BB047D963B1}" dt="2024-04-03T08:17:38.283" v="391" actId="1076"/>
          <ac:picMkLst>
            <pc:docMk/>
            <pc:sldMk cId="3478909876" sldId="258"/>
            <ac:picMk id="55" creationId="{C52960BB-7450-4807-8628-D62BEF09C058}"/>
          </ac:picMkLst>
        </pc:picChg>
        <pc:picChg chg="add mod modCrop">
          <ac:chgData name="Tekle Pauzaite" userId="06f7e524-8501-4f81-9b2a-484f6f2c7061" providerId="ADAL" clId="{8E5480CC-6F87-4B3E-88EB-9BB047D963B1}" dt="2024-04-03T08:18:24.307" v="405" actId="1076"/>
          <ac:picMkLst>
            <pc:docMk/>
            <pc:sldMk cId="3478909876" sldId="258"/>
            <ac:picMk id="57" creationId="{3B6111FD-79A5-476A-BE76-DAB21002030A}"/>
          </ac:picMkLst>
        </pc:picChg>
        <pc:cxnChg chg="mod topLvl">
          <ac:chgData name="Tekle Pauzaite" userId="06f7e524-8501-4f81-9b2a-484f6f2c7061" providerId="ADAL" clId="{8E5480CC-6F87-4B3E-88EB-9BB047D963B1}" dt="2024-04-03T08:14:50.797" v="307" actId="165"/>
          <ac:cxnSpMkLst>
            <pc:docMk/>
            <pc:sldMk cId="3478909876" sldId="258"/>
            <ac:cxnSpMk id="8" creationId="{78AB177B-3AB1-4F51-A118-15637CD398F5}"/>
          </ac:cxnSpMkLst>
        </pc:cxnChg>
        <pc:cxnChg chg="mod topLvl">
          <ac:chgData name="Tekle Pauzaite" userId="06f7e524-8501-4f81-9b2a-484f6f2c7061" providerId="ADAL" clId="{8E5480CC-6F87-4B3E-88EB-9BB047D963B1}" dt="2024-04-03T08:14:50.797" v="307" actId="165"/>
          <ac:cxnSpMkLst>
            <pc:docMk/>
            <pc:sldMk cId="3478909876" sldId="258"/>
            <ac:cxnSpMk id="22" creationId="{7AD94663-A04D-4FF1-A950-2DAFDE9293E2}"/>
          </ac:cxnSpMkLst>
        </pc:cxnChg>
        <pc:cxnChg chg="mod topLvl">
          <ac:chgData name="Tekle Pauzaite" userId="06f7e524-8501-4f81-9b2a-484f6f2c7061" providerId="ADAL" clId="{8E5480CC-6F87-4B3E-88EB-9BB047D963B1}" dt="2024-04-03T08:14:50.797" v="307" actId="165"/>
          <ac:cxnSpMkLst>
            <pc:docMk/>
            <pc:sldMk cId="3478909876" sldId="258"/>
            <ac:cxnSpMk id="42" creationId="{617C13EE-2257-4338-B951-C2B890705BF6}"/>
          </ac:cxnSpMkLst>
        </pc:cxnChg>
        <pc:cxnChg chg="mod topLvl">
          <ac:chgData name="Tekle Pauzaite" userId="06f7e524-8501-4f81-9b2a-484f6f2c7061" providerId="ADAL" clId="{8E5480CC-6F87-4B3E-88EB-9BB047D963B1}" dt="2024-04-03T08:14:50.797" v="307" actId="165"/>
          <ac:cxnSpMkLst>
            <pc:docMk/>
            <pc:sldMk cId="3478909876" sldId="258"/>
            <ac:cxnSpMk id="43" creationId="{1391A7A1-6C27-4812-8373-69FD74376AB5}"/>
          </ac:cxnSpMkLst>
        </pc:cxnChg>
        <pc:cxnChg chg="mod topLvl">
          <ac:chgData name="Tekle Pauzaite" userId="06f7e524-8501-4f81-9b2a-484f6f2c7061" providerId="ADAL" clId="{8E5480CC-6F87-4B3E-88EB-9BB047D963B1}" dt="2024-04-03T08:14:50.797" v="307" actId="165"/>
          <ac:cxnSpMkLst>
            <pc:docMk/>
            <pc:sldMk cId="3478909876" sldId="258"/>
            <ac:cxnSpMk id="45" creationId="{13078D7D-2D88-47F4-8C2F-1A684AD59CC9}"/>
          </ac:cxnSpMkLst>
        </pc:cxnChg>
      </pc:sldChg>
      <pc:sldChg chg="addSp delSp modSp add">
        <pc:chgData name="Tekle Pauzaite" userId="06f7e524-8501-4f81-9b2a-484f6f2c7061" providerId="ADAL" clId="{8E5480CC-6F87-4B3E-88EB-9BB047D963B1}" dt="2024-04-03T08:26:15.931" v="477" actId="571"/>
        <pc:sldMkLst>
          <pc:docMk/>
          <pc:sldMk cId="4288970753" sldId="259"/>
        </pc:sldMkLst>
        <pc:spChg chg="add mod">
          <ac:chgData name="Tekle Pauzaite" userId="06f7e524-8501-4f81-9b2a-484f6f2c7061" providerId="ADAL" clId="{8E5480CC-6F87-4B3E-88EB-9BB047D963B1}" dt="2024-04-03T08:19:08.483" v="413" actId="1076"/>
          <ac:spMkLst>
            <pc:docMk/>
            <pc:sldMk cId="4288970753" sldId="259"/>
            <ac:spMk id="2" creationId="{F63C8866-C39C-4EFB-BB19-F2A318E3C28B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9" creationId="{C2F495DB-E401-40D0-BFAE-033361E41EA1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0" creationId="{CBD6C89C-8095-4A66-9BCA-1F559C3DE5D1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1" creationId="{5C95F9CC-D63C-461D-84FD-5CB2FADD3F88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2" creationId="{1AADEE6E-04FC-4B93-83CB-0E348AE22459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3" creationId="{084CB6EA-AC37-4DB1-924F-02494149CF6E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4" creationId="{16E3E24A-9DFB-45E0-BCA9-2F43662F97BF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5" creationId="{2114DDAC-4232-45AE-B6FB-5755AA7C820B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6" creationId="{FDA3F5C0-B86D-4264-A30F-4FBAF89813D4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7" creationId="{9121C06D-AA9A-48D0-95D3-54B485BB3173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8" creationId="{2A6093D7-D5D7-4B03-AE7F-408F6A9CD163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19" creationId="{57D5847E-054E-4319-9401-9DB12CCBA6ED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0" creationId="{8351F541-8C67-4C3D-B514-25CB8A988898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1" creationId="{793E1D1C-49CF-46F1-8D5D-664F7DFE145D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2" creationId="{C9A96721-7B0A-42F3-BD02-F3978615A650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3" creationId="{58E2950D-05C3-4C9A-9D4B-96E4C284491B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4" creationId="{A3F40CCC-8A17-4F53-BDEA-8F38A41F450F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5" creationId="{022F13DC-586F-4A6F-9FE3-7C15B37CF481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6" creationId="{F099B6D8-ABA8-4525-A0F2-4A9FFE79268B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7" creationId="{D40DF26D-592D-4E13-A04C-F99329108541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8" creationId="{7602E19E-E72F-45A3-94BB-B11277318118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29" creationId="{88209EB3-FE57-4266-BDF5-318A72AA9D68}"/>
          </ac:spMkLst>
        </pc:spChg>
        <pc:spChg chg="mod topLvl">
          <ac:chgData name="Tekle Pauzaite" userId="06f7e524-8501-4f81-9b2a-484f6f2c7061" providerId="ADAL" clId="{8E5480CC-6F87-4B3E-88EB-9BB047D963B1}" dt="2024-04-03T08:19:11.093" v="414" actId="165"/>
          <ac:spMkLst>
            <pc:docMk/>
            <pc:sldMk cId="4288970753" sldId="259"/>
            <ac:spMk id="34" creationId="{6107AFB6-4C10-4F38-AFCD-8ECB98335A5C}"/>
          </ac:spMkLst>
        </pc:spChg>
        <pc:spChg chg="add mod">
          <ac:chgData name="Tekle Pauzaite" userId="06f7e524-8501-4f81-9b2a-484f6f2c7061" providerId="ADAL" clId="{8E5480CC-6F87-4B3E-88EB-9BB047D963B1}" dt="2024-04-03T08:19:46.163" v="426" actId="14100"/>
          <ac:spMkLst>
            <pc:docMk/>
            <pc:sldMk cId="4288970753" sldId="259"/>
            <ac:spMk id="37" creationId="{24B08E6A-0994-451C-AB6C-AA0C25EBDFF0}"/>
          </ac:spMkLst>
        </pc:spChg>
        <pc:spChg chg="add mod">
          <ac:chgData name="Tekle Pauzaite" userId="06f7e524-8501-4f81-9b2a-484f6f2c7061" providerId="ADAL" clId="{8E5480CC-6F87-4B3E-88EB-9BB047D963B1}" dt="2024-04-03T08:20:22.923" v="439" actId="14100"/>
          <ac:spMkLst>
            <pc:docMk/>
            <pc:sldMk cId="4288970753" sldId="259"/>
            <ac:spMk id="39" creationId="{86B393F3-D1D9-4698-BDC3-E75DE86E949B}"/>
          </ac:spMkLst>
        </pc:spChg>
        <pc:spChg chg="add mod">
          <ac:chgData name="Tekle Pauzaite" userId="06f7e524-8501-4f81-9b2a-484f6f2c7061" providerId="ADAL" clId="{8E5480CC-6F87-4B3E-88EB-9BB047D963B1}" dt="2024-04-03T08:20:57.867" v="450" actId="571"/>
          <ac:spMkLst>
            <pc:docMk/>
            <pc:sldMk cId="4288970753" sldId="259"/>
            <ac:spMk id="41" creationId="{59BED9DD-ECA0-4301-8851-98A733490AAF}"/>
          </ac:spMkLst>
        </pc:spChg>
        <pc:spChg chg="add mod">
          <ac:chgData name="Tekle Pauzaite" userId="06f7e524-8501-4f81-9b2a-484f6f2c7061" providerId="ADAL" clId="{8E5480CC-6F87-4B3E-88EB-9BB047D963B1}" dt="2024-04-03T08:21:27.835" v="461" actId="571"/>
          <ac:spMkLst>
            <pc:docMk/>
            <pc:sldMk cId="4288970753" sldId="259"/>
            <ac:spMk id="43" creationId="{53DA2460-A384-4A1F-8194-0A21C8CAF746}"/>
          </ac:spMkLst>
        </pc:spChg>
        <pc:spChg chg="add mod">
          <ac:chgData name="Tekle Pauzaite" userId="06f7e524-8501-4f81-9b2a-484f6f2c7061" providerId="ADAL" clId="{8E5480CC-6F87-4B3E-88EB-9BB047D963B1}" dt="2024-04-03T08:25:55.564" v="472" actId="571"/>
          <ac:spMkLst>
            <pc:docMk/>
            <pc:sldMk cId="4288970753" sldId="259"/>
            <ac:spMk id="46" creationId="{B1BABE01-A5E8-45AE-B8E5-F0D445702B3B}"/>
          </ac:spMkLst>
        </pc:spChg>
        <pc:spChg chg="add mod">
          <ac:chgData name="Tekle Pauzaite" userId="06f7e524-8501-4f81-9b2a-484f6f2c7061" providerId="ADAL" clId="{8E5480CC-6F87-4B3E-88EB-9BB047D963B1}" dt="2024-04-03T08:25:58.867" v="473" actId="571"/>
          <ac:spMkLst>
            <pc:docMk/>
            <pc:sldMk cId="4288970753" sldId="259"/>
            <ac:spMk id="47" creationId="{C10B6347-AD0A-457F-85BD-CE8CC4EF8D66}"/>
          </ac:spMkLst>
        </pc:spChg>
        <pc:spChg chg="add mod">
          <ac:chgData name="Tekle Pauzaite" userId="06f7e524-8501-4f81-9b2a-484f6f2c7061" providerId="ADAL" clId="{8E5480CC-6F87-4B3E-88EB-9BB047D963B1}" dt="2024-04-03T08:26:01.443" v="474" actId="571"/>
          <ac:spMkLst>
            <pc:docMk/>
            <pc:sldMk cId="4288970753" sldId="259"/>
            <ac:spMk id="48" creationId="{AE3F7CF7-2026-440E-94E6-38FE863E6998}"/>
          </ac:spMkLst>
        </pc:spChg>
        <pc:spChg chg="add mod">
          <ac:chgData name="Tekle Pauzaite" userId="06f7e524-8501-4f81-9b2a-484f6f2c7061" providerId="ADAL" clId="{8E5480CC-6F87-4B3E-88EB-9BB047D963B1}" dt="2024-04-03T08:26:05.547" v="475" actId="571"/>
          <ac:spMkLst>
            <pc:docMk/>
            <pc:sldMk cId="4288970753" sldId="259"/>
            <ac:spMk id="49" creationId="{21F9218F-A4C6-481D-8384-2C729A8718DA}"/>
          </ac:spMkLst>
        </pc:spChg>
        <pc:spChg chg="add mod">
          <ac:chgData name="Tekle Pauzaite" userId="06f7e524-8501-4f81-9b2a-484f6f2c7061" providerId="ADAL" clId="{8E5480CC-6F87-4B3E-88EB-9BB047D963B1}" dt="2024-04-03T08:26:12.363" v="476" actId="571"/>
          <ac:spMkLst>
            <pc:docMk/>
            <pc:sldMk cId="4288970753" sldId="259"/>
            <ac:spMk id="50" creationId="{6253BD19-FF70-4BB3-A498-BA4F8106E874}"/>
          </ac:spMkLst>
        </pc:spChg>
        <pc:spChg chg="add mod">
          <ac:chgData name="Tekle Pauzaite" userId="06f7e524-8501-4f81-9b2a-484f6f2c7061" providerId="ADAL" clId="{8E5480CC-6F87-4B3E-88EB-9BB047D963B1}" dt="2024-04-03T08:26:15.931" v="477" actId="571"/>
          <ac:spMkLst>
            <pc:docMk/>
            <pc:sldMk cId="4288970753" sldId="259"/>
            <ac:spMk id="51" creationId="{4A647CBD-41EB-473D-8D48-D785AFA1AE66}"/>
          </ac:spMkLst>
        </pc:spChg>
        <pc:grpChg chg="add del mod">
          <ac:chgData name="Tekle Pauzaite" userId="06f7e524-8501-4f81-9b2a-484f6f2c7061" providerId="ADAL" clId="{8E5480CC-6F87-4B3E-88EB-9BB047D963B1}" dt="2024-04-03T08:19:11.093" v="414" actId="165"/>
          <ac:grpSpMkLst>
            <pc:docMk/>
            <pc:sldMk cId="4288970753" sldId="259"/>
            <ac:grpSpMk id="3" creationId="{6B5C4000-321E-4E7B-8A34-0C5683D73145}"/>
          </ac:grpSpMkLst>
        </pc:grpChg>
        <pc:picChg chg="mod topLvl">
          <ac:chgData name="Tekle Pauzaite" userId="06f7e524-8501-4f81-9b2a-484f6f2c7061" providerId="ADAL" clId="{8E5480CC-6F87-4B3E-88EB-9BB047D963B1}" dt="2024-04-03T08:19:11.093" v="414" actId="165"/>
          <ac:picMkLst>
            <pc:docMk/>
            <pc:sldMk cId="4288970753" sldId="259"/>
            <ac:picMk id="4" creationId="{3ED3CD7B-4639-42A3-A3CE-E963CCD0D8B0}"/>
          </ac:picMkLst>
        </pc:picChg>
        <pc:picChg chg="mod topLvl">
          <ac:chgData name="Tekle Pauzaite" userId="06f7e524-8501-4f81-9b2a-484f6f2c7061" providerId="ADAL" clId="{8E5480CC-6F87-4B3E-88EB-9BB047D963B1}" dt="2024-04-03T08:19:11.093" v="414" actId="165"/>
          <ac:picMkLst>
            <pc:docMk/>
            <pc:sldMk cId="4288970753" sldId="259"/>
            <ac:picMk id="5" creationId="{87FE9D02-4166-4E2C-8626-8A9312CBA4DC}"/>
          </ac:picMkLst>
        </pc:picChg>
        <pc:picChg chg="mod topLvl">
          <ac:chgData name="Tekle Pauzaite" userId="06f7e524-8501-4f81-9b2a-484f6f2c7061" providerId="ADAL" clId="{8E5480CC-6F87-4B3E-88EB-9BB047D963B1}" dt="2024-04-03T08:19:11.093" v="414" actId="165"/>
          <ac:picMkLst>
            <pc:docMk/>
            <pc:sldMk cId="4288970753" sldId="259"/>
            <ac:picMk id="6" creationId="{7C03DF17-3D69-4A4F-809E-BBAE8F4DD6F0}"/>
          </ac:picMkLst>
        </pc:picChg>
        <pc:picChg chg="mod topLvl">
          <ac:chgData name="Tekle Pauzaite" userId="06f7e524-8501-4f81-9b2a-484f6f2c7061" providerId="ADAL" clId="{8E5480CC-6F87-4B3E-88EB-9BB047D963B1}" dt="2024-04-03T08:19:11.093" v="414" actId="165"/>
          <ac:picMkLst>
            <pc:docMk/>
            <pc:sldMk cId="4288970753" sldId="259"/>
            <ac:picMk id="7" creationId="{6617525D-2A4D-4517-B397-3C492B0BD00B}"/>
          </ac:picMkLst>
        </pc:picChg>
        <pc:picChg chg="mod topLvl">
          <ac:chgData name="Tekle Pauzaite" userId="06f7e524-8501-4f81-9b2a-484f6f2c7061" providerId="ADAL" clId="{8E5480CC-6F87-4B3E-88EB-9BB047D963B1}" dt="2024-04-03T08:19:11.093" v="414" actId="165"/>
          <ac:picMkLst>
            <pc:docMk/>
            <pc:sldMk cId="4288970753" sldId="259"/>
            <ac:picMk id="8" creationId="{0A052638-8930-4564-A55B-0484D1A2CB7F}"/>
          </ac:picMkLst>
        </pc:picChg>
        <pc:picChg chg="add mod modCrop">
          <ac:chgData name="Tekle Pauzaite" userId="06f7e524-8501-4f81-9b2a-484f6f2c7061" providerId="ADAL" clId="{8E5480CC-6F87-4B3E-88EB-9BB047D963B1}" dt="2024-04-03T08:19:30.587" v="423" actId="1076"/>
          <ac:picMkLst>
            <pc:docMk/>
            <pc:sldMk cId="4288970753" sldId="259"/>
            <ac:picMk id="36" creationId="{AB451713-0587-4F5E-960B-508881FBC417}"/>
          </ac:picMkLst>
        </pc:picChg>
        <pc:picChg chg="add mod modCrop">
          <ac:chgData name="Tekle Pauzaite" userId="06f7e524-8501-4f81-9b2a-484f6f2c7061" providerId="ADAL" clId="{8E5480CC-6F87-4B3E-88EB-9BB047D963B1}" dt="2024-04-03T08:20:09.131" v="437" actId="1076"/>
          <ac:picMkLst>
            <pc:docMk/>
            <pc:sldMk cId="4288970753" sldId="259"/>
            <ac:picMk id="38" creationId="{FFE6D571-2BE5-4F39-AB52-00C89C31D08A}"/>
          </ac:picMkLst>
        </pc:picChg>
        <pc:picChg chg="add mod modCrop">
          <ac:chgData name="Tekle Pauzaite" userId="06f7e524-8501-4f81-9b2a-484f6f2c7061" providerId="ADAL" clId="{8E5480CC-6F87-4B3E-88EB-9BB047D963B1}" dt="2024-04-03T08:20:50.843" v="449" actId="1076"/>
          <ac:picMkLst>
            <pc:docMk/>
            <pc:sldMk cId="4288970753" sldId="259"/>
            <ac:picMk id="40" creationId="{DF807153-10FE-4FDE-8D2C-2D209F0358D5}"/>
          </ac:picMkLst>
        </pc:picChg>
        <pc:picChg chg="add mod modCrop">
          <ac:chgData name="Tekle Pauzaite" userId="06f7e524-8501-4f81-9b2a-484f6f2c7061" providerId="ADAL" clId="{8E5480CC-6F87-4B3E-88EB-9BB047D963B1}" dt="2024-04-03T08:21:18.643" v="460" actId="1076"/>
          <ac:picMkLst>
            <pc:docMk/>
            <pc:sldMk cId="4288970753" sldId="259"/>
            <ac:picMk id="42" creationId="{CFCB63CD-DB1C-46F6-AC64-4D9BDAF06CF7}"/>
          </ac:picMkLst>
        </pc:picChg>
        <pc:picChg chg="add mod modCrop">
          <ac:chgData name="Tekle Pauzaite" userId="06f7e524-8501-4f81-9b2a-484f6f2c7061" providerId="ADAL" clId="{8E5480CC-6F87-4B3E-88EB-9BB047D963B1}" dt="2024-04-03T08:25:46.387" v="469" actId="1076"/>
          <ac:picMkLst>
            <pc:docMk/>
            <pc:sldMk cId="4288970753" sldId="259"/>
            <ac:picMk id="44" creationId="{C0DD7DD3-82CA-4D82-89FB-A7FA0FC279F7}"/>
          </ac:picMkLst>
        </pc:picChg>
        <pc:picChg chg="add del mod">
          <ac:chgData name="Tekle Pauzaite" userId="06f7e524-8501-4f81-9b2a-484f6f2c7061" providerId="ADAL" clId="{8E5480CC-6F87-4B3E-88EB-9BB047D963B1}" dt="2024-04-03T08:25:49.727" v="471" actId="478"/>
          <ac:picMkLst>
            <pc:docMk/>
            <pc:sldMk cId="4288970753" sldId="259"/>
            <ac:picMk id="45" creationId="{E5392008-EE2F-48F1-9133-9840163317A1}"/>
          </ac:picMkLst>
        </pc:picChg>
        <pc:cxnChg chg="mod topLvl">
          <ac:chgData name="Tekle Pauzaite" userId="06f7e524-8501-4f81-9b2a-484f6f2c7061" providerId="ADAL" clId="{8E5480CC-6F87-4B3E-88EB-9BB047D963B1}" dt="2024-04-03T08:19:11.093" v="414" actId="165"/>
          <ac:cxnSpMkLst>
            <pc:docMk/>
            <pc:sldMk cId="4288970753" sldId="259"/>
            <ac:cxnSpMk id="30" creationId="{91088CB3-6E57-47BE-9DB9-2CAA25C79328}"/>
          </ac:cxnSpMkLst>
        </pc:cxnChg>
        <pc:cxnChg chg="mod topLvl">
          <ac:chgData name="Tekle Pauzaite" userId="06f7e524-8501-4f81-9b2a-484f6f2c7061" providerId="ADAL" clId="{8E5480CC-6F87-4B3E-88EB-9BB047D963B1}" dt="2024-04-03T08:19:11.093" v="414" actId="165"/>
          <ac:cxnSpMkLst>
            <pc:docMk/>
            <pc:sldMk cId="4288970753" sldId="259"/>
            <ac:cxnSpMk id="31" creationId="{570FC269-4E84-4CB6-B798-E54D8E84054D}"/>
          </ac:cxnSpMkLst>
        </pc:cxnChg>
        <pc:cxnChg chg="mod topLvl">
          <ac:chgData name="Tekle Pauzaite" userId="06f7e524-8501-4f81-9b2a-484f6f2c7061" providerId="ADAL" clId="{8E5480CC-6F87-4B3E-88EB-9BB047D963B1}" dt="2024-04-03T08:19:11.093" v="414" actId="165"/>
          <ac:cxnSpMkLst>
            <pc:docMk/>
            <pc:sldMk cId="4288970753" sldId="259"/>
            <ac:cxnSpMk id="32" creationId="{30BD9C71-9EC9-4CD2-8963-7871E43F79C5}"/>
          </ac:cxnSpMkLst>
        </pc:cxnChg>
        <pc:cxnChg chg="mod topLvl">
          <ac:chgData name="Tekle Pauzaite" userId="06f7e524-8501-4f81-9b2a-484f6f2c7061" providerId="ADAL" clId="{8E5480CC-6F87-4B3E-88EB-9BB047D963B1}" dt="2024-04-03T08:19:11.093" v="414" actId="165"/>
          <ac:cxnSpMkLst>
            <pc:docMk/>
            <pc:sldMk cId="4288970753" sldId="259"/>
            <ac:cxnSpMk id="33" creationId="{D67A6D31-3C01-46E8-9402-4E99BEC763DE}"/>
          </ac:cxnSpMkLst>
        </pc:cxnChg>
        <pc:cxnChg chg="mod topLvl">
          <ac:chgData name="Tekle Pauzaite" userId="06f7e524-8501-4f81-9b2a-484f6f2c7061" providerId="ADAL" clId="{8E5480CC-6F87-4B3E-88EB-9BB047D963B1}" dt="2024-04-03T08:19:11.093" v="414" actId="165"/>
          <ac:cxnSpMkLst>
            <pc:docMk/>
            <pc:sldMk cId="4288970753" sldId="259"/>
            <ac:cxnSpMk id="35" creationId="{E223547A-B21F-4461-BC95-AB17006FF7E5}"/>
          </ac:cxnSpMkLst>
        </pc:cxnChg>
      </pc:sldChg>
      <pc:sldChg chg="addSp delSp modSp add">
        <pc:chgData name="Tekle Pauzaite" userId="06f7e524-8501-4f81-9b2a-484f6f2c7061" providerId="ADAL" clId="{8E5480CC-6F87-4B3E-88EB-9BB047D963B1}" dt="2024-04-03T08:30:26.219" v="560" actId="571"/>
        <pc:sldMkLst>
          <pc:docMk/>
          <pc:sldMk cId="280767287" sldId="260"/>
        </pc:sldMkLst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7" creationId="{3EA26924-5714-42FE-9490-471A1DAF011E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8" creationId="{B03EE824-18FF-420E-9584-F91EFE4BF514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9" creationId="{C2099A66-DD5E-4A4D-B48C-3949B1F1D84C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10" creationId="{9FDC4CC0-D7CB-4184-901D-6DD282E8201F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11" creationId="{BE1369C9-153F-4018-BB57-A39261D00EB9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12" creationId="{98AC307C-7815-41FE-8044-558D62ED7A80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13" creationId="{46B9F2CA-3702-4457-949F-EB467AF57615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14" creationId="{944F75F3-04CF-4D90-9868-343D7F39DF28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15" creationId="{F0223313-4899-4E21-81EF-78725584C5F0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16" creationId="{58EE3141-7A41-4557-A72A-259085249940}"/>
          </ac:spMkLst>
        </pc:spChg>
        <pc:spChg chg="mod topLvl">
          <ac:chgData name="Tekle Pauzaite" userId="06f7e524-8501-4f81-9b2a-484f6f2c7061" providerId="ADAL" clId="{8E5480CC-6F87-4B3E-88EB-9BB047D963B1}" dt="2024-04-03T08:26:37.330" v="483" actId="1036"/>
          <ac:spMkLst>
            <pc:docMk/>
            <pc:sldMk cId="280767287" sldId="260"/>
            <ac:spMk id="17" creationId="{5D00B885-C527-40D7-9871-2B0B021A0214}"/>
          </ac:spMkLst>
        </pc:spChg>
        <pc:spChg chg="mod topLvl">
          <ac:chgData name="Tekle Pauzaite" userId="06f7e524-8501-4f81-9b2a-484f6f2c7061" providerId="ADAL" clId="{8E5480CC-6F87-4B3E-88EB-9BB047D963B1}" dt="2024-04-03T08:26:37.330" v="483" actId="1036"/>
          <ac:spMkLst>
            <pc:docMk/>
            <pc:sldMk cId="280767287" sldId="260"/>
            <ac:spMk id="18" creationId="{D10D36F9-C733-4F60-903E-F9E02E79EAE0}"/>
          </ac:spMkLst>
        </pc:spChg>
        <pc:spChg chg="mod topLvl">
          <ac:chgData name="Tekle Pauzaite" userId="06f7e524-8501-4f81-9b2a-484f6f2c7061" providerId="ADAL" clId="{8E5480CC-6F87-4B3E-88EB-9BB047D963B1}" dt="2024-04-03T08:26:37.330" v="483" actId="1036"/>
          <ac:spMkLst>
            <pc:docMk/>
            <pc:sldMk cId="280767287" sldId="260"/>
            <ac:spMk id="19" creationId="{F8394BBA-1FB8-4FC7-A179-6D82471BB653}"/>
          </ac:spMkLst>
        </pc:spChg>
        <pc:spChg chg="mod topLvl">
          <ac:chgData name="Tekle Pauzaite" userId="06f7e524-8501-4f81-9b2a-484f6f2c7061" providerId="ADAL" clId="{8E5480CC-6F87-4B3E-88EB-9BB047D963B1}" dt="2024-04-03T08:26:37.330" v="483" actId="1036"/>
          <ac:spMkLst>
            <pc:docMk/>
            <pc:sldMk cId="280767287" sldId="260"/>
            <ac:spMk id="20" creationId="{A2F174BB-127A-4AEA-AEF9-F982D4115957}"/>
          </ac:spMkLst>
        </pc:spChg>
        <pc:spChg chg="mod topLvl">
          <ac:chgData name="Tekle Pauzaite" userId="06f7e524-8501-4f81-9b2a-484f6f2c7061" providerId="ADAL" clId="{8E5480CC-6F87-4B3E-88EB-9BB047D963B1}" dt="2024-04-03T08:26:37.330" v="483" actId="1036"/>
          <ac:spMkLst>
            <pc:docMk/>
            <pc:sldMk cId="280767287" sldId="260"/>
            <ac:spMk id="21" creationId="{11996C72-C92B-4DF6-AA1A-2A5570B94746}"/>
          </ac:spMkLst>
        </pc:spChg>
        <pc:spChg chg="mod topLvl">
          <ac:chgData name="Tekle Pauzaite" userId="06f7e524-8501-4f81-9b2a-484f6f2c7061" providerId="ADAL" clId="{8E5480CC-6F87-4B3E-88EB-9BB047D963B1}" dt="2024-04-03T08:26:37.330" v="483" actId="1036"/>
          <ac:spMkLst>
            <pc:docMk/>
            <pc:sldMk cId="280767287" sldId="260"/>
            <ac:spMk id="22" creationId="{B599B49A-7714-45B3-90CB-39A4E32FAB08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23" creationId="{11EF41F4-BED3-4999-9A67-5F467532B46A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24" creationId="{0A589AB8-7FAF-4214-ABE8-DF708AEB0CBA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25" creationId="{C168131D-120E-439A-980F-955F4FCE6032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26" creationId="{3EA8268B-3D76-4AC1-9A57-CB319E24A059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27" creationId="{B3EA4470-5BE9-489D-BC93-86A8D4CD5E54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28" creationId="{B130B1C7-7DDE-4288-90CF-3F9AB2523826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29" creationId="{B704B569-BE74-4C89-9FA8-EBB8FCDBF1A9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30" creationId="{A3DEE200-49C7-40D0-8C22-0F3A0013C070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33" creationId="{3477DF1F-6865-4DAA-86DE-C072DE29D756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34" creationId="{638D407A-C388-4D05-BB03-6C8BCD679A48}"/>
          </ac:spMkLst>
        </pc:spChg>
        <pc:spChg chg="mod topLvl">
          <ac:chgData name="Tekle Pauzaite" userId="06f7e524-8501-4f81-9b2a-484f6f2c7061" providerId="ADAL" clId="{8E5480CC-6F87-4B3E-88EB-9BB047D963B1}" dt="2024-04-03T08:27:39.251" v="488" actId="1037"/>
          <ac:spMkLst>
            <pc:docMk/>
            <pc:sldMk cId="280767287" sldId="260"/>
            <ac:spMk id="36" creationId="{DC3C61ED-B58A-4453-887A-837D3C3B97D8}"/>
          </ac:spMkLst>
        </pc:spChg>
        <pc:spChg chg="mod topLvl">
          <ac:chgData name="Tekle Pauzaite" userId="06f7e524-8501-4f81-9b2a-484f6f2c7061" providerId="ADAL" clId="{8E5480CC-6F87-4B3E-88EB-9BB047D963B1}" dt="2024-04-03T08:27:39.251" v="488" actId="1037"/>
          <ac:spMkLst>
            <pc:docMk/>
            <pc:sldMk cId="280767287" sldId="260"/>
            <ac:spMk id="37" creationId="{D191437D-3A6F-4458-A1C1-535106618903}"/>
          </ac:spMkLst>
        </pc:spChg>
        <pc:spChg chg="mod topLvl">
          <ac:chgData name="Tekle Pauzaite" userId="06f7e524-8501-4f81-9b2a-484f6f2c7061" providerId="ADAL" clId="{8E5480CC-6F87-4B3E-88EB-9BB047D963B1}" dt="2024-04-03T08:27:39.251" v="488" actId="1037"/>
          <ac:spMkLst>
            <pc:docMk/>
            <pc:sldMk cId="280767287" sldId="260"/>
            <ac:spMk id="38" creationId="{4D780E6F-BE12-43EC-A0B2-A5A6DC1D9EC1}"/>
          </ac:spMkLst>
        </pc:spChg>
        <pc:spChg chg="mod topLvl">
          <ac:chgData name="Tekle Pauzaite" userId="06f7e524-8501-4f81-9b2a-484f6f2c7061" providerId="ADAL" clId="{8E5480CC-6F87-4B3E-88EB-9BB047D963B1}" dt="2024-04-03T08:27:39.251" v="488" actId="1037"/>
          <ac:spMkLst>
            <pc:docMk/>
            <pc:sldMk cId="280767287" sldId="260"/>
            <ac:spMk id="39" creationId="{5E6FF216-DE9F-4F51-9DB3-2D4E9A1938BB}"/>
          </ac:spMkLst>
        </pc:spChg>
        <pc:spChg chg="mod topLvl">
          <ac:chgData name="Tekle Pauzaite" userId="06f7e524-8501-4f81-9b2a-484f6f2c7061" providerId="ADAL" clId="{8E5480CC-6F87-4B3E-88EB-9BB047D963B1}" dt="2024-04-03T08:27:39.251" v="488" actId="1037"/>
          <ac:spMkLst>
            <pc:docMk/>
            <pc:sldMk cId="280767287" sldId="260"/>
            <ac:spMk id="44" creationId="{BC3DFED0-F4A6-440F-8FA8-F47064880B03}"/>
          </ac:spMkLst>
        </pc:spChg>
        <pc:spChg chg="mod topLvl">
          <ac:chgData name="Tekle Pauzaite" userId="06f7e524-8501-4f81-9b2a-484f6f2c7061" providerId="ADAL" clId="{8E5480CC-6F87-4B3E-88EB-9BB047D963B1}" dt="2024-04-03T08:26:26.243" v="479" actId="165"/>
          <ac:spMkLst>
            <pc:docMk/>
            <pc:sldMk cId="280767287" sldId="260"/>
            <ac:spMk id="46" creationId="{34889AAB-EF65-4592-8116-764DE99DAFB4}"/>
          </ac:spMkLst>
        </pc:spChg>
        <pc:spChg chg="add mod">
          <ac:chgData name="Tekle Pauzaite" userId="06f7e524-8501-4f81-9b2a-484f6f2c7061" providerId="ADAL" clId="{8E5480CC-6F87-4B3E-88EB-9BB047D963B1}" dt="2024-04-03T08:26:22.660" v="478" actId="1076"/>
          <ac:spMkLst>
            <pc:docMk/>
            <pc:sldMk cId="280767287" sldId="260"/>
            <ac:spMk id="47" creationId="{EF35F344-114C-4269-BD05-B68BF1011568}"/>
          </ac:spMkLst>
        </pc:spChg>
        <pc:spChg chg="add mod">
          <ac:chgData name="Tekle Pauzaite" userId="06f7e524-8501-4f81-9b2a-484f6f2c7061" providerId="ADAL" clId="{8E5480CC-6F87-4B3E-88EB-9BB047D963B1}" dt="2024-04-03T08:28:18.652" v="507" actId="14100"/>
          <ac:spMkLst>
            <pc:docMk/>
            <pc:sldMk cId="280767287" sldId="260"/>
            <ac:spMk id="49" creationId="{8E933346-1872-440D-88EA-CDA884A49B76}"/>
          </ac:spMkLst>
        </pc:spChg>
        <pc:spChg chg="add mod">
          <ac:chgData name="Tekle Pauzaite" userId="06f7e524-8501-4f81-9b2a-484f6f2c7061" providerId="ADAL" clId="{8E5480CC-6F87-4B3E-88EB-9BB047D963B1}" dt="2024-04-03T08:28:46.292" v="520" actId="571"/>
          <ac:spMkLst>
            <pc:docMk/>
            <pc:sldMk cId="280767287" sldId="260"/>
            <ac:spMk id="51" creationId="{4427C983-5655-4BFC-B3CE-2B577F04A6FC}"/>
          </ac:spMkLst>
        </pc:spChg>
        <pc:spChg chg="add mod">
          <ac:chgData name="Tekle Pauzaite" userId="06f7e524-8501-4f81-9b2a-484f6f2c7061" providerId="ADAL" clId="{8E5480CC-6F87-4B3E-88EB-9BB047D963B1}" dt="2024-04-03T08:29:14.307" v="534" actId="571"/>
          <ac:spMkLst>
            <pc:docMk/>
            <pc:sldMk cId="280767287" sldId="260"/>
            <ac:spMk id="53" creationId="{8A15FE86-5201-494C-AA77-36D825538D40}"/>
          </ac:spMkLst>
        </pc:spChg>
        <pc:spChg chg="add mod">
          <ac:chgData name="Tekle Pauzaite" userId="06f7e524-8501-4f81-9b2a-484f6f2c7061" providerId="ADAL" clId="{8E5480CC-6F87-4B3E-88EB-9BB047D963B1}" dt="2024-04-03T08:29:38.924" v="544" actId="571"/>
          <ac:spMkLst>
            <pc:docMk/>
            <pc:sldMk cId="280767287" sldId="260"/>
            <ac:spMk id="55" creationId="{20C45677-C11F-43B1-838E-8189F2E975CF}"/>
          </ac:spMkLst>
        </pc:spChg>
        <pc:spChg chg="add mod">
          <ac:chgData name="Tekle Pauzaite" userId="06f7e524-8501-4f81-9b2a-484f6f2c7061" providerId="ADAL" clId="{8E5480CC-6F87-4B3E-88EB-9BB047D963B1}" dt="2024-04-03T08:30:05.859" v="555" actId="14100"/>
          <ac:spMkLst>
            <pc:docMk/>
            <pc:sldMk cId="280767287" sldId="260"/>
            <ac:spMk id="57" creationId="{FF607C5E-A0BA-4A40-9ED1-D5257A33A74A}"/>
          </ac:spMkLst>
        </pc:spChg>
        <pc:spChg chg="add mod">
          <ac:chgData name="Tekle Pauzaite" userId="06f7e524-8501-4f81-9b2a-484f6f2c7061" providerId="ADAL" clId="{8E5480CC-6F87-4B3E-88EB-9BB047D963B1}" dt="2024-04-03T08:30:10.379" v="556" actId="571"/>
          <ac:spMkLst>
            <pc:docMk/>
            <pc:sldMk cId="280767287" sldId="260"/>
            <ac:spMk id="58" creationId="{32470951-72E2-4D74-927F-BB00EE9C7074}"/>
          </ac:spMkLst>
        </pc:spChg>
        <pc:spChg chg="add mod">
          <ac:chgData name="Tekle Pauzaite" userId="06f7e524-8501-4f81-9b2a-484f6f2c7061" providerId="ADAL" clId="{8E5480CC-6F87-4B3E-88EB-9BB047D963B1}" dt="2024-04-03T08:30:14.548" v="557" actId="571"/>
          <ac:spMkLst>
            <pc:docMk/>
            <pc:sldMk cId="280767287" sldId="260"/>
            <ac:spMk id="59" creationId="{B0CD9200-D6E0-48BF-8303-FF7F897BF7A1}"/>
          </ac:spMkLst>
        </pc:spChg>
        <pc:spChg chg="add mod">
          <ac:chgData name="Tekle Pauzaite" userId="06f7e524-8501-4f81-9b2a-484f6f2c7061" providerId="ADAL" clId="{8E5480CC-6F87-4B3E-88EB-9BB047D963B1}" dt="2024-04-03T08:30:18.532" v="558" actId="571"/>
          <ac:spMkLst>
            <pc:docMk/>
            <pc:sldMk cId="280767287" sldId="260"/>
            <ac:spMk id="60" creationId="{A95E4EA1-0D1C-4310-AE92-57F523829C9C}"/>
          </ac:spMkLst>
        </pc:spChg>
        <pc:spChg chg="add mod">
          <ac:chgData name="Tekle Pauzaite" userId="06f7e524-8501-4f81-9b2a-484f6f2c7061" providerId="ADAL" clId="{8E5480CC-6F87-4B3E-88EB-9BB047D963B1}" dt="2024-04-03T08:30:22.939" v="559" actId="571"/>
          <ac:spMkLst>
            <pc:docMk/>
            <pc:sldMk cId="280767287" sldId="260"/>
            <ac:spMk id="61" creationId="{F320810F-BBA5-44FE-8A3C-B6C2B0553A00}"/>
          </ac:spMkLst>
        </pc:spChg>
        <pc:spChg chg="add mod">
          <ac:chgData name="Tekle Pauzaite" userId="06f7e524-8501-4f81-9b2a-484f6f2c7061" providerId="ADAL" clId="{8E5480CC-6F87-4B3E-88EB-9BB047D963B1}" dt="2024-04-03T08:30:26.219" v="560" actId="571"/>
          <ac:spMkLst>
            <pc:docMk/>
            <pc:sldMk cId="280767287" sldId="260"/>
            <ac:spMk id="62" creationId="{2A951B42-98EC-4EC8-9279-8ACD8711392B}"/>
          </ac:spMkLst>
        </pc:spChg>
        <pc:grpChg chg="add del mod">
          <ac:chgData name="Tekle Pauzaite" userId="06f7e524-8501-4f81-9b2a-484f6f2c7061" providerId="ADAL" clId="{8E5480CC-6F87-4B3E-88EB-9BB047D963B1}" dt="2024-04-03T08:26:26.243" v="479" actId="165"/>
          <ac:grpSpMkLst>
            <pc:docMk/>
            <pc:sldMk cId="280767287" sldId="260"/>
            <ac:grpSpMk id="2" creationId="{1F1EDD42-EF6B-4331-9F23-8582FD1D87CA}"/>
          </ac:grpSpMkLst>
        </pc:grpChg>
        <pc:picChg chg="mod topLvl">
          <ac:chgData name="Tekle Pauzaite" userId="06f7e524-8501-4f81-9b2a-484f6f2c7061" providerId="ADAL" clId="{8E5480CC-6F87-4B3E-88EB-9BB047D963B1}" dt="2024-04-03T08:26:37.330" v="483" actId="1036"/>
          <ac:picMkLst>
            <pc:docMk/>
            <pc:sldMk cId="280767287" sldId="260"/>
            <ac:picMk id="3" creationId="{D0C4311B-0E2E-4C02-B171-23FE61428C11}"/>
          </ac:picMkLst>
        </pc:picChg>
        <pc:picChg chg="mod topLvl">
          <ac:chgData name="Tekle Pauzaite" userId="06f7e524-8501-4f81-9b2a-484f6f2c7061" providerId="ADAL" clId="{8E5480CC-6F87-4B3E-88EB-9BB047D963B1}" dt="2024-04-03T08:26:37.330" v="483" actId="1036"/>
          <ac:picMkLst>
            <pc:docMk/>
            <pc:sldMk cId="280767287" sldId="260"/>
            <ac:picMk id="4" creationId="{87CEF34A-8A30-4A0D-8657-F1E45D0320EC}"/>
          </ac:picMkLst>
        </pc:picChg>
        <pc:picChg chg="mod topLvl">
          <ac:chgData name="Tekle Pauzaite" userId="06f7e524-8501-4f81-9b2a-484f6f2c7061" providerId="ADAL" clId="{8E5480CC-6F87-4B3E-88EB-9BB047D963B1}" dt="2024-04-03T08:26:37.330" v="483" actId="1036"/>
          <ac:picMkLst>
            <pc:docMk/>
            <pc:sldMk cId="280767287" sldId="260"/>
            <ac:picMk id="5" creationId="{9A889557-3FCA-4CA9-8D00-9AFC66726F2F}"/>
          </ac:picMkLst>
        </pc:picChg>
        <pc:picChg chg="mod topLvl">
          <ac:chgData name="Tekle Pauzaite" userId="06f7e524-8501-4f81-9b2a-484f6f2c7061" providerId="ADAL" clId="{8E5480CC-6F87-4B3E-88EB-9BB047D963B1}" dt="2024-04-03T08:26:37.330" v="483" actId="1036"/>
          <ac:picMkLst>
            <pc:docMk/>
            <pc:sldMk cId="280767287" sldId="260"/>
            <ac:picMk id="6" creationId="{485892DE-F4FD-4CD9-8C26-CD333FFA1368}"/>
          </ac:picMkLst>
        </pc:picChg>
        <pc:picChg chg="mod topLvl">
          <ac:chgData name="Tekle Pauzaite" userId="06f7e524-8501-4f81-9b2a-484f6f2c7061" providerId="ADAL" clId="{8E5480CC-6F87-4B3E-88EB-9BB047D963B1}" dt="2024-04-03T08:26:37.330" v="483" actId="1036"/>
          <ac:picMkLst>
            <pc:docMk/>
            <pc:sldMk cId="280767287" sldId="260"/>
            <ac:picMk id="35" creationId="{7BCE5D48-6E74-4B5E-8C4C-371F2517654F}"/>
          </ac:picMkLst>
        </pc:picChg>
        <pc:picChg chg="add mod modCrop">
          <ac:chgData name="Tekle Pauzaite" userId="06f7e524-8501-4f81-9b2a-484f6f2c7061" providerId="ADAL" clId="{8E5480CC-6F87-4B3E-88EB-9BB047D963B1}" dt="2024-04-03T08:28:02.051" v="504" actId="1076"/>
          <ac:picMkLst>
            <pc:docMk/>
            <pc:sldMk cId="280767287" sldId="260"/>
            <ac:picMk id="48" creationId="{7CDCA48B-7B19-45B1-B2C4-926BCA6A087D}"/>
          </ac:picMkLst>
        </pc:picChg>
        <pc:picChg chg="add mod modCrop">
          <ac:chgData name="Tekle Pauzaite" userId="06f7e524-8501-4f81-9b2a-484f6f2c7061" providerId="ADAL" clId="{8E5480CC-6F87-4B3E-88EB-9BB047D963B1}" dt="2024-04-03T08:28:39.851" v="519" actId="1076"/>
          <ac:picMkLst>
            <pc:docMk/>
            <pc:sldMk cId="280767287" sldId="260"/>
            <ac:picMk id="50" creationId="{E04CFA97-6F45-44E8-A877-6778A914D64D}"/>
          </ac:picMkLst>
        </pc:picChg>
        <pc:picChg chg="add mod modCrop">
          <ac:chgData name="Tekle Pauzaite" userId="06f7e524-8501-4f81-9b2a-484f6f2c7061" providerId="ADAL" clId="{8E5480CC-6F87-4B3E-88EB-9BB047D963B1}" dt="2024-04-03T08:29:03.259" v="533" actId="1076"/>
          <ac:picMkLst>
            <pc:docMk/>
            <pc:sldMk cId="280767287" sldId="260"/>
            <ac:picMk id="52" creationId="{7ADBC197-096E-468B-8A0F-F603B76E9F6C}"/>
          </ac:picMkLst>
        </pc:picChg>
        <pc:picChg chg="add mod modCrop">
          <ac:chgData name="Tekle Pauzaite" userId="06f7e524-8501-4f81-9b2a-484f6f2c7061" providerId="ADAL" clId="{8E5480CC-6F87-4B3E-88EB-9BB047D963B1}" dt="2024-04-03T08:29:32.115" v="543" actId="1076"/>
          <ac:picMkLst>
            <pc:docMk/>
            <pc:sldMk cId="280767287" sldId="260"/>
            <ac:picMk id="54" creationId="{A5DEE224-D67E-4472-BFBE-C1238C2830D6}"/>
          </ac:picMkLst>
        </pc:picChg>
        <pc:picChg chg="add mod modCrop">
          <ac:chgData name="Tekle Pauzaite" userId="06f7e524-8501-4f81-9b2a-484f6f2c7061" providerId="ADAL" clId="{8E5480CC-6F87-4B3E-88EB-9BB047D963B1}" dt="2024-04-03T08:29:58.843" v="553" actId="1076"/>
          <ac:picMkLst>
            <pc:docMk/>
            <pc:sldMk cId="280767287" sldId="260"/>
            <ac:picMk id="56" creationId="{FC7257DC-2F0A-4A31-BB35-28EE0594AE57}"/>
          </ac:picMkLst>
        </pc:picChg>
        <pc:cxnChg chg="mod topLvl">
          <ac:chgData name="Tekle Pauzaite" userId="06f7e524-8501-4f81-9b2a-484f6f2c7061" providerId="ADAL" clId="{8E5480CC-6F87-4B3E-88EB-9BB047D963B1}" dt="2024-04-03T08:26:26.243" v="479" actId="165"/>
          <ac:cxnSpMkLst>
            <pc:docMk/>
            <pc:sldMk cId="280767287" sldId="260"/>
            <ac:cxnSpMk id="31" creationId="{5F5A6780-94DF-4B51-BDD2-3FEF8A554A9A}"/>
          </ac:cxnSpMkLst>
        </pc:cxnChg>
        <pc:cxnChg chg="mod topLvl">
          <ac:chgData name="Tekle Pauzaite" userId="06f7e524-8501-4f81-9b2a-484f6f2c7061" providerId="ADAL" clId="{8E5480CC-6F87-4B3E-88EB-9BB047D963B1}" dt="2024-04-03T08:26:26.243" v="479" actId="165"/>
          <ac:cxnSpMkLst>
            <pc:docMk/>
            <pc:sldMk cId="280767287" sldId="260"/>
            <ac:cxnSpMk id="32" creationId="{4E113BF0-CD40-4B24-8F0D-C98D727A0A9F}"/>
          </ac:cxnSpMkLst>
        </pc:cxnChg>
        <pc:cxnChg chg="mod topLvl">
          <ac:chgData name="Tekle Pauzaite" userId="06f7e524-8501-4f81-9b2a-484f6f2c7061" providerId="ADAL" clId="{8E5480CC-6F87-4B3E-88EB-9BB047D963B1}" dt="2024-04-03T08:27:44.163" v="493" actId="1038"/>
          <ac:cxnSpMkLst>
            <pc:docMk/>
            <pc:sldMk cId="280767287" sldId="260"/>
            <ac:cxnSpMk id="40" creationId="{B7DCD8F3-E2CF-4596-B203-165A36802C30}"/>
          </ac:cxnSpMkLst>
        </pc:cxnChg>
        <pc:cxnChg chg="mod topLvl">
          <ac:chgData name="Tekle Pauzaite" userId="06f7e524-8501-4f81-9b2a-484f6f2c7061" providerId="ADAL" clId="{8E5480CC-6F87-4B3E-88EB-9BB047D963B1}" dt="2024-04-03T08:27:44.163" v="493" actId="1038"/>
          <ac:cxnSpMkLst>
            <pc:docMk/>
            <pc:sldMk cId="280767287" sldId="260"/>
            <ac:cxnSpMk id="41" creationId="{6E8446F1-5C39-4BCA-B618-A5988FA1AF9C}"/>
          </ac:cxnSpMkLst>
        </pc:cxnChg>
        <pc:cxnChg chg="mod topLvl">
          <ac:chgData name="Tekle Pauzaite" userId="06f7e524-8501-4f81-9b2a-484f6f2c7061" providerId="ADAL" clId="{8E5480CC-6F87-4B3E-88EB-9BB047D963B1}" dt="2024-04-03T08:27:44.163" v="493" actId="1038"/>
          <ac:cxnSpMkLst>
            <pc:docMk/>
            <pc:sldMk cId="280767287" sldId="260"/>
            <ac:cxnSpMk id="42" creationId="{CB1375F6-5D74-46E4-9B5C-0D293A0EC5AC}"/>
          </ac:cxnSpMkLst>
        </pc:cxnChg>
        <pc:cxnChg chg="mod topLvl">
          <ac:chgData name="Tekle Pauzaite" userId="06f7e524-8501-4f81-9b2a-484f6f2c7061" providerId="ADAL" clId="{8E5480CC-6F87-4B3E-88EB-9BB047D963B1}" dt="2024-04-03T08:27:44.163" v="493" actId="1038"/>
          <ac:cxnSpMkLst>
            <pc:docMk/>
            <pc:sldMk cId="280767287" sldId="260"/>
            <ac:cxnSpMk id="43" creationId="{4C0AA351-9FAB-4785-922A-2C22B374538C}"/>
          </ac:cxnSpMkLst>
        </pc:cxnChg>
        <pc:cxnChg chg="mod topLvl">
          <ac:chgData name="Tekle Pauzaite" userId="06f7e524-8501-4f81-9b2a-484f6f2c7061" providerId="ADAL" clId="{8E5480CC-6F87-4B3E-88EB-9BB047D963B1}" dt="2024-04-03T08:27:44.163" v="493" actId="1038"/>
          <ac:cxnSpMkLst>
            <pc:docMk/>
            <pc:sldMk cId="280767287" sldId="260"/>
            <ac:cxnSpMk id="45" creationId="{BCFF4EE9-B565-4CDE-A021-7D406072FEA4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9136F3-4B36-4F48-A9FD-8E5AF1CCD2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DFD0CB-99B4-4FD5-B097-90D56E8DB6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EB71A7-986F-4F67-97CD-14BD92D55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628D37-C9AE-4F6A-B702-67C7834F9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BB7B46-EB23-427D-8FF5-BD1A80CD0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2814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79019-9BA7-4BC7-A88F-49E0099496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3DD32D-B134-48D1-9152-34ECF8BFFE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7A84B2-F7B6-44FE-870B-5B3956014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AF1181-DBFA-4FAF-BBB4-10633E9D3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DA7E8-6A44-4C93-99BF-1ABC341D6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172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1F059B4-1B9D-4CD9-925A-3EC2C19968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5828F3-49A3-4A82-917F-1524DD8CCD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7D7FD8-67AE-42B4-822A-03B6943AB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2AF0B6-474A-472A-9065-DF59C711C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F8F536-3C6A-43CD-9355-110F9D5FC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673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C5B8B7-FBC6-4B35-80B8-FB71455130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045085-F5D1-4C57-986A-DE6E80EA97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078B2-5DB9-4E52-864F-F44EA3F05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980361-2239-4210-8A80-E39ED12F3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00D724-9BD7-4871-BAFE-D32F83F9EB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498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31B16D-C4E9-4C40-ADB7-07FD989548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6F4363-5CE5-46A6-822A-BDE9A23BD7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84B3D0-D164-4998-86A6-2E5DB02672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77100A-02FC-4D5C-BB54-321775AF0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0F2054-E73F-4E45-8D6E-224EEACB7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721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F58D20-5DAE-4F5F-8727-FEC48C0B15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607BEE-54F7-4B02-8678-1299D43AD0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4C364F-D4A9-437D-9B06-BD88A06F0C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0A212A-AE5D-4A3E-9E66-F542F2F91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D9AFBB-D202-4DC8-8E66-201DDC394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EEF89F-32AF-4687-8BE2-955E8B619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6932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F7763D-2AC5-4707-BCA4-32A46D65EF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3B9DBF-C3E6-4F14-9DBE-99C7E75624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E30510-8ABE-43A5-B5E1-5EFE22F53F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3A81E3F-06C2-49D6-B404-D32CD8A7B0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5E8BCA-5EA7-45B8-8112-81120373B6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D44649-E25D-46E1-B542-E630E58D9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C20187-537C-4961-8489-8838FEA3DC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79BA9C-A78E-40EF-8856-BA4DD4B5C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8761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B2B45F-D091-4D7A-8A49-41B30D3FDE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F2D3D9-B70B-468F-837E-6C55731FB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FD90E9-CB0D-4A05-8F0C-639ED46BB4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78757A7-827A-4A8F-AD2B-97DC99E4E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3727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07BD8E6-09E7-4DA0-9555-389D256F9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6E223C-CF05-4D4B-B706-D9E17E7C7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E17F1F-7E48-4197-A24A-6038A73C4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31954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A94C7D-DCDE-4676-A42D-669B2E519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8E4B35-ECC2-43C0-8B27-70CD3471A8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9BE023-1DBD-43ED-882B-2AF1469706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731263-7C6C-4071-B964-527CBFDCD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276E8B-9BE4-4A32-88D4-1A48B319D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5408F9-9A33-4E12-9067-DCCBD3A19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3844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D859C-A75F-46D1-81A5-E0361BC3C3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09DDB1-38E5-45FE-B7B7-3703EB21DD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677E07-42CA-450F-B02A-74D8CBF8FD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51835B-5035-4F5A-BD8A-076E62771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BEEC9E-1780-400A-ADAA-ECCD328D1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7F4D6C-57BA-4404-B37E-577D6F176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045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C02991A-537D-4860-BD9C-C83F22B46B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615DD8-39CB-46FF-B988-5D4D9E5A69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C9EB11-0B2E-4A5A-8C2D-7C769E0D05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47BE7-9AE9-48E8-B385-778A0EE630E8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DC6EC-C70F-4A0A-AB5B-E0EA410458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546372-EE3A-44AE-878C-F4C9CD60C8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49CA3C-1573-4693-ADDC-F1D3ACBC55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0798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13.png"/><Relationship Id="rId4" Type="http://schemas.openxmlformats.org/officeDocument/2006/relationships/image" Target="../media/image12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g"/><Relationship Id="rId5" Type="http://schemas.openxmlformats.org/officeDocument/2006/relationships/image" Target="../media/image20.jpg"/><Relationship Id="rId4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5ED6DC1-476E-40C5-ACD2-0E1A57C73DC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64" t="37226" r="72162" b="56594"/>
          <a:stretch/>
        </p:blipFill>
        <p:spPr>
          <a:xfrm rot="5400000">
            <a:off x="1178338" y="1356618"/>
            <a:ext cx="297521" cy="4106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694AE06-86A4-484D-83D7-797A2B89631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63" t="72181" r="79459" b="14408"/>
          <a:stretch/>
        </p:blipFill>
        <p:spPr>
          <a:xfrm rot="5400000">
            <a:off x="1178339" y="1035750"/>
            <a:ext cx="297521" cy="4106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B666102-E86B-4BD2-B3E5-53376E3DE18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228" t="61746" r="39298" b="25999"/>
          <a:stretch/>
        </p:blipFill>
        <p:spPr>
          <a:xfrm rot="5400000">
            <a:off x="1612434" y="1356618"/>
            <a:ext cx="297521" cy="4106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9DC4208-6BEC-449F-870E-E03FA13CE22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85" t="64458" r="67441" b="23268"/>
          <a:stretch/>
        </p:blipFill>
        <p:spPr>
          <a:xfrm rot="5400000">
            <a:off x="1178339" y="2002086"/>
            <a:ext cx="297521" cy="4106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0361C98-F721-49FE-821A-D6A887239A4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27" t="49745" r="48587" b="37435"/>
          <a:stretch/>
        </p:blipFill>
        <p:spPr>
          <a:xfrm rot="5400000">
            <a:off x="1612435" y="1035750"/>
            <a:ext cx="297521" cy="4106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807DEC7-653E-47BF-B418-27A89567195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78" t="53176" r="35235" b="33759"/>
          <a:stretch/>
        </p:blipFill>
        <p:spPr>
          <a:xfrm rot="5400000">
            <a:off x="1612435" y="2002086"/>
            <a:ext cx="297521" cy="4106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E6937C5-3D71-4EF4-A968-82044EBFAADA}"/>
              </a:ext>
            </a:extLst>
          </p:cNvPr>
          <p:cNvSpPr txBox="1"/>
          <p:nvPr/>
        </p:nvSpPr>
        <p:spPr>
          <a:xfrm rot="16200000">
            <a:off x="1155354" y="793730"/>
            <a:ext cx="511524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4E170B6-D9E1-4E63-9B58-F560BC0FEC71}"/>
              </a:ext>
            </a:extLst>
          </p:cNvPr>
          <p:cNvSpPr txBox="1"/>
          <p:nvPr/>
        </p:nvSpPr>
        <p:spPr>
          <a:xfrm rot="16200000">
            <a:off x="956305" y="784971"/>
            <a:ext cx="529042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BEG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862180F-A7AC-4876-BB61-E7E431286513}"/>
              </a:ext>
            </a:extLst>
          </p:cNvPr>
          <p:cNvSpPr txBox="1"/>
          <p:nvPr/>
        </p:nvSpPr>
        <p:spPr>
          <a:xfrm>
            <a:off x="1933602" y="1145255"/>
            <a:ext cx="37576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27042F3-10A9-4EF9-A4C1-B2B57E7B6CD2}"/>
              </a:ext>
            </a:extLst>
          </p:cNvPr>
          <p:cNvSpPr txBox="1"/>
          <p:nvPr/>
        </p:nvSpPr>
        <p:spPr>
          <a:xfrm>
            <a:off x="1933601" y="1448309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E6A0A7C-65BD-4BF7-8C71-B9886EDED4F9}"/>
              </a:ext>
            </a:extLst>
          </p:cNvPr>
          <p:cNvSpPr txBox="1"/>
          <p:nvPr/>
        </p:nvSpPr>
        <p:spPr>
          <a:xfrm>
            <a:off x="1933602" y="2098786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BEG2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H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A5DA23B-3696-4240-A702-85406DF5C998}"/>
              </a:ext>
            </a:extLst>
          </p:cNvPr>
          <p:cNvSpPr txBox="1"/>
          <p:nvPr/>
        </p:nvSpPr>
        <p:spPr>
          <a:xfrm>
            <a:off x="1068002" y="2351605"/>
            <a:ext cx="340725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CC38FF2-6FF1-4375-8B2B-7E73B217790C}"/>
              </a:ext>
            </a:extLst>
          </p:cNvPr>
          <p:cNvSpPr txBox="1"/>
          <p:nvPr/>
        </p:nvSpPr>
        <p:spPr>
          <a:xfrm>
            <a:off x="1534274" y="2351605"/>
            <a:ext cx="331965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 I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5691320-0612-424F-95E7-AF5CCA61901B}"/>
              </a:ext>
            </a:extLst>
          </p:cNvPr>
          <p:cNvSpPr txBox="1"/>
          <p:nvPr/>
        </p:nvSpPr>
        <p:spPr>
          <a:xfrm rot="16200000">
            <a:off x="1576788" y="793730"/>
            <a:ext cx="511524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53D75B3-76D9-44B4-B4AD-C49846979D8E}"/>
              </a:ext>
            </a:extLst>
          </p:cNvPr>
          <p:cNvSpPr txBox="1"/>
          <p:nvPr/>
        </p:nvSpPr>
        <p:spPr>
          <a:xfrm rot="16200000">
            <a:off x="1377738" y="784971"/>
            <a:ext cx="529042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BEG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CB80E99-AA30-46C8-869E-1B4842FA2A83}"/>
              </a:ext>
            </a:extLst>
          </p:cNvPr>
          <p:cNvSpPr txBox="1"/>
          <p:nvPr/>
        </p:nvSpPr>
        <p:spPr>
          <a:xfrm>
            <a:off x="832894" y="910932"/>
            <a:ext cx="266273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7E07662-71A0-4404-B822-9EF26623C5BD}"/>
              </a:ext>
            </a:extLst>
          </p:cNvPr>
          <p:cNvSpPr txBox="1"/>
          <p:nvPr/>
        </p:nvSpPr>
        <p:spPr>
          <a:xfrm>
            <a:off x="1933602" y="1791650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HA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AA6BDD6E-E390-47B5-84BC-8E88FB65BA0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61" t="30418" r="53139" b="55447"/>
          <a:stretch/>
        </p:blipFill>
        <p:spPr>
          <a:xfrm rot="5400000">
            <a:off x="1612435" y="1681712"/>
            <a:ext cx="297521" cy="4106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C7A32732-0B2D-4B41-AD38-93A3E6D3D21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16" t="49485" r="52984" b="36380"/>
          <a:stretch/>
        </p:blipFill>
        <p:spPr>
          <a:xfrm rot="5400000">
            <a:off x="1178339" y="1681712"/>
            <a:ext cx="297521" cy="4106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8C1232F4-835E-4C65-A8D5-AD5C1C7E1C2F}"/>
              </a:ext>
            </a:extLst>
          </p:cNvPr>
          <p:cNvSpPr txBox="1"/>
          <p:nvPr/>
        </p:nvSpPr>
        <p:spPr>
          <a:xfrm>
            <a:off x="712114" y="111006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FFD095-1203-4363-9523-3969ECF83F16}"/>
              </a:ext>
            </a:extLst>
          </p:cNvPr>
          <p:cNvSpPr txBox="1"/>
          <p:nvPr/>
        </p:nvSpPr>
        <p:spPr>
          <a:xfrm>
            <a:off x="760289" y="150499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09B31248-90CC-42E5-8728-6DA71E89FE37}"/>
              </a:ext>
            </a:extLst>
          </p:cNvPr>
          <p:cNvCxnSpPr/>
          <p:nvPr/>
        </p:nvCxnSpPr>
        <p:spPr>
          <a:xfrm>
            <a:off x="1013569" y="122769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6A952A6E-5510-48B6-9B22-2BBCA62418A1}"/>
              </a:ext>
            </a:extLst>
          </p:cNvPr>
          <p:cNvCxnSpPr/>
          <p:nvPr/>
        </p:nvCxnSpPr>
        <p:spPr>
          <a:xfrm>
            <a:off x="1013569" y="161531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9FD45DE2-7461-4FD2-B597-D7D6D0806A96}"/>
              </a:ext>
            </a:extLst>
          </p:cNvPr>
          <p:cNvSpPr txBox="1"/>
          <p:nvPr/>
        </p:nvSpPr>
        <p:spPr>
          <a:xfrm>
            <a:off x="714492" y="168876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C2BCBA4-3286-4129-98D5-9771BA4F995C}"/>
              </a:ext>
            </a:extLst>
          </p:cNvPr>
          <p:cNvSpPr txBox="1"/>
          <p:nvPr/>
        </p:nvSpPr>
        <p:spPr>
          <a:xfrm>
            <a:off x="762667" y="208369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A7FF1418-C696-4869-AD9D-F61397F6F2AC}"/>
              </a:ext>
            </a:extLst>
          </p:cNvPr>
          <p:cNvCxnSpPr/>
          <p:nvPr/>
        </p:nvCxnSpPr>
        <p:spPr>
          <a:xfrm>
            <a:off x="1015947" y="180639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66CF5F81-2D01-427B-B666-7708B5EF9BF5}"/>
              </a:ext>
            </a:extLst>
          </p:cNvPr>
          <p:cNvCxnSpPr/>
          <p:nvPr/>
        </p:nvCxnSpPr>
        <p:spPr>
          <a:xfrm>
            <a:off x="1015947" y="2194017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AC19F593-B0C9-46C7-8113-6F4D81D865DE}"/>
              </a:ext>
            </a:extLst>
          </p:cNvPr>
          <p:cNvSpPr txBox="1"/>
          <p:nvPr/>
        </p:nvSpPr>
        <p:spPr>
          <a:xfrm>
            <a:off x="1186346" y="2489817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9A157C6F-1873-4784-92B8-947D1D5B549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" t="840" r="395" b="11"/>
          <a:stretch/>
        </p:blipFill>
        <p:spPr>
          <a:xfrm rot="5400000">
            <a:off x="2674731" y="831966"/>
            <a:ext cx="2749318" cy="17136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5A1139CB-4BE1-4C06-8102-4E8ACFCFB12F}"/>
              </a:ext>
            </a:extLst>
          </p:cNvPr>
          <p:cNvSpPr/>
          <p:nvPr/>
        </p:nvSpPr>
        <p:spPr>
          <a:xfrm>
            <a:off x="3421224" y="671804"/>
            <a:ext cx="255037" cy="239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DA826FDA-7421-4B4B-9D70-AEDA65319D4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70" t="294" r="86" b="613"/>
          <a:stretch/>
        </p:blipFill>
        <p:spPr>
          <a:xfrm rot="5400000">
            <a:off x="4596536" y="624488"/>
            <a:ext cx="2850682" cy="19707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Rectangle 35">
            <a:extLst>
              <a:ext uri="{FF2B5EF4-FFF2-40B4-BE49-F238E27FC236}">
                <a16:creationId xmlns:a16="http://schemas.microsoft.com/office/drawing/2014/main" id="{ED752801-24F8-4714-BE08-9389A4C0371D}"/>
              </a:ext>
            </a:extLst>
          </p:cNvPr>
          <p:cNvSpPr/>
          <p:nvPr/>
        </p:nvSpPr>
        <p:spPr>
          <a:xfrm>
            <a:off x="5766840" y="1455706"/>
            <a:ext cx="255037" cy="239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9B4C8B3D-6AFC-44C8-9111-354A5A72D40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" t="77" r="97" b="580"/>
          <a:stretch/>
        </p:blipFill>
        <p:spPr>
          <a:xfrm rot="5400000">
            <a:off x="7717891" y="-117850"/>
            <a:ext cx="2580130" cy="37259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5E3C73FA-315D-4103-8539-D1F42B126CB2}"/>
              </a:ext>
            </a:extLst>
          </p:cNvPr>
          <p:cNvSpPr/>
          <p:nvPr/>
        </p:nvSpPr>
        <p:spPr>
          <a:xfrm>
            <a:off x="9243465" y="989762"/>
            <a:ext cx="255037" cy="239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888771B0-7853-4410-815D-18CA7A3CD80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03" t="837" r="663" b="685"/>
          <a:stretch/>
        </p:blipFill>
        <p:spPr>
          <a:xfrm rot="5400000">
            <a:off x="-158176" y="3935372"/>
            <a:ext cx="3133805" cy="22537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Rectangle 39">
            <a:extLst>
              <a:ext uri="{FF2B5EF4-FFF2-40B4-BE49-F238E27FC236}">
                <a16:creationId xmlns:a16="http://schemas.microsoft.com/office/drawing/2014/main" id="{CE3EFDD7-B69D-4B42-A29B-FD32D19886F3}"/>
              </a:ext>
            </a:extLst>
          </p:cNvPr>
          <p:cNvSpPr/>
          <p:nvPr/>
        </p:nvSpPr>
        <p:spPr>
          <a:xfrm>
            <a:off x="866747" y="5205701"/>
            <a:ext cx="255037" cy="239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3982A2FF-A0D2-41C2-9AA3-4E79D0A27A5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3" t="-388" r="44" b="386"/>
          <a:stretch/>
        </p:blipFill>
        <p:spPr>
          <a:xfrm rot="5400000">
            <a:off x="2065834" y="3952668"/>
            <a:ext cx="3636721" cy="19842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Rectangle 41">
            <a:extLst>
              <a:ext uri="{FF2B5EF4-FFF2-40B4-BE49-F238E27FC236}">
                <a16:creationId xmlns:a16="http://schemas.microsoft.com/office/drawing/2014/main" id="{1942DBF6-CCDE-4CDD-A906-6234B085ACAB}"/>
              </a:ext>
            </a:extLst>
          </p:cNvPr>
          <p:cNvSpPr/>
          <p:nvPr/>
        </p:nvSpPr>
        <p:spPr>
          <a:xfrm>
            <a:off x="4003903" y="4605626"/>
            <a:ext cx="255037" cy="239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164A0FFA-30DA-4197-829D-B61F5F8F483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" t="673" r="1191" b="1347"/>
          <a:stretch/>
        </p:blipFill>
        <p:spPr>
          <a:xfrm rot="5400000">
            <a:off x="4598334" y="3977644"/>
            <a:ext cx="3088686" cy="22388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id="{D97A3787-B623-4A2B-B6C7-6015BDEA2749}"/>
              </a:ext>
            </a:extLst>
          </p:cNvPr>
          <p:cNvSpPr/>
          <p:nvPr/>
        </p:nvSpPr>
        <p:spPr>
          <a:xfrm>
            <a:off x="5537428" y="4333449"/>
            <a:ext cx="255037" cy="239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FEFA859F-04B5-43A4-8204-DA1A028ADB6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96" t="-324" r="375" b="-27"/>
          <a:stretch/>
        </p:blipFill>
        <p:spPr>
          <a:xfrm rot="5400000">
            <a:off x="7051774" y="3867663"/>
            <a:ext cx="3158305" cy="21542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Rectangle 47">
            <a:extLst>
              <a:ext uri="{FF2B5EF4-FFF2-40B4-BE49-F238E27FC236}">
                <a16:creationId xmlns:a16="http://schemas.microsoft.com/office/drawing/2014/main" id="{E4B69102-1136-4E0A-B673-2530C9043E09}"/>
              </a:ext>
            </a:extLst>
          </p:cNvPr>
          <p:cNvSpPr/>
          <p:nvPr/>
        </p:nvSpPr>
        <p:spPr>
          <a:xfrm>
            <a:off x="8309203" y="5205701"/>
            <a:ext cx="329972" cy="239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03FDF01-2762-4BBD-A50C-5848526A93ED}"/>
              </a:ext>
            </a:extLst>
          </p:cNvPr>
          <p:cNvSpPr txBox="1"/>
          <p:nvPr/>
        </p:nvSpPr>
        <p:spPr>
          <a:xfrm>
            <a:off x="3298884" y="482643"/>
            <a:ext cx="37576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E3EC8F9-83FE-470C-ACCC-9DD6AD9C74BF}"/>
              </a:ext>
            </a:extLst>
          </p:cNvPr>
          <p:cNvSpPr txBox="1"/>
          <p:nvPr/>
        </p:nvSpPr>
        <p:spPr>
          <a:xfrm>
            <a:off x="5649815" y="1224085"/>
            <a:ext cx="375760" cy="1576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CCB9680-51FD-4655-B951-65256E0BC2B4}"/>
              </a:ext>
            </a:extLst>
          </p:cNvPr>
          <p:cNvSpPr txBox="1"/>
          <p:nvPr/>
        </p:nvSpPr>
        <p:spPr>
          <a:xfrm>
            <a:off x="9111937" y="1277003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F597C40-A8BF-4CB3-89AC-B9B8992F8456}"/>
              </a:ext>
            </a:extLst>
          </p:cNvPr>
          <p:cNvSpPr txBox="1"/>
          <p:nvPr/>
        </p:nvSpPr>
        <p:spPr>
          <a:xfrm>
            <a:off x="1314459" y="5205701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E6DACDE-7E44-4319-8AF5-01B096CFCD8D}"/>
              </a:ext>
            </a:extLst>
          </p:cNvPr>
          <p:cNvSpPr txBox="1"/>
          <p:nvPr/>
        </p:nvSpPr>
        <p:spPr>
          <a:xfrm>
            <a:off x="3660841" y="4236294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HA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793CF4BE-59AC-44F9-8628-85524D5C25B0}"/>
              </a:ext>
            </a:extLst>
          </p:cNvPr>
          <p:cNvSpPr/>
          <p:nvPr/>
        </p:nvSpPr>
        <p:spPr>
          <a:xfrm>
            <a:off x="3603021" y="4605626"/>
            <a:ext cx="255037" cy="2391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D2180F1-14D7-4E5E-8DF7-C9BBCEA839B0}"/>
              </a:ext>
            </a:extLst>
          </p:cNvPr>
          <p:cNvSpPr txBox="1"/>
          <p:nvPr/>
        </p:nvSpPr>
        <p:spPr>
          <a:xfrm>
            <a:off x="6485552" y="4081401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BEG2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HA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46F542A-CFDB-400F-A0DA-C27C7A13E2FD}"/>
              </a:ext>
            </a:extLst>
          </p:cNvPr>
          <p:cNvSpPr txBox="1"/>
          <p:nvPr/>
        </p:nvSpPr>
        <p:spPr>
          <a:xfrm>
            <a:off x="8009552" y="6057337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BEG2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B: HA</a:t>
            </a:r>
          </a:p>
        </p:txBody>
      </p:sp>
    </p:spTree>
    <p:extLst>
      <p:ext uri="{BB962C8B-B14F-4D97-AF65-F5344CB8AC3E}">
        <p14:creationId xmlns:p14="http://schemas.microsoft.com/office/powerpoint/2010/main" val="11685368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26C24A6-18F4-4341-9B7A-17D41386AE9D}"/>
              </a:ext>
            </a:extLst>
          </p:cNvPr>
          <p:cNvSpPr txBox="1"/>
          <p:nvPr/>
        </p:nvSpPr>
        <p:spPr>
          <a:xfrm>
            <a:off x="1355317" y="328244"/>
            <a:ext cx="545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O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6E64B8D-DD46-4438-B070-87B4275E3D96}"/>
              </a:ext>
            </a:extLst>
          </p:cNvPr>
          <p:cNvSpPr txBox="1"/>
          <p:nvPr/>
        </p:nvSpPr>
        <p:spPr>
          <a:xfrm>
            <a:off x="1785556" y="328244"/>
            <a:ext cx="545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A9188FA-2718-491E-B3EE-9768ACF02826}"/>
              </a:ext>
            </a:extLst>
          </p:cNvPr>
          <p:cNvSpPr txBox="1"/>
          <p:nvPr/>
        </p:nvSpPr>
        <p:spPr>
          <a:xfrm>
            <a:off x="866198" y="328244"/>
            <a:ext cx="545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WT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1918E86-BE87-4220-86E6-C83638643CB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384" t="23443" r="25672" b="29238"/>
          <a:stretch/>
        </p:blipFill>
        <p:spPr>
          <a:xfrm rot="16200000">
            <a:off x="1395793" y="1097899"/>
            <a:ext cx="336491" cy="13740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7A13BA2-D507-46EE-BE04-4068C9FD515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09" t="37929" r="37773" b="25485"/>
          <a:stretch/>
        </p:blipFill>
        <p:spPr>
          <a:xfrm rot="16200000">
            <a:off x="1395793" y="341765"/>
            <a:ext cx="336491" cy="13740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573096E-BD92-490F-867E-BE21AAAFBB4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03" t="62923" r="30092" b="16009"/>
          <a:stretch/>
        </p:blipFill>
        <p:spPr>
          <a:xfrm rot="16200000">
            <a:off x="1395792" y="719831"/>
            <a:ext cx="336491" cy="13740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F3FF233-3E70-4A1D-8906-8AC47EBB0CC3}"/>
              </a:ext>
            </a:extLst>
          </p:cNvPr>
          <p:cNvSpPr txBox="1"/>
          <p:nvPr/>
        </p:nvSpPr>
        <p:spPr>
          <a:xfrm>
            <a:off x="2191525" y="990645"/>
            <a:ext cx="413336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E26FF8-04F0-4743-9D64-2738E5372B75}"/>
              </a:ext>
            </a:extLst>
          </p:cNvPr>
          <p:cNvSpPr txBox="1"/>
          <p:nvPr/>
        </p:nvSpPr>
        <p:spPr>
          <a:xfrm rot="16200000">
            <a:off x="185080" y="1826513"/>
            <a:ext cx="495233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IP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1BB7094-4764-4918-9A0A-4436ECD2315E}"/>
              </a:ext>
            </a:extLst>
          </p:cNvPr>
          <p:cNvCxnSpPr>
            <a:cxnSpLocks/>
          </p:cNvCxnSpPr>
          <p:nvPr/>
        </p:nvCxnSpPr>
        <p:spPr>
          <a:xfrm flipH="1">
            <a:off x="544724" y="847225"/>
            <a:ext cx="1" cy="6521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339C171A-F50E-4DAF-8DB8-968007F4715C}"/>
              </a:ext>
            </a:extLst>
          </p:cNvPr>
          <p:cNvSpPr txBox="1"/>
          <p:nvPr/>
        </p:nvSpPr>
        <p:spPr>
          <a:xfrm>
            <a:off x="2203027" y="665799"/>
            <a:ext cx="7409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 h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74F2389-88DC-48AB-86C2-546C1AB3FD3C}"/>
              </a:ext>
            </a:extLst>
          </p:cNvPr>
          <p:cNvSpPr txBox="1"/>
          <p:nvPr/>
        </p:nvSpPr>
        <p:spPr>
          <a:xfrm>
            <a:off x="2192612" y="1307939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15AD2E-B3B7-401D-A11D-55FC89049E54}"/>
              </a:ext>
            </a:extLst>
          </p:cNvPr>
          <p:cNvSpPr txBox="1"/>
          <p:nvPr/>
        </p:nvSpPr>
        <p:spPr>
          <a:xfrm>
            <a:off x="808127" y="652411"/>
            <a:ext cx="278448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B552B2D-5CF8-407C-9ABB-D1F4AB9521E6}"/>
              </a:ext>
            </a:extLst>
          </p:cNvPr>
          <p:cNvSpPr txBox="1"/>
          <p:nvPr/>
        </p:nvSpPr>
        <p:spPr>
          <a:xfrm>
            <a:off x="1430477" y="663063"/>
            <a:ext cx="173669" cy="1734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5E7B039-0A28-49CF-A848-33CF1070DA22}"/>
              </a:ext>
            </a:extLst>
          </p:cNvPr>
          <p:cNvSpPr txBox="1"/>
          <p:nvPr/>
        </p:nvSpPr>
        <p:spPr>
          <a:xfrm>
            <a:off x="1624400" y="663063"/>
            <a:ext cx="173669" cy="279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89468B5-1592-4AD5-86CB-F241F40D6CD7}"/>
              </a:ext>
            </a:extLst>
          </p:cNvPr>
          <p:cNvSpPr txBox="1"/>
          <p:nvPr/>
        </p:nvSpPr>
        <p:spPr>
          <a:xfrm>
            <a:off x="1832537" y="663063"/>
            <a:ext cx="196551" cy="279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022EDAC-62C0-4250-BBFA-1BCE7F0CFEFF}"/>
              </a:ext>
            </a:extLst>
          </p:cNvPr>
          <p:cNvSpPr txBox="1"/>
          <p:nvPr/>
        </p:nvSpPr>
        <p:spPr>
          <a:xfrm>
            <a:off x="2035129" y="663063"/>
            <a:ext cx="196551" cy="1734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8B731A9-D820-422E-97EA-6E2E2DD3830C}"/>
              </a:ext>
            </a:extLst>
          </p:cNvPr>
          <p:cNvSpPr txBox="1"/>
          <p:nvPr/>
        </p:nvSpPr>
        <p:spPr>
          <a:xfrm>
            <a:off x="1250767" y="663063"/>
            <a:ext cx="173669" cy="1734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5F35C8F-7A67-48F7-806C-371C9A0FCC6B}"/>
              </a:ext>
            </a:extLst>
          </p:cNvPr>
          <p:cNvSpPr txBox="1"/>
          <p:nvPr/>
        </p:nvSpPr>
        <p:spPr>
          <a:xfrm>
            <a:off x="1077097" y="663063"/>
            <a:ext cx="173669" cy="279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3141683-21A3-4EAA-83A9-52BEE9505251}"/>
              </a:ext>
            </a:extLst>
          </p:cNvPr>
          <p:cNvCxnSpPr>
            <a:cxnSpLocks/>
          </p:cNvCxnSpPr>
          <p:nvPr/>
        </p:nvCxnSpPr>
        <p:spPr>
          <a:xfrm flipH="1">
            <a:off x="544724" y="1606005"/>
            <a:ext cx="235" cy="6495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0F989AE7-6078-415D-8AB7-360835616B58}"/>
              </a:ext>
            </a:extLst>
          </p:cNvPr>
          <p:cNvSpPr txBox="1"/>
          <p:nvPr/>
        </p:nvSpPr>
        <p:spPr>
          <a:xfrm>
            <a:off x="485814" y="655953"/>
            <a:ext cx="292900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6E3C77C-50F3-4C55-95CC-3EA39A96340E}"/>
              </a:ext>
            </a:extLst>
          </p:cNvPr>
          <p:cNvSpPr txBox="1"/>
          <p:nvPr/>
        </p:nvSpPr>
        <p:spPr>
          <a:xfrm rot="16200000">
            <a:off x="266977" y="1090433"/>
            <a:ext cx="331439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5EBD1BB-C945-424A-BFFF-49A0C2E78109}"/>
              </a:ext>
            </a:extLst>
          </p:cNvPr>
          <p:cNvSpPr txBox="1"/>
          <p:nvPr/>
        </p:nvSpPr>
        <p:spPr>
          <a:xfrm>
            <a:off x="2185672" y="1688626"/>
            <a:ext cx="413336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DDA15C9-FC93-49C2-BBF8-070B08138B41}"/>
              </a:ext>
            </a:extLst>
          </p:cNvPr>
          <p:cNvSpPr txBox="1"/>
          <p:nvPr/>
        </p:nvSpPr>
        <p:spPr>
          <a:xfrm>
            <a:off x="2215514" y="2005920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1F9F4F4-314A-48D2-94DF-FDAB57B37006}"/>
              </a:ext>
            </a:extLst>
          </p:cNvPr>
          <p:cNvSpPr txBox="1"/>
          <p:nvPr/>
        </p:nvSpPr>
        <p:spPr>
          <a:xfrm>
            <a:off x="305234" y="2581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A5A369B1-2DE8-41D0-A447-55418B1DB68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65649" t="9991" r="28733" b="65774"/>
          <a:stretch/>
        </p:blipFill>
        <p:spPr>
          <a:xfrm rot="16200000">
            <a:off x="1396935" y="1482372"/>
            <a:ext cx="338400" cy="13752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E70395FC-C5D7-48AF-9F8F-3AD10D8C1E10}"/>
              </a:ext>
            </a:extLst>
          </p:cNvPr>
          <p:cNvCxnSpPr/>
          <p:nvPr/>
        </p:nvCxnSpPr>
        <p:spPr>
          <a:xfrm>
            <a:off x="951629" y="678992"/>
            <a:ext cx="40435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35A8350-B2B9-47A3-9786-DF24C7AE40D4}"/>
              </a:ext>
            </a:extLst>
          </p:cNvPr>
          <p:cNvCxnSpPr/>
          <p:nvPr/>
        </p:nvCxnSpPr>
        <p:spPr>
          <a:xfrm>
            <a:off x="1456026" y="678992"/>
            <a:ext cx="33417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4EDBAD88-B45E-4F8A-B12D-4F58FEA1AFD0}"/>
              </a:ext>
            </a:extLst>
          </p:cNvPr>
          <p:cNvCxnSpPr/>
          <p:nvPr/>
        </p:nvCxnSpPr>
        <p:spPr>
          <a:xfrm>
            <a:off x="1890246" y="678992"/>
            <a:ext cx="33417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CA7B6F58-1CF5-4541-8761-62A577B88885}"/>
              </a:ext>
            </a:extLst>
          </p:cNvPr>
          <p:cNvSpPr txBox="1"/>
          <p:nvPr/>
        </p:nvSpPr>
        <p:spPr>
          <a:xfrm>
            <a:off x="477259" y="93186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0EF6B35-4DCE-4468-8640-7A69A37D525E}"/>
              </a:ext>
            </a:extLst>
          </p:cNvPr>
          <p:cNvSpPr txBox="1"/>
          <p:nvPr/>
        </p:nvSpPr>
        <p:spPr>
          <a:xfrm>
            <a:off x="525434" y="132678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72B3497-35B1-4030-9F04-D85531B8E1DB}"/>
              </a:ext>
            </a:extLst>
          </p:cNvPr>
          <p:cNvCxnSpPr/>
          <p:nvPr/>
        </p:nvCxnSpPr>
        <p:spPr>
          <a:xfrm>
            <a:off x="778714" y="104949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6D58F144-1DE3-4AC0-AEE1-48ED2D59AF3E}"/>
              </a:ext>
            </a:extLst>
          </p:cNvPr>
          <p:cNvCxnSpPr/>
          <p:nvPr/>
        </p:nvCxnSpPr>
        <p:spPr>
          <a:xfrm>
            <a:off x="778714" y="143711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C10604E2-0BE3-4DB0-A9DC-1988FCAC121A}"/>
              </a:ext>
            </a:extLst>
          </p:cNvPr>
          <p:cNvSpPr txBox="1"/>
          <p:nvPr/>
        </p:nvSpPr>
        <p:spPr>
          <a:xfrm>
            <a:off x="479637" y="161851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A5A7B23-7710-4E99-8816-9FCF57DCF087}"/>
              </a:ext>
            </a:extLst>
          </p:cNvPr>
          <p:cNvSpPr txBox="1"/>
          <p:nvPr/>
        </p:nvSpPr>
        <p:spPr>
          <a:xfrm>
            <a:off x="527812" y="208329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2FEAACEA-E92E-4444-98DF-DC672897F4E0}"/>
              </a:ext>
            </a:extLst>
          </p:cNvPr>
          <p:cNvCxnSpPr/>
          <p:nvPr/>
        </p:nvCxnSpPr>
        <p:spPr>
          <a:xfrm>
            <a:off x="781092" y="173614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38CA4D55-C2D8-4A81-98FE-3BDBA1A7EDBD}"/>
              </a:ext>
            </a:extLst>
          </p:cNvPr>
          <p:cNvCxnSpPr/>
          <p:nvPr/>
        </p:nvCxnSpPr>
        <p:spPr>
          <a:xfrm>
            <a:off x="781092" y="219361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04EFB4F0-5A70-4369-A172-1479FB297857}"/>
              </a:ext>
            </a:extLst>
          </p:cNvPr>
          <p:cNvSpPr txBox="1"/>
          <p:nvPr/>
        </p:nvSpPr>
        <p:spPr>
          <a:xfrm>
            <a:off x="785257" y="2307937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F951747A-A0D7-4094-A424-B36EEBE09C2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" t="-448" r="-223" b="-305"/>
          <a:stretch/>
        </p:blipFill>
        <p:spPr>
          <a:xfrm rot="16200000">
            <a:off x="3144831" y="569837"/>
            <a:ext cx="3317907" cy="25844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Rectangle 40">
            <a:extLst>
              <a:ext uri="{FF2B5EF4-FFF2-40B4-BE49-F238E27FC236}">
                <a16:creationId xmlns:a16="http://schemas.microsoft.com/office/drawing/2014/main" id="{D2529630-6003-4D16-884B-9E1AB761ED34}"/>
              </a:ext>
            </a:extLst>
          </p:cNvPr>
          <p:cNvSpPr/>
          <p:nvPr/>
        </p:nvSpPr>
        <p:spPr>
          <a:xfrm>
            <a:off x="4391025" y="1499341"/>
            <a:ext cx="1207325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16CC2216-B445-4694-9E11-2290B1CFF3B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" t="403" r="372" b="-110"/>
          <a:stretch/>
        </p:blipFill>
        <p:spPr>
          <a:xfrm rot="16200000">
            <a:off x="6081099" y="396449"/>
            <a:ext cx="3465446" cy="30335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FAEB797B-026A-4FBA-9A26-F487BDAE0B1A}"/>
              </a:ext>
            </a:extLst>
          </p:cNvPr>
          <p:cNvSpPr/>
          <p:nvPr/>
        </p:nvSpPr>
        <p:spPr>
          <a:xfrm>
            <a:off x="8099037" y="1166383"/>
            <a:ext cx="814816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D5B5C734-60E0-41BE-B84F-EBE3683BBF8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1" t="-473" r="260" b="858"/>
          <a:stretch/>
        </p:blipFill>
        <p:spPr>
          <a:xfrm rot="16200000">
            <a:off x="8864833" y="833477"/>
            <a:ext cx="3281576" cy="19756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Rectangle 44">
            <a:extLst>
              <a:ext uri="{FF2B5EF4-FFF2-40B4-BE49-F238E27FC236}">
                <a16:creationId xmlns:a16="http://schemas.microsoft.com/office/drawing/2014/main" id="{603B9E2E-ED3E-4B75-AA33-B9A3166CAA56}"/>
              </a:ext>
            </a:extLst>
          </p:cNvPr>
          <p:cNvSpPr/>
          <p:nvPr/>
        </p:nvSpPr>
        <p:spPr>
          <a:xfrm>
            <a:off x="9867900" y="1012071"/>
            <a:ext cx="1045129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CD248093-9F2D-4A1B-AC0D-AE8B1FDB532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-43" t="235" r="-371" b="528"/>
          <a:stretch/>
        </p:blipFill>
        <p:spPr>
          <a:xfrm rot="16200000">
            <a:off x="27963" y="3422291"/>
            <a:ext cx="3414150" cy="31786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7" name="Rectangle 46">
            <a:extLst>
              <a:ext uri="{FF2B5EF4-FFF2-40B4-BE49-F238E27FC236}">
                <a16:creationId xmlns:a16="http://schemas.microsoft.com/office/drawing/2014/main" id="{A0DD897C-565B-421A-8D55-E02D458DB462}"/>
              </a:ext>
            </a:extLst>
          </p:cNvPr>
          <p:cNvSpPr/>
          <p:nvPr/>
        </p:nvSpPr>
        <p:spPr>
          <a:xfrm>
            <a:off x="345982" y="4241714"/>
            <a:ext cx="961839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76DF236-8577-464C-AB2F-BF9E7A09147F}"/>
              </a:ext>
            </a:extLst>
          </p:cNvPr>
          <p:cNvSpPr txBox="1"/>
          <p:nvPr/>
        </p:nvSpPr>
        <p:spPr>
          <a:xfrm>
            <a:off x="5621764" y="1529941"/>
            <a:ext cx="413336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0A70594-FBF9-4D77-9EAA-5DFA5C83E853}"/>
              </a:ext>
            </a:extLst>
          </p:cNvPr>
          <p:cNvSpPr txBox="1"/>
          <p:nvPr/>
        </p:nvSpPr>
        <p:spPr>
          <a:xfrm>
            <a:off x="8195647" y="1459663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E113162-22A4-4495-AE28-E2ED2C6D09D1}"/>
              </a:ext>
            </a:extLst>
          </p:cNvPr>
          <p:cNvSpPr txBox="1"/>
          <p:nvPr/>
        </p:nvSpPr>
        <p:spPr>
          <a:xfrm>
            <a:off x="9449126" y="1067693"/>
            <a:ext cx="413336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ECDFC7E-A874-4DB7-B456-93ABA83D12AC}"/>
              </a:ext>
            </a:extLst>
          </p:cNvPr>
          <p:cNvSpPr txBox="1"/>
          <p:nvPr/>
        </p:nvSpPr>
        <p:spPr>
          <a:xfrm>
            <a:off x="1311102" y="4269610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</p:spTree>
    <p:extLst>
      <p:ext uri="{BB962C8B-B14F-4D97-AF65-F5344CB8AC3E}">
        <p14:creationId xmlns:p14="http://schemas.microsoft.com/office/powerpoint/2010/main" val="21978209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219F376-6AC5-4313-AB76-05D3AB71351A}"/>
              </a:ext>
            </a:extLst>
          </p:cNvPr>
          <p:cNvSpPr txBox="1"/>
          <p:nvPr/>
        </p:nvSpPr>
        <p:spPr>
          <a:xfrm>
            <a:off x="138966" y="11332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77124CB-7F61-48DE-9291-3C046CFB5368}"/>
              </a:ext>
            </a:extLst>
          </p:cNvPr>
          <p:cNvSpPr txBox="1"/>
          <p:nvPr/>
        </p:nvSpPr>
        <p:spPr>
          <a:xfrm>
            <a:off x="810629" y="46875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EF123B8-DFC2-41B1-A4A3-216CC71B51FB}"/>
              </a:ext>
            </a:extLst>
          </p:cNvPr>
          <p:cNvSpPr txBox="1"/>
          <p:nvPr/>
        </p:nvSpPr>
        <p:spPr>
          <a:xfrm>
            <a:off x="997082" y="46875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FE2F6A5-8B40-4B93-8D73-83672AD22B94}"/>
              </a:ext>
            </a:extLst>
          </p:cNvPr>
          <p:cNvSpPr txBox="1"/>
          <p:nvPr/>
        </p:nvSpPr>
        <p:spPr>
          <a:xfrm>
            <a:off x="1183536" y="46875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07FCAF-360A-4159-A639-F483815A660F}"/>
              </a:ext>
            </a:extLst>
          </p:cNvPr>
          <p:cNvSpPr txBox="1"/>
          <p:nvPr/>
        </p:nvSpPr>
        <p:spPr>
          <a:xfrm>
            <a:off x="1390791" y="46875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78AB177B-3AB1-4F51-A118-15637CD398F5}"/>
              </a:ext>
            </a:extLst>
          </p:cNvPr>
          <p:cNvCxnSpPr/>
          <p:nvPr/>
        </p:nvCxnSpPr>
        <p:spPr>
          <a:xfrm>
            <a:off x="685492" y="373697"/>
            <a:ext cx="798174" cy="193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AA474611-44E2-4A87-A613-A781AEE679AB}"/>
              </a:ext>
            </a:extLst>
          </p:cNvPr>
          <p:cNvSpPr txBox="1"/>
          <p:nvPr/>
        </p:nvSpPr>
        <p:spPr>
          <a:xfrm>
            <a:off x="885478" y="17369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E87A2D-ED16-44EE-A1BC-C2F8A9A96CE3}"/>
              </a:ext>
            </a:extLst>
          </p:cNvPr>
          <p:cNvSpPr txBox="1"/>
          <p:nvPr/>
        </p:nvSpPr>
        <p:spPr>
          <a:xfrm>
            <a:off x="624176" y="46875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D6DFF50-54E8-43F1-B1D6-C0E5677579CE}"/>
              </a:ext>
            </a:extLst>
          </p:cNvPr>
          <p:cNvSpPr txBox="1"/>
          <p:nvPr/>
        </p:nvSpPr>
        <p:spPr>
          <a:xfrm>
            <a:off x="810629" y="346162"/>
            <a:ext cx="1578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1ACD153-FD9E-418D-BDC9-2893F8AF8D96}"/>
              </a:ext>
            </a:extLst>
          </p:cNvPr>
          <p:cNvSpPr txBox="1"/>
          <p:nvPr/>
        </p:nvSpPr>
        <p:spPr>
          <a:xfrm>
            <a:off x="997082" y="346162"/>
            <a:ext cx="1578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EC5CCF1-FB6A-4D6E-B9BB-DB9254CD9B1B}"/>
              </a:ext>
            </a:extLst>
          </p:cNvPr>
          <p:cNvSpPr txBox="1"/>
          <p:nvPr/>
        </p:nvSpPr>
        <p:spPr>
          <a:xfrm>
            <a:off x="1183536" y="346162"/>
            <a:ext cx="1786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6CB8C0B-365C-472B-9BD5-41A1607966A9}"/>
              </a:ext>
            </a:extLst>
          </p:cNvPr>
          <p:cNvSpPr txBox="1"/>
          <p:nvPr/>
        </p:nvSpPr>
        <p:spPr>
          <a:xfrm>
            <a:off x="1390791" y="346162"/>
            <a:ext cx="1786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E26D758-4A01-49E4-A44D-6681755905E3}"/>
              </a:ext>
            </a:extLst>
          </p:cNvPr>
          <p:cNvSpPr txBox="1"/>
          <p:nvPr/>
        </p:nvSpPr>
        <p:spPr>
          <a:xfrm>
            <a:off x="624176" y="346162"/>
            <a:ext cx="1578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547CD9A-22AE-477E-962C-66D333098F75}"/>
              </a:ext>
            </a:extLst>
          </p:cNvPr>
          <p:cNvSpPr txBox="1"/>
          <p:nvPr/>
        </p:nvSpPr>
        <p:spPr>
          <a:xfrm>
            <a:off x="2602556" y="73418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9380862-57EF-45FB-964C-4D1A197E847B}"/>
              </a:ext>
            </a:extLst>
          </p:cNvPr>
          <p:cNvSpPr txBox="1"/>
          <p:nvPr/>
        </p:nvSpPr>
        <p:spPr>
          <a:xfrm>
            <a:off x="1784129" y="173693"/>
            <a:ext cx="6591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I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0176208-B9B6-49BF-BF8F-8D16DC151A02}"/>
              </a:ext>
            </a:extLst>
          </p:cNvPr>
          <p:cNvSpPr txBox="1"/>
          <p:nvPr/>
        </p:nvSpPr>
        <p:spPr>
          <a:xfrm>
            <a:off x="1855777" y="46875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FEDE59B-0672-4504-8FF9-33CDD9960CC8}"/>
              </a:ext>
            </a:extLst>
          </p:cNvPr>
          <p:cNvSpPr txBox="1"/>
          <p:nvPr/>
        </p:nvSpPr>
        <p:spPr>
          <a:xfrm>
            <a:off x="2032071" y="46875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FB0403A-3637-48B6-BCBA-A5CE399374E2}"/>
              </a:ext>
            </a:extLst>
          </p:cNvPr>
          <p:cNvSpPr txBox="1"/>
          <p:nvPr/>
        </p:nvSpPr>
        <p:spPr>
          <a:xfrm>
            <a:off x="2208365" y="46875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6D2A5F6-16E5-47C8-894E-EF10E11F3D41}"/>
              </a:ext>
            </a:extLst>
          </p:cNvPr>
          <p:cNvSpPr txBox="1"/>
          <p:nvPr/>
        </p:nvSpPr>
        <p:spPr>
          <a:xfrm>
            <a:off x="2405461" y="468755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7AD94663-A04D-4FF1-A950-2DAFDE9293E2}"/>
              </a:ext>
            </a:extLst>
          </p:cNvPr>
          <p:cNvCxnSpPr/>
          <p:nvPr/>
        </p:nvCxnSpPr>
        <p:spPr>
          <a:xfrm>
            <a:off x="1733646" y="373697"/>
            <a:ext cx="798174" cy="193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F25AF3B6-920E-4EBE-8462-FCF1ED5CF227}"/>
              </a:ext>
            </a:extLst>
          </p:cNvPr>
          <p:cNvSpPr txBox="1"/>
          <p:nvPr/>
        </p:nvSpPr>
        <p:spPr>
          <a:xfrm>
            <a:off x="1679483" y="468755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3FAF14A-7386-4590-820C-BF1A8F8DDDB0}"/>
              </a:ext>
            </a:extLst>
          </p:cNvPr>
          <p:cNvSpPr txBox="1"/>
          <p:nvPr/>
        </p:nvSpPr>
        <p:spPr>
          <a:xfrm>
            <a:off x="1855777" y="346162"/>
            <a:ext cx="1578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D117203-9805-43F4-8966-CEA08EBF8263}"/>
              </a:ext>
            </a:extLst>
          </p:cNvPr>
          <p:cNvSpPr txBox="1"/>
          <p:nvPr/>
        </p:nvSpPr>
        <p:spPr>
          <a:xfrm>
            <a:off x="2032071" y="346162"/>
            <a:ext cx="1578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10BE83F-55C8-4916-A471-960AAA988DD2}"/>
              </a:ext>
            </a:extLst>
          </p:cNvPr>
          <p:cNvSpPr txBox="1"/>
          <p:nvPr/>
        </p:nvSpPr>
        <p:spPr>
          <a:xfrm>
            <a:off x="2208365" y="346162"/>
            <a:ext cx="1786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0E3CC02-0A60-40A3-A00A-75BFF06AABD6}"/>
              </a:ext>
            </a:extLst>
          </p:cNvPr>
          <p:cNvSpPr txBox="1"/>
          <p:nvPr/>
        </p:nvSpPr>
        <p:spPr>
          <a:xfrm>
            <a:off x="2405461" y="346162"/>
            <a:ext cx="1786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4689B0D-CD1D-4C18-8B92-4209BFF2BD69}"/>
              </a:ext>
            </a:extLst>
          </p:cNvPr>
          <p:cNvSpPr txBox="1"/>
          <p:nvPr/>
        </p:nvSpPr>
        <p:spPr>
          <a:xfrm>
            <a:off x="1679483" y="346162"/>
            <a:ext cx="15788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4A0EC5E-98C3-499C-B3A2-48B677FC5880}"/>
              </a:ext>
            </a:extLst>
          </p:cNvPr>
          <p:cNvSpPr txBox="1"/>
          <p:nvPr/>
        </p:nvSpPr>
        <p:spPr>
          <a:xfrm>
            <a:off x="2602556" y="473021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066A984-3BCF-4C8B-A896-48CF4328E34A}"/>
              </a:ext>
            </a:extLst>
          </p:cNvPr>
          <p:cNvSpPr txBox="1"/>
          <p:nvPr/>
        </p:nvSpPr>
        <p:spPr>
          <a:xfrm>
            <a:off x="2602556" y="345911"/>
            <a:ext cx="7409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 h 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E68201C-6511-47C9-9C27-D0476C31886B}"/>
              </a:ext>
            </a:extLst>
          </p:cNvPr>
          <p:cNvSpPr txBox="1"/>
          <p:nvPr/>
        </p:nvSpPr>
        <p:spPr>
          <a:xfrm>
            <a:off x="2604003" y="1055605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31A4D37-C9FA-4BF5-912F-16CD7C777BF1}"/>
              </a:ext>
            </a:extLst>
          </p:cNvPr>
          <p:cNvSpPr txBox="1"/>
          <p:nvPr/>
        </p:nvSpPr>
        <p:spPr>
          <a:xfrm>
            <a:off x="2601660" y="1367662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64969D9-CC86-4775-B7B9-5BD5E2C78FBC}"/>
              </a:ext>
            </a:extLst>
          </p:cNvPr>
          <p:cNvSpPr txBox="1"/>
          <p:nvPr/>
        </p:nvSpPr>
        <p:spPr>
          <a:xfrm>
            <a:off x="198461" y="440725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FFEF1708-8396-4F50-810A-34AB5C6DFB7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18" t="13981" r="69485" b="72853"/>
          <a:stretch/>
        </p:blipFill>
        <p:spPr>
          <a:xfrm rot="16200000">
            <a:off x="947838" y="655965"/>
            <a:ext cx="295062" cy="9835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6A3A881E-EE2B-4827-A8F9-A78DE5062A8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342" t="13326" r="15802" b="73508"/>
          <a:stretch/>
        </p:blipFill>
        <p:spPr>
          <a:xfrm rot="16200000">
            <a:off x="947838" y="999487"/>
            <a:ext cx="295062" cy="9835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ADB44F98-DC3B-4A07-A992-F81AACA0864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730" t="26594" r="51635" b="60239"/>
          <a:stretch/>
        </p:blipFill>
        <p:spPr>
          <a:xfrm rot="16200000">
            <a:off x="1979066" y="998889"/>
            <a:ext cx="295062" cy="9835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A6AAFB52-896D-40ED-80AB-D815F07753C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13" t="48762" r="32776" b="12772"/>
          <a:stretch/>
        </p:blipFill>
        <p:spPr>
          <a:xfrm rot="16200000">
            <a:off x="1979066" y="313459"/>
            <a:ext cx="295062" cy="9835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ED727F6A-E77C-4D93-9703-DDC5D67F693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916" t="13521" r="18630" b="47933"/>
          <a:stretch/>
        </p:blipFill>
        <p:spPr>
          <a:xfrm rot="16200000">
            <a:off x="947838" y="313711"/>
            <a:ext cx="295062" cy="9835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9F3621E6-96A1-4A39-BD07-3A90EC5CDDF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388" t="26546" r="37114" b="60287"/>
          <a:stretch/>
        </p:blipFill>
        <p:spPr>
          <a:xfrm rot="16200000">
            <a:off x="1978997" y="654675"/>
            <a:ext cx="295200" cy="9835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74E15099-8C98-4AC8-B954-D5759F5BC7C7}"/>
              </a:ext>
            </a:extLst>
          </p:cNvPr>
          <p:cNvSpPr txBox="1"/>
          <p:nvPr/>
        </p:nvSpPr>
        <p:spPr>
          <a:xfrm>
            <a:off x="201202" y="61691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4599040-E771-4E40-A608-EE8474746D53}"/>
              </a:ext>
            </a:extLst>
          </p:cNvPr>
          <p:cNvSpPr txBox="1"/>
          <p:nvPr/>
        </p:nvSpPr>
        <p:spPr>
          <a:xfrm>
            <a:off x="249377" y="11451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617C13EE-2257-4338-B951-C2B890705BF6}"/>
              </a:ext>
            </a:extLst>
          </p:cNvPr>
          <p:cNvCxnSpPr/>
          <p:nvPr/>
        </p:nvCxnSpPr>
        <p:spPr>
          <a:xfrm>
            <a:off x="502657" y="73454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1391A7A1-6C27-4812-8373-69FD74376AB5}"/>
              </a:ext>
            </a:extLst>
          </p:cNvPr>
          <p:cNvCxnSpPr/>
          <p:nvPr/>
        </p:nvCxnSpPr>
        <p:spPr>
          <a:xfrm>
            <a:off x="502657" y="125551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2942628A-4FAF-4DA7-BFD8-99D864EA9F25}"/>
              </a:ext>
            </a:extLst>
          </p:cNvPr>
          <p:cNvSpPr txBox="1"/>
          <p:nvPr/>
        </p:nvSpPr>
        <p:spPr>
          <a:xfrm>
            <a:off x="244299" y="14563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13078D7D-2D88-47F4-8C2F-1A684AD59CC9}"/>
              </a:ext>
            </a:extLst>
          </p:cNvPr>
          <p:cNvCxnSpPr/>
          <p:nvPr/>
        </p:nvCxnSpPr>
        <p:spPr>
          <a:xfrm>
            <a:off x="505035" y="157359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C2654015-51DC-439F-B679-0DDF0BACDAA2}"/>
              </a:ext>
            </a:extLst>
          </p:cNvPr>
          <p:cNvSpPr txBox="1"/>
          <p:nvPr/>
        </p:nvSpPr>
        <p:spPr>
          <a:xfrm>
            <a:off x="509406" y="1610651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C7D9E36B-7224-411F-A929-7B53A47F3C8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" t="-341" r="-1651" b="-535"/>
          <a:stretch/>
        </p:blipFill>
        <p:spPr>
          <a:xfrm rot="16200000">
            <a:off x="2752393" y="1108276"/>
            <a:ext cx="3747972" cy="17580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Rectangle 47">
            <a:extLst>
              <a:ext uri="{FF2B5EF4-FFF2-40B4-BE49-F238E27FC236}">
                <a16:creationId xmlns:a16="http://schemas.microsoft.com/office/drawing/2014/main" id="{B5185257-9DB7-478F-8180-F590824DA222}"/>
              </a:ext>
            </a:extLst>
          </p:cNvPr>
          <p:cNvSpPr/>
          <p:nvPr/>
        </p:nvSpPr>
        <p:spPr>
          <a:xfrm>
            <a:off x="3922429" y="795100"/>
            <a:ext cx="744821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856C9402-2C6E-452B-B346-1D3C39E8D99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5" t="-1061" r="-74" b="1012"/>
          <a:stretch/>
        </p:blipFill>
        <p:spPr>
          <a:xfrm rot="16200000">
            <a:off x="4974086" y="724876"/>
            <a:ext cx="2983456" cy="17472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Rectangle 49">
            <a:extLst>
              <a:ext uri="{FF2B5EF4-FFF2-40B4-BE49-F238E27FC236}">
                <a16:creationId xmlns:a16="http://schemas.microsoft.com/office/drawing/2014/main" id="{25D9928E-5627-44A1-B5B5-012852501E1E}"/>
              </a:ext>
            </a:extLst>
          </p:cNvPr>
          <p:cNvSpPr/>
          <p:nvPr/>
        </p:nvSpPr>
        <p:spPr>
          <a:xfrm>
            <a:off x="6405694" y="1033540"/>
            <a:ext cx="744821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FF63E569-5736-43B6-AD3B-3BC714D5EE3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82" t="-49" r="-20" b="419"/>
          <a:stretch/>
        </p:blipFill>
        <p:spPr>
          <a:xfrm rot="16200000">
            <a:off x="8072597" y="-534075"/>
            <a:ext cx="3339595" cy="46212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Rectangle 51">
            <a:extLst>
              <a:ext uri="{FF2B5EF4-FFF2-40B4-BE49-F238E27FC236}">
                <a16:creationId xmlns:a16="http://schemas.microsoft.com/office/drawing/2014/main" id="{89C2741B-64F1-4BCC-BB94-AFDA50B3D541}"/>
              </a:ext>
            </a:extLst>
          </p:cNvPr>
          <p:cNvSpPr/>
          <p:nvPr/>
        </p:nvSpPr>
        <p:spPr>
          <a:xfrm>
            <a:off x="7992418" y="1237409"/>
            <a:ext cx="744821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FA223F06-9C36-4371-9963-91CF6707445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9" t="-315" r="-9" b="-873"/>
          <a:stretch/>
        </p:blipFill>
        <p:spPr>
          <a:xfrm rot="16200000">
            <a:off x="-49540" y="2962282"/>
            <a:ext cx="3917950" cy="35261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Rectangle 53">
            <a:extLst>
              <a:ext uri="{FF2B5EF4-FFF2-40B4-BE49-F238E27FC236}">
                <a16:creationId xmlns:a16="http://schemas.microsoft.com/office/drawing/2014/main" id="{A8A75E76-E980-4008-AB1F-2947C1DF19D8}"/>
              </a:ext>
            </a:extLst>
          </p:cNvPr>
          <p:cNvSpPr/>
          <p:nvPr/>
        </p:nvSpPr>
        <p:spPr>
          <a:xfrm>
            <a:off x="1046231" y="4157663"/>
            <a:ext cx="523243" cy="1381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C52960BB-7450-4807-8628-D62BEF09C05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9" t="423" r="-1076" b="-290"/>
          <a:stretch/>
        </p:blipFill>
        <p:spPr>
          <a:xfrm rot="16200000">
            <a:off x="5015148" y="2860340"/>
            <a:ext cx="2559915" cy="50955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Rectangle 55">
            <a:extLst>
              <a:ext uri="{FF2B5EF4-FFF2-40B4-BE49-F238E27FC236}">
                <a16:creationId xmlns:a16="http://schemas.microsoft.com/office/drawing/2014/main" id="{2EA82ACF-CD5A-466D-99C1-343D79861360}"/>
              </a:ext>
            </a:extLst>
          </p:cNvPr>
          <p:cNvSpPr/>
          <p:nvPr/>
        </p:nvSpPr>
        <p:spPr>
          <a:xfrm>
            <a:off x="4295722" y="4543073"/>
            <a:ext cx="744821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3B6111FD-79A5-476A-BE76-DAB21002030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" t="1011" r="703" b="606"/>
          <a:stretch/>
        </p:blipFill>
        <p:spPr>
          <a:xfrm rot="16200000">
            <a:off x="8039465" y="2739412"/>
            <a:ext cx="3007654" cy="50194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8" name="Rectangle 57">
            <a:extLst>
              <a:ext uri="{FF2B5EF4-FFF2-40B4-BE49-F238E27FC236}">
                <a16:creationId xmlns:a16="http://schemas.microsoft.com/office/drawing/2014/main" id="{56D24C79-3F32-438C-9C12-E93C1EE8D4FA}"/>
              </a:ext>
            </a:extLst>
          </p:cNvPr>
          <p:cNvSpPr/>
          <p:nvPr/>
        </p:nvSpPr>
        <p:spPr>
          <a:xfrm>
            <a:off x="8364828" y="5277845"/>
            <a:ext cx="744821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1DF3DA2-E8BC-443B-B864-A1CCC2BB237F}"/>
              </a:ext>
            </a:extLst>
          </p:cNvPr>
          <p:cNvSpPr txBox="1"/>
          <p:nvPr/>
        </p:nvSpPr>
        <p:spPr>
          <a:xfrm>
            <a:off x="4034855" y="57439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DF1B60F-5246-4CC9-A5F1-62AD3ACD1415}"/>
              </a:ext>
            </a:extLst>
          </p:cNvPr>
          <p:cNvSpPr txBox="1"/>
          <p:nvPr/>
        </p:nvSpPr>
        <p:spPr>
          <a:xfrm>
            <a:off x="6558825" y="822396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2959A97-E075-4A0A-A921-2BB944CE9A72}"/>
              </a:ext>
            </a:extLst>
          </p:cNvPr>
          <p:cNvSpPr txBox="1"/>
          <p:nvPr/>
        </p:nvSpPr>
        <p:spPr>
          <a:xfrm>
            <a:off x="8047017" y="998844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8A2DF24-F10F-42FE-97CD-8514B57E1A39}"/>
              </a:ext>
            </a:extLst>
          </p:cNvPr>
          <p:cNvSpPr txBox="1"/>
          <p:nvPr/>
        </p:nvSpPr>
        <p:spPr>
          <a:xfrm>
            <a:off x="1272877" y="4288779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8C4E259-1632-4015-98B8-38C371F6493E}"/>
              </a:ext>
            </a:extLst>
          </p:cNvPr>
          <p:cNvSpPr txBox="1"/>
          <p:nvPr/>
        </p:nvSpPr>
        <p:spPr>
          <a:xfrm>
            <a:off x="4283086" y="4315922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FBC237D-1D02-4ACF-A545-019FF8A45524}"/>
              </a:ext>
            </a:extLst>
          </p:cNvPr>
          <p:cNvSpPr txBox="1"/>
          <p:nvPr/>
        </p:nvSpPr>
        <p:spPr>
          <a:xfrm>
            <a:off x="8466971" y="5048175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89098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63C8866-C39C-4EFB-BB19-F2A318E3C28B}"/>
              </a:ext>
            </a:extLst>
          </p:cNvPr>
          <p:cNvSpPr txBox="1"/>
          <p:nvPr/>
        </p:nvSpPr>
        <p:spPr>
          <a:xfrm>
            <a:off x="146448" y="36620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ED3CD7B-4639-42A3-A3CE-E963CCD0D8B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69" t="18962" r="75493" b="68092"/>
          <a:stretch/>
        </p:blipFill>
        <p:spPr>
          <a:xfrm rot="5400000">
            <a:off x="1096388" y="652227"/>
            <a:ext cx="284658" cy="7303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7FE9D02-4166-4E2C-8626-8A9312CBA4D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83" t="18745" r="69079" b="68309"/>
          <a:stretch/>
        </p:blipFill>
        <p:spPr>
          <a:xfrm rot="5400000">
            <a:off x="1096388" y="963139"/>
            <a:ext cx="284658" cy="7303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C03DF17-3D69-4A4F-809E-BBAE8F4DD6F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09" t="18917" r="59841" b="68625"/>
          <a:stretch/>
        </p:blipFill>
        <p:spPr>
          <a:xfrm rot="5400000">
            <a:off x="1096387" y="1275646"/>
            <a:ext cx="284659" cy="7303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617525D-2A4D-4517-B397-3C492B0BD00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26" t="24500" r="50224" b="51071"/>
          <a:stretch/>
        </p:blipFill>
        <p:spPr>
          <a:xfrm rot="5400000">
            <a:off x="1096388" y="341316"/>
            <a:ext cx="284659" cy="7303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A052638-8930-4564-A55B-0484D1A2CB7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24" t="25502" r="38426" b="50069"/>
          <a:stretch/>
        </p:blipFill>
        <p:spPr>
          <a:xfrm rot="5400000">
            <a:off x="1096386" y="1597662"/>
            <a:ext cx="284659" cy="7303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2F495DB-E401-40D0-BFAE-033361E41EA1}"/>
              </a:ext>
            </a:extLst>
          </p:cNvPr>
          <p:cNvSpPr txBox="1"/>
          <p:nvPr/>
        </p:nvSpPr>
        <p:spPr>
          <a:xfrm>
            <a:off x="1600371" y="382036"/>
            <a:ext cx="8771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siRN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BD6C89C-8095-4A66-9BCA-1F559C3DE5D1}"/>
              </a:ext>
            </a:extLst>
          </p:cNvPr>
          <p:cNvSpPr txBox="1"/>
          <p:nvPr/>
        </p:nvSpPr>
        <p:spPr>
          <a:xfrm>
            <a:off x="827122" y="366206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C95F9CC-D63C-461D-84FD-5CB2FADD3F88}"/>
              </a:ext>
            </a:extLst>
          </p:cNvPr>
          <p:cNvSpPr txBox="1"/>
          <p:nvPr/>
        </p:nvSpPr>
        <p:spPr>
          <a:xfrm>
            <a:off x="1007997" y="366206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AADEE6E-04FC-4B93-83CB-0E348AE22459}"/>
              </a:ext>
            </a:extLst>
          </p:cNvPr>
          <p:cNvSpPr txBox="1"/>
          <p:nvPr/>
        </p:nvSpPr>
        <p:spPr>
          <a:xfrm>
            <a:off x="1209674" y="366206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4CB6EA-AC37-4DB1-924F-02494149CF6E}"/>
              </a:ext>
            </a:extLst>
          </p:cNvPr>
          <p:cNvSpPr txBox="1"/>
          <p:nvPr/>
        </p:nvSpPr>
        <p:spPr>
          <a:xfrm>
            <a:off x="1390550" y="366206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6E3E24A-9DFB-45E0-BCA9-2F43662F97BF}"/>
              </a:ext>
            </a:extLst>
          </p:cNvPr>
          <p:cNvSpPr txBox="1"/>
          <p:nvPr/>
        </p:nvSpPr>
        <p:spPr>
          <a:xfrm>
            <a:off x="1602561" y="217167"/>
            <a:ext cx="5485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114DDAC-4232-45AE-B6FB-5755AA7C820B}"/>
              </a:ext>
            </a:extLst>
          </p:cNvPr>
          <p:cNvSpPr txBox="1"/>
          <p:nvPr/>
        </p:nvSpPr>
        <p:spPr>
          <a:xfrm>
            <a:off x="826990" y="217167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DA3F5C0-B86D-4264-A30F-4FBAF89813D4}"/>
              </a:ext>
            </a:extLst>
          </p:cNvPr>
          <p:cNvSpPr txBox="1"/>
          <p:nvPr/>
        </p:nvSpPr>
        <p:spPr>
          <a:xfrm>
            <a:off x="1007865" y="217167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121C06D-AA9A-48D0-95D3-54B485BB3173}"/>
              </a:ext>
            </a:extLst>
          </p:cNvPr>
          <p:cNvSpPr txBox="1"/>
          <p:nvPr/>
        </p:nvSpPr>
        <p:spPr>
          <a:xfrm>
            <a:off x="1209542" y="217167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A6093D7-D5D7-4B03-AE7F-408F6A9CD163}"/>
              </a:ext>
            </a:extLst>
          </p:cNvPr>
          <p:cNvSpPr txBox="1"/>
          <p:nvPr/>
        </p:nvSpPr>
        <p:spPr>
          <a:xfrm>
            <a:off x="1390417" y="217167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7D5847E-054E-4319-9401-9DB12CCBA6ED}"/>
              </a:ext>
            </a:extLst>
          </p:cNvPr>
          <p:cNvSpPr txBox="1"/>
          <p:nvPr/>
        </p:nvSpPr>
        <p:spPr>
          <a:xfrm>
            <a:off x="1603203" y="59463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351F541-8C67-4C3D-B514-25CB8A988898}"/>
              </a:ext>
            </a:extLst>
          </p:cNvPr>
          <p:cNvSpPr txBox="1"/>
          <p:nvPr/>
        </p:nvSpPr>
        <p:spPr>
          <a:xfrm>
            <a:off x="1603203" y="902352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93E1D1C-49CF-46F1-8D5D-664F7DFE145D}"/>
              </a:ext>
            </a:extLst>
          </p:cNvPr>
          <p:cNvSpPr txBox="1"/>
          <p:nvPr/>
        </p:nvSpPr>
        <p:spPr>
          <a:xfrm>
            <a:off x="1603203" y="1202864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9A96721-7B0A-42F3-BD02-F3978615A650}"/>
              </a:ext>
            </a:extLst>
          </p:cNvPr>
          <p:cNvSpPr txBox="1"/>
          <p:nvPr/>
        </p:nvSpPr>
        <p:spPr>
          <a:xfrm>
            <a:off x="1603203" y="1519163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8E2950D-05C3-4C9A-9D4B-96E4C284491B}"/>
              </a:ext>
            </a:extLst>
          </p:cNvPr>
          <p:cNvSpPr txBox="1"/>
          <p:nvPr/>
        </p:nvSpPr>
        <p:spPr>
          <a:xfrm>
            <a:off x="1603203" y="1823141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3F40CCC-8A17-4F53-BDEA-8F38A41F450F}"/>
              </a:ext>
            </a:extLst>
          </p:cNvPr>
          <p:cNvSpPr txBox="1"/>
          <p:nvPr/>
        </p:nvSpPr>
        <p:spPr>
          <a:xfrm>
            <a:off x="790492" y="2077593"/>
            <a:ext cx="12939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-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hE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22F13DC-586F-4A6F-9FE3-7C15B37CF481}"/>
              </a:ext>
            </a:extLst>
          </p:cNvPr>
          <p:cNvSpPr txBox="1"/>
          <p:nvPr/>
        </p:nvSpPr>
        <p:spPr>
          <a:xfrm>
            <a:off x="472915" y="336990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099B6D8-ABA8-4525-A0F2-4A9FFE79268B}"/>
              </a:ext>
            </a:extLst>
          </p:cNvPr>
          <p:cNvSpPr txBox="1"/>
          <p:nvPr/>
        </p:nvSpPr>
        <p:spPr>
          <a:xfrm>
            <a:off x="472873" y="50395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40DF26D-592D-4E13-A04C-F99329108541}"/>
              </a:ext>
            </a:extLst>
          </p:cNvPr>
          <p:cNvSpPr txBox="1"/>
          <p:nvPr/>
        </p:nvSpPr>
        <p:spPr>
          <a:xfrm>
            <a:off x="521048" y="898879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602E19E-E72F-45A3-94BB-B11277318118}"/>
              </a:ext>
            </a:extLst>
          </p:cNvPr>
          <p:cNvSpPr txBox="1"/>
          <p:nvPr/>
        </p:nvSpPr>
        <p:spPr>
          <a:xfrm>
            <a:off x="521048" y="155338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8209EB3-FE57-4266-BDF5-318A72AA9D68}"/>
              </a:ext>
            </a:extLst>
          </p:cNvPr>
          <p:cNvSpPr txBox="1"/>
          <p:nvPr/>
        </p:nvSpPr>
        <p:spPr>
          <a:xfrm>
            <a:off x="521048" y="129062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91088CB3-6E57-47BE-9DB9-2CAA25C79328}"/>
              </a:ext>
            </a:extLst>
          </p:cNvPr>
          <p:cNvCxnSpPr/>
          <p:nvPr/>
        </p:nvCxnSpPr>
        <p:spPr>
          <a:xfrm>
            <a:off x="774328" y="62158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570FC269-4E84-4CB6-B798-E54D8E84054D}"/>
              </a:ext>
            </a:extLst>
          </p:cNvPr>
          <p:cNvCxnSpPr/>
          <p:nvPr/>
        </p:nvCxnSpPr>
        <p:spPr>
          <a:xfrm>
            <a:off x="774328" y="100920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0BD9C71-9EC9-4CD2-8963-7871E43F79C5}"/>
              </a:ext>
            </a:extLst>
          </p:cNvPr>
          <p:cNvCxnSpPr/>
          <p:nvPr/>
        </p:nvCxnSpPr>
        <p:spPr>
          <a:xfrm>
            <a:off x="774328" y="140199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D67A6D31-3C01-46E8-9402-4E99BEC763DE}"/>
              </a:ext>
            </a:extLst>
          </p:cNvPr>
          <p:cNvCxnSpPr/>
          <p:nvPr/>
        </p:nvCxnSpPr>
        <p:spPr>
          <a:xfrm>
            <a:off x="774328" y="167497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6107AFB6-4C10-4F38-AFCD-8ECB98335A5C}"/>
              </a:ext>
            </a:extLst>
          </p:cNvPr>
          <p:cNvSpPr txBox="1"/>
          <p:nvPr/>
        </p:nvSpPr>
        <p:spPr>
          <a:xfrm>
            <a:off x="521048" y="190848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E223547A-B21F-4461-BC95-AB17006FF7E5}"/>
              </a:ext>
            </a:extLst>
          </p:cNvPr>
          <p:cNvCxnSpPr/>
          <p:nvPr/>
        </p:nvCxnSpPr>
        <p:spPr>
          <a:xfrm>
            <a:off x="774328" y="203007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6" name="Picture 35">
            <a:extLst>
              <a:ext uri="{FF2B5EF4-FFF2-40B4-BE49-F238E27FC236}">
                <a16:creationId xmlns:a16="http://schemas.microsoft.com/office/drawing/2014/main" id="{AB451713-0587-4F5E-960B-508881FBC41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42" t="1047" r="515" b="-74"/>
          <a:stretch/>
        </p:blipFill>
        <p:spPr>
          <a:xfrm rot="5400000">
            <a:off x="2121297" y="623582"/>
            <a:ext cx="3012142" cy="20219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Rectangle 36">
            <a:extLst>
              <a:ext uri="{FF2B5EF4-FFF2-40B4-BE49-F238E27FC236}">
                <a16:creationId xmlns:a16="http://schemas.microsoft.com/office/drawing/2014/main" id="{24B08E6A-0994-451C-AB6C-AA0C25EBDFF0}"/>
              </a:ext>
            </a:extLst>
          </p:cNvPr>
          <p:cNvSpPr/>
          <p:nvPr/>
        </p:nvSpPr>
        <p:spPr>
          <a:xfrm>
            <a:off x="3627368" y="1374074"/>
            <a:ext cx="554107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FFE6D571-2BE5-4F39-AB52-00C89C31D08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" t="-119" r="180" b="-1115"/>
          <a:stretch/>
        </p:blipFill>
        <p:spPr>
          <a:xfrm rot="5400000">
            <a:off x="5116104" y="-243316"/>
            <a:ext cx="2479944" cy="32235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Rectangle 38">
            <a:extLst>
              <a:ext uri="{FF2B5EF4-FFF2-40B4-BE49-F238E27FC236}">
                <a16:creationId xmlns:a16="http://schemas.microsoft.com/office/drawing/2014/main" id="{86B393F3-D1D9-4698-BDC3-E75DE86E949B}"/>
              </a:ext>
            </a:extLst>
          </p:cNvPr>
          <p:cNvSpPr/>
          <p:nvPr/>
        </p:nvSpPr>
        <p:spPr>
          <a:xfrm>
            <a:off x="6913494" y="481622"/>
            <a:ext cx="506482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DF807153-10FE-4FDE-8D2C-2D209F0358D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73" t="291" r="441" b="-24"/>
          <a:stretch/>
        </p:blipFill>
        <p:spPr>
          <a:xfrm rot="5400000">
            <a:off x="8408410" y="-206116"/>
            <a:ext cx="2506577" cy="31758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Rectangle 40">
            <a:extLst>
              <a:ext uri="{FF2B5EF4-FFF2-40B4-BE49-F238E27FC236}">
                <a16:creationId xmlns:a16="http://schemas.microsoft.com/office/drawing/2014/main" id="{59BED9DD-ECA0-4301-8851-98A733490AAF}"/>
              </a:ext>
            </a:extLst>
          </p:cNvPr>
          <p:cNvSpPr/>
          <p:nvPr/>
        </p:nvSpPr>
        <p:spPr>
          <a:xfrm>
            <a:off x="10209144" y="720934"/>
            <a:ext cx="506482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CFCB63CD-DB1C-46F6-AC64-4D9BDAF06CF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84" t="555" r="-333" b="266"/>
          <a:stretch/>
        </p:blipFill>
        <p:spPr>
          <a:xfrm rot="5400000">
            <a:off x="824943" y="3380109"/>
            <a:ext cx="2518987" cy="328185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53DA2460-A384-4A1F-8194-0A21C8CAF746}"/>
              </a:ext>
            </a:extLst>
          </p:cNvPr>
          <p:cNvSpPr/>
          <p:nvPr/>
        </p:nvSpPr>
        <p:spPr>
          <a:xfrm>
            <a:off x="2703444" y="4587714"/>
            <a:ext cx="506482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C0DD7DD3-82CA-4D82-89FB-A7FA0FC279F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" t="274" r="11" b="457"/>
          <a:stretch/>
        </p:blipFill>
        <p:spPr>
          <a:xfrm rot="5400000">
            <a:off x="3415078" y="3772337"/>
            <a:ext cx="3005636" cy="20269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6" name="Rectangle 45">
            <a:extLst>
              <a:ext uri="{FF2B5EF4-FFF2-40B4-BE49-F238E27FC236}">
                <a16:creationId xmlns:a16="http://schemas.microsoft.com/office/drawing/2014/main" id="{B1BABE01-A5E8-45AE-B8E5-F0D445702B3B}"/>
              </a:ext>
            </a:extLst>
          </p:cNvPr>
          <p:cNvSpPr/>
          <p:nvPr/>
        </p:nvSpPr>
        <p:spPr>
          <a:xfrm>
            <a:off x="4917896" y="4890782"/>
            <a:ext cx="554107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10B6347-AD0A-457F-85BD-CE8CC4EF8D66}"/>
              </a:ext>
            </a:extLst>
          </p:cNvPr>
          <p:cNvSpPr txBox="1"/>
          <p:nvPr/>
        </p:nvSpPr>
        <p:spPr>
          <a:xfrm>
            <a:off x="3631324" y="1070545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E3F7CF7-2026-440E-94E6-38FE863E6998}"/>
              </a:ext>
            </a:extLst>
          </p:cNvPr>
          <p:cNvSpPr txBox="1"/>
          <p:nvPr/>
        </p:nvSpPr>
        <p:spPr>
          <a:xfrm>
            <a:off x="6913494" y="250790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1F9218F-A4C6-481D-8384-2C729A8718DA}"/>
              </a:ext>
            </a:extLst>
          </p:cNvPr>
          <p:cNvSpPr txBox="1"/>
          <p:nvPr/>
        </p:nvSpPr>
        <p:spPr>
          <a:xfrm>
            <a:off x="10778872" y="71966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253BD19-FF70-4BB3-A498-BA4F8106E874}"/>
              </a:ext>
            </a:extLst>
          </p:cNvPr>
          <p:cNvSpPr txBox="1"/>
          <p:nvPr/>
        </p:nvSpPr>
        <p:spPr>
          <a:xfrm>
            <a:off x="3218726" y="4594924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A647CBD-41EB-473D-8D48-D785AFA1AE66}"/>
              </a:ext>
            </a:extLst>
          </p:cNvPr>
          <p:cNvSpPr txBox="1"/>
          <p:nvPr/>
        </p:nvSpPr>
        <p:spPr>
          <a:xfrm>
            <a:off x="5470464" y="4890782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42889707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0C4311B-0E2E-4C02-B171-23FE61428C1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939" t="52216" r="23515" b="22628"/>
          <a:stretch/>
        </p:blipFill>
        <p:spPr>
          <a:xfrm rot="16200000">
            <a:off x="1264425" y="886433"/>
            <a:ext cx="304816" cy="12192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7CEF34A-8A30-4A0D-8657-F1E45D0320E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600" t="14528" r="33459" b="33164"/>
          <a:stretch/>
        </p:blipFill>
        <p:spPr>
          <a:xfrm rot="16200000">
            <a:off x="1264426" y="1214300"/>
            <a:ext cx="304816" cy="12192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A889557-3FCA-4CA9-8D00-9AFC66726F2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32" t="34565" r="43345" b="26282"/>
          <a:stretch/>
        </p:blipFill>
        <p:spPr>
          <a:xfrm rot="16200000">
            <a:off x="1264425" y="1542167"/>
            <a:ext cx="304816" cy="12192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85892DE-F4FD-4CD9-8C26-CD333FFA136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005" t="37154" r="28848" b="19175"/>
          <a:stretch/>
        </p:blipFill>
        <p:spPr>
          <a:xfrm rot="16200000">
            <a:off x="1264425" y="230702"/>
            <a:ext cx="304816" cy="12192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EA26924-5714-42FE-9490-471A1DAF011E}"/>
              </a:ext>
            </a:extLst>
          </p:cNvPr>
          <p:cNvSpPr txBox="1"/>
          <p:nvPr/>
        </p:nvSpPr>
        <p:spPr>
          <a:xfrm>
            <a:off x="2039048" y="492946"/>
            <a:ext cx="72492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 siRN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03EE824-18FF-420E-9584-F91EFE4BF514}"/>
              </a:ext>
            </a:extLst>
          </p:cNvPr>
          <p:cNvSpPr txBox="1"/>
          <p:nvPr/>
        </p:nvSpPr>
        <p:spPr>
          <a:xfrm>
            <a:off x="807311" y="477012"/>
            <a:ext cx="12595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2099A66-DD5E-4A4D-B48C-3949B1F1D84C}"/>
              </a:ext>
            </a:extLst>
          </p:cNvPr>
          <p:cNvSpPr txBox="1"/>
          <p:nvPr/>
        </p:nvSpPr>
        <p:spPr>
          <a:xfrm>
            <a:off x="956795" y="477012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DC4CC0-D7CB-4184-901D-6DD282E8201F}"/>
              </a:ext>
            </a:extLst>
          </p:cNvPr>
          <p:cNvSpPr txBox="1"/>
          <p:nvPr/>
        </p:nvSpPr>
        <p:spPr>
          <a:xfrm>
            <a:off x="1123470" y="477012"/>
            <a:ext cx="12595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E1369C9-153F-4018-BB57-A39261D00EB9}"/>
              </a:ext>
            </a:extLst>
          </p:cNvPr>
          <p:cNvSpPr txBox="1"/>
          <p:nvPr/>
        </p:nvSpPr>
        <p:spPr>
          <a:xfrm>
            <a:off x="1272953" y="477012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8AC307C-7815-41FE-8044-558D62ED7A80}"/>
              </a:ext>
            </a:extLst>
          </p:cNvPr>
          <p:cNvSpPr txBox="1"/>
          <p:nvPr/>
        </p:nvSpPr>
        <p:spPr>
          <a:xfrm>
            <a:off x="2039048" y="356690"/>
            <a:ext cx="309641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6B9F2CA-3702-4457-949F-EB467AF57615}"/>
              </a:ext>
            </a:extLst>
          </p:cNvPr>
          <p:cNvSpPr txBox="1"/>
          <p:nvPr/>
        </p:nvSpPr>
        <p:spPr>
          <a:xfrm>
            <a:off x="807202" y="353840"/>
            <a:ext cx="12595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44F75F3-04CF-4D90-9868-343D7F39DF28}"/>
              </a:ext>
            </a:extLst>
          </p:cNvPr>
          <p:cNvSpPr txBox="1"/>
          <p:nvPr/>
        </p:nvSpPr>
        <p:spPr>
          <a:xfrm>
            <a:off x="956686" y="353840"/>
            <a:ext cx="12595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0223313-4899-4E21-81EF-78725584C5F0}"/>
              </a:ext>
            </a:extLst>
          </p:cNvPr>
          <p:cNvSpPr txBox="1"/>
          <p:nvPr/>
        </p:nvSpPr>
        <p:spPr>
          <a:xfrm>
            <a:off x="1123360" y="353840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8EE3141-7A41-4557-A72A-259085249940}"/>
              </a:ext>
            </a:extLst>
          </p:cNvPr>
          <p:cNvSpPr txBox="1"/>
          <p:nvPr/>
        </p:nvSpPr>
        <p:spPr>
          <a:xfrm>
            <a:off x="1272844" y="353840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D00B885-C527-40D7-9871-2B0B021A0214}"/>
              </a:ext>
            </a:extLst>
          </p:cNvPr>
          <p:cNvSpPr txBox="1"/>
          <p:nvPr/>
        </p:nvSpPr>
        <p:spPr>
          <a:xfrm>
            <a:off x="2039048" y="748637"/>
            <a:ext cx="31054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10D36F9-C733-4F60-903E-F9E02E79EAE0}"/>
              </a:ext>
            </a:extLst>
          </p:cNvPr>
          <p:cNvSpPr txBox="1"/>
          <p:nvPr/>
        </p:nvSpPr>
        <p:spPr>
          <a:xfrm>
            <a:off x="2039048" y="1100227"/>
            <a:ext cx="30511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8394BBA-1FB8-4FC7-A179-6D82471BB653}"/>
              </a:ext>
            </a:extLst>
          </p:cNvPr>
          <p:cNvSpPr txBox="1"/>
          <p:nvPr/>
        </p:nvSpPr>
        <p:spPr>
          <a:xfrm>
            <a:off x="2039048" y="1387943"/>
            <a:ext cx="230918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2F174BB-127A-4AEA-AEF9-F982D4115957}"/>
              </a:ext>
            </a:extLst>
          </p:cNvPr>
          <p:cNvSpPr txBox="1"/>
          <p:nvPr/>
        </p:nvSpPr>
        <p:spPr>
          <a:xfrm>
            <a:off x="2039048" y="1762499"/>
            <a:ext cx="428174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1996C72-C92B-4DF6-AA1A-2A5570B94746}"/>
              </a:ext>
            </a:extLst>
          </p:cNvPr>
          <p:cNvSpPr txBox="1"/>
          <p:nvPr/>
        </p:nvSpPr>
        <p:spPr>
          <a:xfrm>
            <a:off x="2039048" y="2043173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599B49A-7714-45B3-90CB-39A4E32FAB08}"/>
              </a:ext>
            </a:extLst>
          </p:cNvPr>
          <p:cNvSpPr txBox="1"/>
          <p:nvPr/>
        </p:nvSpPr>
        <p:spPr>
          <a:xfrm>
            <a:off x="733667" y="2295404"/>
            <a:ext cx="59774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1EF41F4-BED3-4999-9A67-5F467532B46A}"/>
              </a:ext>
            </a:extLst>
          </p:cNvPr>
          <p:cNvSpPr txBox="1"/>
          <p:nvPr/>
        </p:nvSpPr>
        <p:spPr>
          <a:xfrm>
            <a:off x="1418507" y="477012"/>
            <a:ext cx="12595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A589AB8-7FAF-4214-ABE8-DF708AEB0CBA}"/>
              </a:ext>
            </a:extLst>
          </p:cNvPr>
          <p:cNvSpPr txBox="1"/>
          <p:nvPr/>
        </p:nvSpPr>
        <p:spPr>
          <a:xfrm>
            <a:off x="1567990" y="477012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168131D-120E-439A-980F-955F4FCE6032}"/>
              </a:ext>
            </a:extLst>
          </p:cNvPr>
          <p:cNvSpPr txBox="1"/>
          <p:nvPr/>
        </p:nvSpPr>
        <p:spPr>
          <a:xfrm>
            <a:off x="1734665" y="477012"/>
            <a:ext cx="12595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EA8268B-3D76-4AC1-9A57-CB319E24A059}"/>
              </a:ext>
            </a:extLst>
          </p:cNvPr>
          <p:cNvSpPr txBox="1"/>
          <p:nvPr/>
        </p:nvSpPr>
        <p:spPr>
          <a:xfrm>
            <a:off x="1884149" y="477012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3EA4470-5BE9-489D-BC93-86A8D4CD5E54}"/>
              </a:ext>
            </a:extLst>
          </p:cNvPr>
          <p:cNvSpPr txBox="1"/>
          <p:nvPr/>
        </p:nvSpPr>
        <p:spPr>
          <a:xfrm>
            <a:off x="1418398" y="353840"/>
            <a:ext cx="12595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130B1C7-7DDE-4288-90CF-3F9AB2523826}"/>
              </a:ext>
            </a:extLst>
          </p:cNvPr>
          <p:cNvSpPr txBox="1"/>
          <p:nvPr/>
        </p:nvSpPr>
        <p:spPr>
          <a:xfrm>
            <a:off x="1567881" y="353840"/>
            <a:ext cx="12595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704B569-BE74-4C89-9FA8-EBB8FCDBF1A9}"/>
              </a:ext>
            </a:extLst>
          </p:cNvPr>
          <p:cNvSpPr txBox="1"/>
          <p:nvPr/>
        </p:nvSpPr>
        <p:spPr>
          <a:xfrm>
            <a:off x="1734556" y="353840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3DEE200-49C7-40D0-8C22-0F3A0013C070}"/>
              </a:ext>
            </a:extLst>
          </p:cNvPr>
          <p:cNvSpPr txBox="1"/>
          <p:nvPr/>
        </p:nvSpPr>
        <p:spPr>
          <a:xfrm>
            <a:off x="1884040" y="353840"/>
            <a:ext cx="142243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5F5A6780-94DF-4B51-BDD2-3FEF8A554A9A}"/>
              </a:ext>
            </a:extLst>
          </p:cNvPr>
          <p:cNvCxnSpPr/>
          <p:nvPr/>
        </p:nvCxnSpPr>
        <p:spPr>
          <a:xfrm>
            <a:off x="822833" y="370612"/>
            <a:ext cx="53947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4E113BF0-CD40-4B24-8F0D-C98D727A0A9F}"/>
              </a:ext>
            </a:extLst>
          </p:cNvPr>
          <p:cNvCxnSpPr/>
          <p:nvPr/>
        </p:nvCxnSpPr>
        <p:spPr>
          <a:xfrm>
            <a:off x="1436147" y="370612"/>
            <a:ext cx="53947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477DF1F-6865-4DAA-86DE-C072DE29D756}"/>
              </a:ext>
            </a:extLst>
          </p:cNvPr>
          <p:cNvSpPr txBox="1"/>
          <p:nvPr/>
        </p:nvSpPr>
        <p:spPr>
          <a:xfrm>
            <a:off x="801758" y="155639"/>
            <a:ext cx="31416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38D407A-C388-4D05-BB03-6C8BCD679A48}"/>
              </a:ext>
            </a:extLst>
          </p:cNvPr>
          <p:cNvSpPr txBox="1"/>
          <p:nvPr/>
        </p:nvSpPr>
        <p:spPr>
          <a:xfrm>
            <a:off x="1350311" y="155638"/>
            <a:ext cx="618944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KO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7BCE5D48-6E74-4B5E-8C4C-371F2517654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90" t="23998" r="54276" b="28852"/>
          <a:stretch/>
        </p:blipFill>
        <p:spPr>
          <a:xfrm rot="16200000">
            <a:off x="1263404" y="555888"/>
            <a:ext cx="306446" cy="121983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DC3C61ED-B58A-4453-887A-837D3C3B97D8}"/>
              </a:ext>
            </a:extLst>
          </p:cNvPr>
          <p:cNvSpPr txBox="1"/>
          <p:nvPr/>
        </p:nvSpPr>
        <p:spPr>
          <a:xfrm>
            <a:off x="427654" y="682253"/>
            <a:ext cx="31159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191437D-3A6F-4458-A1C1-535106618903}"/>
              </a:ext>
            </a:extLst>
          </p:cNvPr>
          <p:cNvSpPr txBox="1"/>
          <p:nvPr/>
        </p:nvSpPr>
        <p:spPr>
          <a:xfrm>
            <a:off x="467468" y="1092606"/>
            <a:ext cx="194290" cy="143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D780E6F-BE12-43EC-A0B2-A5A6DC1D9EC1}"/>
              </a:ext>
            </a:extLst>
          </p:cNvPr>
          <p:cNvSpPr txBox="1"/>
          <p:nvPr/>
        </p:nvSpPr>
        <p:spPr>
          <a:xfrm>
            <a:off x="467468" y="1780461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E6FF216-DE9F-4F51-9DB3-2D4E9A1938BB}"/>
              </a:ext>
            </a:extLst>
          </p:cNvPr>
          <p:cNvSpPr txBox="1"/>
          <p:nvPr/>
        </p:nvSpPr>
        <p:spPr>
          <a:xfrm>
            <a:off x="467468" y="1479339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7DCD8F3-E2CF-4596-B203-165A36802C30}"/>
              </a:ext>
            </a:extLst>
          </p:cNvPr>
          <p:cNvCxnSpPr/>
          <p:nvPr/>
        </p:nvCxnSpPr>
        <p:spPr>
          <a:xfrm>
            <a:off x="724415" y="779466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6E8446F1-5C39-4BCA-B618-A5988FA1AF9C}"/>
              </a:ext>
            </a:extLst>
          </p:cNvPr>
          <p:cNvCxnSpPr/>
          <p:nvPr/>
        </p:nvCxnSpPr>
        <p:spPr>
          <a:xfrm>
            <a:off x="724415" y="1183781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B1375F6-5D74-46E4-9B5C-0D293A0EC5AC}"/>
              </a:ext>
            </a:extLst>
          </p:cNvPr>
          <p:cNvCxnSpPr/>
          <p:nvPr/>
        </p:nvCxnSpPr>
        <p:spPr>
          <a:xfrm>
            <a:off x="724415" y="1571378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4C0AA351-9FAB-4785-922A-2C22B374538C}"/>
              </a:ext>
            </a:extLst>
          </p:cNvPr>
          <p:cNvCxnSpPr/>
          <p:nvPr/>
        </p:nvCxnSpPr>
        <p:spPr>
          <a:xfrm>
            <a:off x="724415" y="1880951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BC3DFED0-F4A6-440F-8FA8-F47064880B03}"/>
              </a:ext>
            </a:extLst>
          </p:cNvPr>
          <p:cNvSpPr txBox="1"/>
          <p:nvPr/>
        </p:nvSpPr>
        <p:spPr>
          <a:xfrm>
            <a:off x="467468" y="2115914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BCFF4EE9-B565-4CDE-A021-7D406072FEA4}"/>
              </a:ext>
            </a:extLst>
          </p:cNvPr>
          <p:cNvCxnSpPr/>
          <p:nvPr/>
        </p:nvCxnSpPr>
        <p:spPr>
          <a:xfrm>
            <a:off x="724415" y="2216405"/>
            <a:ext cx="472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34889AAB-EF65-4592-8116-764DE99DAFB4}"/>
              </a:ext>
            </a:extLst>
          </p:cNvPr>
          <p:cNvSpPr txBox="1"/>
          <p:nvPr/>
        </p:nvSpPr>
        <p:spPr>
          <a:xfrm>
            <a:off x="485325" y="458683"/>
            <a:ext cx="32219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F35F344-114C-4269-BD05-B68BF1011568}"/>
              </a:ext>
            </a:extLst>
          </p:cNvPr>
          <p:cNvSpPr txBox="1"/>
          <p:nvPr/>
        </p:nvSpPr>
        <p:spPr>
          <a:xfrm>
            <a:off x="165873" y="14290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7CDCA48B-7B19-45B1-B2C4-926BCA6A087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" t="2184" r="275" b="-696"/>
          <a:stretch/>
        </p:blipFill>
        <p:spPr>
          <a:xfrm rot="16200000">
            <a:off x="2746075" y="505161"/>
            <a:ext cx="2790949" cy="20664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Rectangle 48">
            <a:extLst>
              <a:ext uri="{FF2B5EF4-FFF2-40B4-BE49-F238E27FC236}">
                <a16:creationId xmlns:a16="http://schemas.microsoft.com/office/drawing/2014/main" id="{8E933346-1872-440D-88EA-CDA884A49B76}"/>
              </a:ext>
            </a:extLst>
          </p:cNvPr>
          <p:cNvSpPr/>
          <p:nvPr/>
        </p:nvSpPr>
        <p:spPr>
          <a:xfrm>
            <a:off x="3841445" y="942974"/>
            <a:ext cx="968680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E04CFA97-6F45-44E8-A877-6778A914D64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" t="-783" r="193" b="-1538"/>
          <a:stretch/>
        </p:blipFill>
        <p:spPr>
          <a:xfrm rot="16200000">
            <a:off x="4745346" y="758629"/>
            <a:ext cx="3220323" cy="19888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Rectangle 50">
            <a:extLst>
              <a:ext uri="{FF2B5EF4-FFF2-40B4-BE49-F238E27FC236}">
                <a16:creationId xmlns:a16="http://schemas.microsoft.com/office/drawing/2014/main" id="{4427C983-5655-4BFC-B3CE-2B577F04A6FC}"/>
              </a:ext>
            </a:extLst>
          </p:cNvPr>
          <p:cNvSpPr/>
          <p:nvPr/>
        </p:nvSpPr>
        <p:spPr>
          <a:xfrm>
            <a:off x="5814253" y="1891293"/>
            <a:ext cx="968680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7ADBC197-096E-468B-8A0F-F603B76E9F6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1" t="-541" r="-26" b="175"/>
          <a:stretch/>
        </p:blipFill>
        <p:spPr>
          <a:xfrm rot="16200000">
            <a:off x="7808698" y="-133948"/>
            <a:ext cx="2743405" cy="33225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3" name="Rectangle 52">
            <a:extLst>
              <a:ext uri="{FF2B5EF4-FFF2-40B4-BE49-F238E27FC236}">
                <a16:creationId xmlns:a16="http://schemas.microsoft.com/office/drawing/2014/main" id="{8A15FE86-5201-494C-AA77-36D825538D40}"/>
              </a:ext>
            </a:extLst>
          </p:cNvPr>
          <p:cNvSpPr/>
          <p:nvPr/>
        </p:nvSpPr>
        <p:spPr>
          <a:xfrm>
            <a:off x="9184272" y="777638"/>
            <a:ext cx="968680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A5DEE224-D67E-4472-BFBE-C1238C2830D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5" t="-1307" r="296" b="148"/>
          <a:stretch/>
        </p:blipFill>
        <p:spPr>
          <a:xfrm rot="16200000">
            <a:off x="-608520" y="3930365"/>
            <a:ext cx="3622410" cy="19487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5" name="Rectangle 54">
            <a:extLst>
              <a:ext uri="{FF2B5EF4-FFF2-40B4-BE49-F238E27FC236}">
                <a16:creationId xmlns:a16="http://schemas.microsoft.com/office/drawing/2014/main" id="{20C45677-C11F-43B1-838E-8189F2E975CF}"/>
              </a:ext>
            </a:extLst>
          </p:cNvPr>
          <p:cNvSpPr/>
          <p:nvPr/>
        </p:nvSpPr>
        <p:spPr>
          <a:xfrm>
            <a:off x="543576" y="4308854"/>
            <a:ext cx="968680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FC7257DC-2F0A-4A31-BB35-28EE0594AE5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40" t="1182" r="-1091" b="-923"/>
          <a:stretch/>
        </p:blipFill>
        <p:spPr>
          <a:xfrm rot="16200000">
            <a:off x="1932149" y="3604610"/>
            <a:ext cx="3419945" cy="25669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7" name="Rectangle 56">
            <a:extLst>
              <a:ext uri="{FF2B5EF4-FFF2-40B4-BE49-F238E27FC236}">
                <a16:creationId xmlns:a16="http://schemas.microsoft.com/office/drawing/2014/main" id="{FF607C5E-A0BA-4A40-9ED1-D5257A33A74A}"/>
              </a:ext>
            </a:extLst>
          </p:cNvPr>
          <p:cNvSpPr/>
          <p:nvPr/>
        </p:nvSpPr>
        <p:spPr>
          <a:xfrm>
            <a:off x="3209925" y="4644226"/>
            <a:ext cx="1043477" cy="2605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2470951-72E2-4D74-927F-BB00EE9C7074}"/>
              </a:ext>
            </a:extLst>
          </p:cNvPr>
          <p:cNvSpPr txBox="1"/>
          <p:nvPr/>
        </p:nvSpPr>
        <p:spPr>
          <a:xfrm>
            <a:off x="3357090" y="980085"/>
            <a:ext cx="310545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0CD9200-D6E0-48BF-8303-FF7F897BF7A1}"/>
              </a:ext>
            </a:extLst>
          </p:cNvPr>
          <p:cNvSpPr txBox="1"/>
          <p:nvPr/>
        </p:nvSpPr>
        <p:spPr>
          <a:xfrm>
            <a:off x="6761322" y="1906082"/>
            <a:ext cx="305116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95E4EA1-0D1C-4310-AE92-57F523829C9C}"/>
              </a:ext>
            </a:extLst>
          </p:cNvPr>
          <p:cNvSpPr txBox="1"/>
          <p:nvPr/>
        </p:nvSpPr>
        <p:spPr>
          <a:xfrm>
            <a:off x="10206661" y="778282"/>
            <a:ext cx="230918" cy="1302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320810F-BBA5-44FE-8A3C-B6C2B0553A00}"/>
              </a:ext>
            </a:extLst>
          </p:cNvPr>
          <p:cNvSpPr txBox="1"/>
          <p:nvPr/>
        </p:nvSpPr>
        <p:spPr>
          <a:xfrm>
            <a:off x="1600447" y="4322098"/>
            <a:ext cx="428174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A951B42-98EC-4EC8-9279-8ACD8711392B}"/>
              </a:ext>
            </a:extLst>
          </p:cNvPr>
          <p:cNvSpPr txBox="1"/>
          <p:nvPr/>
        </p:nvSpPr>
        <p:spPr>
          <a:xfrm>
            <a:off x="4325785" y="4644226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280767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209</Words>
  <Application>Microsoft Office PowerPoint</Application>
  <PresentationFormat>Widescreen</PresentationFormat>
  <Paragraphs>16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3</cp:revision>
  <dcterms:created xsi:type="dcterms:W3CDTF">2024-04-03T07:36:22Z</dcterms:created>
  <dcterms:modified xsi:type="dcterms:W3CDTF">2024-04-03T08:30:29Z</dcterms:modified>
</cp:coreProperties>
</file>